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9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20.xml" ContentType="application/vnd.openxmlformats-officedocument.presentationml.notesSlide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notesSlides/notesSlide21.xml" ContentType="application/vnd.openxmlformats-officedocument.presentationml.notesSlide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notesSlides/notesSlide22.xml" ContentType="application/vnd.openxmlformats-officedocument.presentationml.notesSlide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notesSlides/notesSlide23.xml" ContentType="application/vnd.openxmlformats-officedocument.presentationml.notesSlide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notesSlides/notesSlide24.xml" ContentType="application/vnd.openxmlformats-officedocument.presentationml.notesSlide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howSpecialPlsOnTitleSld="0" saveSubsetFonts="1" autoCompressPictures="0">
  <p:sldMasterIdLst>
    <p:sldMasterId id="2147483700" r:id="rId4"/>
  </p:sldMasterIdLst>
  <p:notesMasterIdLst>
    <p:notesMasterId r:id="rId55"/>
  </p:notesMasterIdLst>
  <p:handoutMasterIdLst>
    <p:handoutMasterId r:id="rId56"/>
  </p:handoutMasterIdLst>
  <p:sldIdLst>
    <p:sldId id="256" r:id="rId5"/>
    <p:sldId id="527" r:id="rId6"/>
    <p:sldId id="409" r:id="rId7"/>
    <p:sldId id="449" r:id="rId8"/>
    <p:sldId id="631" r:id="rId9"/>
    <p:sldId id="640" r:id="rId10"/>
    <p:sldId id="638" r:id="rId11"/>
    <p:sldId id="540" r:id="rId12"/>
    <p:sldId id="607" r:id="rId13"/>
    <p:sldId id="632" r:id="rId14"/>
    <p:sldId id="633" r:id="rId15"/>
    <p:sldId id="637" r:id="rId16"/>
    <p:sldId id="570" r:id="rId17"/>
    <p:sldId id="634" r:id="rId18"/>
    <p:sldId id="635" r:id="rId19"/>
    <p:sldId id="636" r:id="rId20"/>
    <p:sldId id="627" r:id="rId21"/>
    <p:sldId id="629" r:id="rId22"/>
    <p:sldId id="625" r:id="rId23"/>
    <p:sldId id="603" r:id="rId24"/>
    <p:sldId id="457" r:id="rId25"/>
    <p:sldId id="445" r:id="rId26"/>
    <p:sldId id="458" r:id="rId27"/>
    <p:sldId id="459" r:id="rId28"/>
    <p:sldId id="460" r:id="rId29"/>
    <p:sldId id="461" r:id="rId30"/>
    <p:sldId id="462" r:id="rId31"/>
    <p:sldId id="639" r:id="rId32"/>
    <p:sldId id="604" r:id="rId33"/>
    <p:sldId id="606" r:id="rId34"/>
    <p:sldId id="605" r:id="rId35"/>
    <p:sldId id="611" r:id="rId36"/>
    <p:sldId id="610" r:id="rId37"/>
    <p:sldId id="618" r:id="rId38"/>
    <p:sldId id="619" r:id="rId39"/>
    <p:sldId id="620" r:id="rId40"/>
    <p:sldId id="260" r:id="rId41"/>
    <p:sldId id="617" r:id="rId42"/>
    <p:sldId id="616" r:id="rId43"/>
    <p:sldId id="615" r:id="rId44"/>
    <p:sldId id="614" r:id="rId45"/>
    <p:sldId id="613" r:id="rId46"/>
    <p:sldId id="257" r:id="rId47"/>
    <p:sldId id="621" r:id="rId48"/>
    <p:sldId id="268" r:id="rId49"/>
    <p:sldId id="612" r:id="rId50"/>
    <p:sldId id="622" r:id="rId51"/>
    <p:sldId id="623" r:id="rId52"/>
    <p:sldId id="472" r:id="rId53"/>
    <p:sldId id="641" r:id="rId54"/>
  </p:sldIdLst>
  <p:sldSz cx="12192000" cy="6858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E04F55F-4C69-989A-5EEB-B665DB84A9AD}" name="Amanda Marie Acquaire" initials="AA" userId="S::ama3666@ads.northwestern.edu::db274da0-b6d6-444b-8357-39f46da39958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ne Louise Holl" initials="JLH" lastIdx="7" clrIdx="0">
    <p:extLst>
      <p:ext uri="{19B8F6BF-5375-455C-9EA6-DF929625EA0E}">
        <p15:presenceInfo xmlns:p15="http://schemas.microsoft.com/office/powerpoint/2012/main" userId="S-1-5-21-2086500257-1188392490-3880406080-523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6AF9"/>
    <a:srgbClr val="E9CDFF"/>
    <a:srgbClr val="253746"/>
    <a:srgbClr val="558DD5"/>
    <a:srgbClr val="33CC33"/>
    <a:srgbClr val="FDE82C"/>
    <a:srgbClr val="CCFF99"/>
    <a:srgbClr val="CCFF66"/>
    <a:srgbClr val="CCFFCC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56D89F-9033-4417-BE15-8B80100569CB}" v="3166" dt="2023-09-26T20:57:09.28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9"/>
  </p:normalViewPr>
  <p:slideViewPr>
    <p:cSldViewPr snapToGrid="0">
      <p:cViewPr varScale="1">
        <p:scale>
          <a:sx n="112" d="100"/>
          <a:sy n="112" d="100"/>
        </p:scale>
        <p:origin x="600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slide" Target="slides/slide35.xml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slide" Target="slides/slide38.xml"/><Relationship Id="rId47" Type="http://schemas.openxmlformats.org/officeDocument/2006/relationships/slide" Target="slides/slide43.xml"/><Relationship Id="rId50" Type="http://schemas.openxmlformats.org/officeDocument/2006/relationships/slide" Target="slides/slide46.xml"/><Relationship Id="rId55" Type="http://schemas.openxmlformats.org/officeDocument/2006/relationships/notesMaster" Target="notesMasters/notesMaster1.xml"/><Relationship Id="rId63" Type="http://schemas.microsoft.com/office/2018/10/relationships/authors" Target="authors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9" Type="http://schemas.openxmlformats.org/officeDocument/2006/relationships/slide" Target="slides/slide25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40" Type="http://schemas.openxmlformats.org/officeDocument/2006/relationships/slide" Target="slides/slide36.xml"/><Relationship Id="rId45" Type="http://schemas.openxmlformats.org/officeDocument/2006/relationships/slide" Target="slides/slide41.xml"/><Relationship Id="rId53" Type="http://schemas.openxmlformats.org/officeDocument/2006/relationships/slide" Target="slides/slide49.xml"/><Relationship Id="rId58" Type="http://schemas.openxmlformats.org/officeDocument/2006/relationships/presProps" Target="presProps.xml"/><Relationship Id="rId5" Type="http://schemas.openxmlformats.org/officeDocument/2006/relationships/slide" Target="slides/slide1.xml"/><Relationship Id="rId61" Type="http://schemas.openxmlformats.org/officeDocument/2006/relationships/tableStyles" Target="tableStyles.xml"/><Relationship Id="rId19" Type="http://schemas.openxmlformats.org/officeDocument/2006/relationships/slide" Target="slides/slide1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43" Type="http://schemas.openxmlformats.org/officeDocument/2006/relationships/slide" Target="slides/slide39.xml"/><Relationship Id="rId48" Type="http://schemas.openxmlformats.org/officeDocument/2006/relationships/slide" Target="slides/slide44.xml"/><Relationship Id="rId56" Type="http://schemas.openxmlformats.org/officeDocument/2006/relationships/handoutMaster" Target="handoutMasters/handoutMaster1.xml"/><Relationship Id="rId8" Type="http://schemas.openxmlformats.org/officeDocument/2006/relationships/slide" Target="slides/slide4.xml"/><Relationship Id="rId51" Type="http://schemas.openxmlformats.org/officeDocument/2006/relationships/slide" Target="slides/slide47.xml"/><Relationship Id="rId3" Type="http://schemas.openxmlformats.org/officeDocument/2006/relationships/customXml" Target="../customXml/item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46" Type="http://schemas.openxmlformats.org/officeDocument/2006/relationships/slide" Target="slides/slide42.xml"/><Relationship Id="rId59" Type="http://schemas.openxmlformats.org/officeDocument/2006/relationships/viewProps" Target="viewProps.xml"/><Relationship Id="rId20" Type="http://schemas.openxmlformats.org/officeDocument/2006/relationships/slide" Target="slides/slide16.xml"/><Relationship Id="rId41" Type="http://schemas.openxmlformats.org/officeDocument/2006/relationships/slide" Target="slides/slide37.xml"/><Relationship Id="rId54" Type="http://schemas.openxmlformats.org/officeDocument/2006/relationships/slide" Target="slides/slide50.xml"/><Relationship Id="rId62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slide" Target="slides/slide32.xml"/><Relationship Id="rId49" Type="http://schemas.openxmlformats.org/officeDocument/2006/relationships/slide" Target="slides/slide45.xml"/><Relationship Id="rId57" Type="http://schemas.openxmlformats.org/officeDocument/2006/relationships/commentAuthors" Target="commentAuthors.xml"/><Relationship Id="rId10" Type="http://schemas.openxmlformats.org/officeDocument/2006/relationships/slide" Target="slides/slide6.xml"/><Relationship Id="rId31" Type="http://schemas.openxmlformats.org/officeDocument/2006/relationships/slide" Target="slides/slide27.xml"/><Relationship Id="rId44" Type="http://schemas.openxmlformats.org/officeDocument/2006/relationships/slide" Target="slides/slide40.xml"/><Relationship Id="rId52" Type="http://schemas.openxmlformats.org/officeDocument/2006/relationships/slide" Target="slides/slide48.xml"/><Relationship Id="rId6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B261E96-2B8F-43BF-BD5C-0C4912B98776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3AE1EBA0-0F6A-447D-B9AA-B79D696950AB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gm:t>
    </dgm:pt>
    <dgm:pt modelId="{4881C3BC-C9D9-4F26-B36D-4C18A4BE5197}" type="par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2DF1FEB-E23C-4131-BF68-7CA5FC571772}" type="sib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1B478C-9EAA-4288-95CF-FF2106F146BE}">
      <dgm:prSet phldrT="[Text]"/>
      <dgm:spPr>
        <a:solidFill>
          <a:schemeClr val="bg2"/>
        </a:solidFill>
      </dgm:spPr>
      <dgm:t>
        <a:bodyPr/>
        <a:lstStyle/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gm:t>
    </dgm:pt>
    <dgm:pt modelId="{83CBD108-C3CA-46C0-884D-12E68342F261}" type="par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17B51FF-BC69-4E04-81AB-6DA1B7FDAA9F}" type="sib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6B5D8C0-AB7C-4D34-A856-2F3F8474D79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gm:t>
    </dgm:pt>
    <dgm:pt modelId="{AD7891D8-089E-4CD5-B30F-1B01264AA27D}" type="par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3A76733-7ABD-4520-88E4-D24FFB74F67F}" type="sib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04C54B-3D46-4DF9-91E5-0B5989AD910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gm:t>
    </dgm:pt>
    <dgm:pt modelId="{882B2ADD-E3DA-4146-A2FA-929056F93521}" type="par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845E7A-E8FD-48B8-A9C7-062FF0666164}" type="sib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7FE8CD3-AEC0-411E-B74A-001D323F3AC9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gm:t>
    </dgm:pt>
    <dgm:pt modelId="{4A773196-8155-48AC-8E13-E5F09228253C}" type="par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A2E692-B5BE-4606-8C3A-457AFD02982C}" type="sib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EFF909-DDEF-4515-93A5-FE48EDCB4200}" type="pres">
      <dgm:prSet presAssocID="{8B261E96-2B8F-43BF-BD5C-0C4912B98776}" presName="cycle" presStyleCnt="0">
        <dgm:presLayoutVars>
          <dgm:dir/>
          <dgm:resizeHandles val="exact"/>
        </dgm:presLayoutVars>
      </dgm:prSet>
      <dgm:spPr/>
    </dgm:pt>
    <dgm:pt modelId="{96D3859A-93FB-4B2D-821F-C5B3713ECD62}" type="pres">
      <dgm:prSet presAssocID="{3AE1EBA0-0F6A-447D-B9AA-B79D696950AB}" presName="dummy" presStyleCnt="0"/>
      <dgm:spPr/>
    </dgm:pt>
    <dgm:pt modelId="{C0590FB8-714B-4522-BA97-989C54126878}" type="pres">
      <dgm:prSet presAssocID="{3AE1EBA0-0F6A-447D-B9AA-B79D696950AB}" presName="node" presStyleLbl="revTx" presStyleIdx="0" presStyleCnt="5">
        <dgm:presLayoutVars>
          <dgm:bulletEnabled val="1"/>
        </dgm:presLayoutVars>
      </dgm:prSet>
      <dgm:spPr/>
    </dgm:pt>
    <dgm:pt modelId="{AC91F25E-DDBF-437B-9FFE-5B9CAC749C61}" type="pres">
      <dgm:prSet presAssocID="{12DF1FEB-E23C-4131-BF68-7CA5FC571772}" presName="sibTrans" presStyleLbl="node1" presStyleIdx="0" presStyleCnt="5"/>
      <dgm:spPr/>
    </dgm:pt>
    <dgm:pt modelId="{653EF67A-834D-4F18-9DC6-00AFA14C62AE}" type="pres">
      <dgm:prSet presAssocID="{4A1B478C-9EAA-4288-95CF-FF2106F146BE}" presName="dummy" presStyleCnt="0"/>
      <dgm:spPr/>
    </dgm:pt>
    <dgm:pt modelId="{508389B2-0D19-4900-B9C9-66F95B20F2F1}" type="pres">
      <dgm:prSet presAssocID="{4A1B478C-9EAA-4288-95CF-FF2106F146BE}" presName="node" presStyleLbl="revTx" presStyleIdx="1" presStyleCnt="5">
        <dgm:presLayoutVars>
          <dgm:bulletEnabled val="1"/>
        </dgm:presLayoutVars>
      </dgm:prSet>
      <dgm:spPr/>
    </dgm:pt>
    <dgm:pt modelId="{1AD0943B-A1A6-4BDA-9062-80F39E7A1C7B}" type="pres">
      <dgm:prSet presAssocID="{317B51FF-BC69-4E04-81AB-6DA1B7FDAA9F}" presName="sibTrans" presStyleLbl="node1" presStyleIdx="1" presStyleCnt="5"/>
      <dgm:spPr/>
    </dgm:pt>
    <dgm:pt modelId="{A4F3001E-0B9D-480E-8555-86F345ECA762}" type="pres">
      <dgm:prSet presAssocID="{26B5D8C0-AB7C-4D34-A856-2F3F8474D796}" presName="dummy" presStyleCnt="0"/>
      <dgm:spPr/>
    </dgm:pt>
    <dgm:pt modelId="{8E8544CC-D122-438F-8CFB-19B02956CE5A}" type="pres">
      <dgm:prSet presAssocID="{26B5D8C0-AB7C-4D34-A856-2F3F8474D796}" presName="node" presStyleLbl="revTx" presStyleIdx="2" presStyleCnt="5">
        <dgm:presLayoutVars>
          <dgm:bulletEnabled val="1"/>
        </dgm:presLayoutVars>
      </dgm:prSet>
      <dgm:spPr/>
    </dgm:pt>
    <dgm:pt modelId="{7E4E7EF2-8419-4AC3-BC4A-FEBB76D26FCF}" type="pres">
      <dgm:prSet presAssocID="{63A76733-7ABD-4520-88E4-D24FFB74F67F}" presName="sibTrans" presStyleLbl="node1" presStyleIdx="2" presStyleCnt="5"/>
      <dgm:spPr/>
    </dgm:pt>
    <dgm:pt modelId="{6AF17485-D839-4973-91CF-9A647E0CE8CE}" type="pres">
      <dgm:prSet presAssocID="{3C04C54B-3D46-4DF9-91E5-0B5989AD9106}" presName="dummy" presStyleCnt="0"/>
      <dgm:spPr/>
    </dgm:pt>
    <dgm:pt modelId="{C5D1478B-3DF9-4F88-9386-06D6F1D70D7C}" type="pres">
      <dgm:prSet presAssocID="{3C04C54B-3D46-4DF9-91E5-0B5989AD9106}" presName="node" presStyleLbl="revTx" presStyleIdx="3" presStyleCnt="5">
        <dgm:presLayoutVars>
          <dgm:bulletEnabled val="1"/>
        </dgm:presLayoutVars>
      </dgm:prSet>
      <dgm:spPr/>
    </dgm:pt>
    <dgm:pt modelId="{CBEC7562-3EF2-438B-9B8E-B353ABC9D262}" type="pres">
      <dgm:prSet presAssocID="{6E845E7A-E8FD-48B8-A9C7-062FF0666164}" presName="sibTrans" presStyleLbl="node1" presStyleIdx="3" presStyleCnt="5"/>
      <dgm:spPr/>
    </dgm:pt>
    <dgm:pt modelId="{2E0CB526-68A6-4565-AFF9-A83BFC47EBD1}" type="pres">
      <dgm:prSet presAssocID="{B7FE8CD3-AEC0-411E-B74A-001D323F3AC9}" presName="dummy" presStyleCnt="0"/>
      <dgm:spPr/>
    </dgm:pt>
    <dgm:pt modelId="{A716A197-9A4D-4EBE-9F4D-40044665010E}" type="pres">
      <dgm:prSet presAssocID="{B7FE8CD3-AEC0-411E-B74A-001D323F3AC9}" presName="node" presStyleLbl="revTx" presStyleIdx="4" presStyleCnt="5">
        <dgm:presLayoutVars>
          <dgm:bulletEnabled val="1"/>
        </dgm:presLayoutVars>
      </dgm:prSet>
      <dgm:spPr/>
    </dgm:pt>
    <dgm:pt modelId="{6B4827B4-378F-4DED-B815-A396804F439C}" type="pres">
      <dgm:prSet presAssocID="{70A2E692-B5BE-4606-8C3A-457AFD02982C}" presName="sibTrans" presStyleLbl="node1" presStyleIdx="4" presStyleCnt="5"/>
      <dgm:spPr/>
    </dgm:pt>
  </dgm:ptLst>
  <dgm:cxnLst>
    <dgm:cxn modelId="{1635C810-649C-409B-8DA5-473E195D4E14}" srcId="{8B261E96-2B8F-43BF-BD5C-0C4912B98776}" destId="{4A1B478C-9EAA-4288-95CF-FF2106F146BE}" srcOrd="1" destOrd="0" parTransId="{83CBD108-C3CA-46C0-884D-12E68342F261}" sibTransId="{317B51FF-BC69-4E04-81AB-6DA1B7FDAA9F}"/>
    <dgm:cxn modelId="{E2E1C015-53CE-440C-A9CE-3F4ECCBCF219}" type="presOf" srcId="{3AE1EBA0-0F6A-447D-B9AA-B79D696950AB}" destId="{C0590FB8-714B-4522-BA97-989C54126878}" srcOrd="0" destOrd="0" presId="urn:microsoft.com/office/officeart/2005/8/layout/cycle1"/>
    <dgm:cxn modelId="{3094581E-2B8F-443F-94EE-1FAF01F27546}" type="presOf" srcId="{8B261E96-2B8F-43BF-BD5C-0C4912B98776}" destId="{06EFF909-DDEF-4515-93A5-FE48EDCB4200}" srcOrd="0" destOrd="0" presId="urn:microsoft.com/office/officeart/2005/8/layout/cycle1"/>
    <dgm:cxn modelId="{8C6D034A-F0C0-4555-B87E-FF77FAC5E487}" srcId="{8B261E96-2B8F-43BF-BD5C-0C4912B98776}" destId="{3C04C54B-3D46-4DF9-91E5-0B5989AD9106}" srcOrd="3" destOrd="0" parTransId="{882B2ADD-E3DA-4146-A2FA-929056F93521}" sibTransId="{6E845E7A-E8FD-48B8-A9C7-062FF0666164}"/>
    <dgm:cxn modelId="{8EFBD85E-73EC-46BA-BC90-1CC88DF69CCF}" type="presOf" srcId="{3C04C54B-3D46-4DF9-91E5-0B5989AD9106}" destId="{C5D1478B-3DF9-4F88-9386-06D6F1D70D7C}" srcOrd="0" destOrd="0" presId="urn:microsoft.com/office/officeart/2005/8/layout/cycle1"/>
    <dgm:cxn modelId="{21F59369-655C-43D0-A69D-CAE33E025C1A}" srcId="{8B261E96-2B8F-43BF-BD5C-0C4912B98776}" destId="{3AE1EBA0-0F6A-447D-B9AA-B79D696950AB}" srcOrd="0" destOrd="0" parTransId="{4881C3BC-C9D9-4F26-B36D-4C18A4BE5197}" sibTransId="{12DF1FEB-E23C-4131-BF68-7CA5FC571772}"/>
    <dgm:cxn modelId="{66258F82-B33B-4B84-81BF-6AACF240E972}" type="presOf" srcId="{317B51FF-BC69-4E04-81AB-6DA1B7FDAA9F}" destId="{1AD0943B-A1A6-4BDA-9062-80F39E7A1C7B}" srcOrd="0" destOrd="0" presId="urn:microsoft.com/office/officeart/2005/8/layout/cycle1"/>
    <dgm:cxn modelId="{C01078A0-21A0-47D6-B6E8-CA050C9592A4}" type="presOf" srcId="{6E845E7A-E8FD-48B8-A9C7-062FF0666164}" destId="{CBEC7562-3EF2-438B-9B8E-B353ABC9D262}" srcOrd="0" destOrd="0" presId="urn:microsoft.com/office/officeart/2005/8/layout/cycle1"/>
    <dgm:cxn modelId="{7AFB57B9-4C28-4DA6-B80B-9A2FEE2C45E8}" srcId="{8B261E96-2B8F-43BF-BD5C-0C4912B98776}" destId="{B7FE8CD3-AEC0-411E-B74A-001D323F3AC9}" srcOrd="4" destOrd="0" parTransId="{4A773196-8155-48AC-8E13-E5F09228253C}" sibTransId="{70A2E692-B5BE-4606-8C3A-457AFD02982C}"/>
    <dgm:cxn modelId="{2148AABE-C736-4970-BAC0-212550455B4C}" type="presOf" srcId="{26B5D8C0-AB7C-4D34-A856-2F3F8474D796}" destId="{8E8544CC-D122-438F-8CFB-19B02956CE5A}" srcOrd="0" destOrd="0" presId="urn:microsoft.com/office/officeart/2005/8/layout/cycle1"/>
    <dgm:cxn modelId="{5DE79AD6-9B6F-4689-A196-E4BCCC91CDEF}" srcId="{8B261E96-2B8F-43BF-BD5C-0C4912B98776}" destId="{26B5D8C0-AB7C-4D34-A856-2F3F8474D796}" srcOrd="2" destOrd="0" parTransId="{AD7891D8-089E-4CD5-B30F-1B01264AA27D}" sibTransId="{63A76733-7ABD-4520-88E4-D24FFB74F67F}"/>
    <dgm:cxn modelId="{2A809EDE-7A28-4548-9990-16452B478BF4}" type="presOf" srcId="{4A1B478C-9EAA-4288-95CF-FF2106F146BE}" destId="{508389B2-0D19-4900-B9C9-66F95B20F2F1}" srcOrd="0" destOrd="0" presId="urn:microsoft.com/office/officeart/2005/8/layout/cycle1"/>
    <dgm:cxn modelId="{4D69D5E5-68AF-4777-87B1-81A324E3C3C1}" type="presOf" srcId="{12DF1FEB-E23C-4131-BF68-7CA5FC571772}" destId="{AC91F25E-DDBF-437B-9FFE-5B9CAC749C61}" srcOrd="0" destOrd="0" presId="urn:microsoft.com/office/officeart/2005/8/layout/cycle1"/>
    <dgm:cxn modelId="{551E3DED-16AE-4C77-B3F7-38378C0B9459}" type="presOf" srcId="{70A2E692-B5BE-4606-8C3A-457AFD02982C}" destId="{6B4827B4-378F-4DED-B815-A396804F439C}" srcOrd="0" destOrd="0" presId="urn:microsoft.com/office/officeart/2005/8/layout/cycle1"/>
    <dgm:cxn modelId="{22C838EF-D9C6-4FB0-8FEA-4A293A299CB5}" type="presOf" srcId="{63A76733-7ABD-4520-88E4-D24FFB74F67F}" destId="{7E4E7EF2-8419-4AC3-BC4A-FEBB76D26FCF}" srcOrd="0" destOrd="0" presId="urn:microsoft.com/office/officeart/2005/8/layout/cycle1"/>
    <dgm:cxn modelId="{4B6149FA-CDCD-4075-B0D9-F047EA8D9EE9}" type="presOf" srcId="{B7FE8CD3-AEC0-411E-B74A-001D323F3AC9}" destId="{A716A197-9A4D-4EBE-9F4D-40044665010E}" srcOrd="0" destOrd="0" presId="urn:microsoft.com/office/officeart/2005/8/layout/cycle1"/>
    <dgm:cxn modelId="{4263E2D5-8950-4525-9310-8736C49AD2EA}" type="presParOf" srcId="{06EFF909-DDEF-4515-93A5-FE48EDCB4200}" destId="{96D3859A-93FB-4B2D-821F-C5B3713ECD62}" srcOrd="0" destOrd="0" presId="urn:microsoft.com/office/officeart/2005/8/layout/cycle1"/>
    <dgm:cxn modelId="{CD814C8D-FF63-4C57-88E4-AFF373793E36}" type="presParOf" srcId="{06EFF909-DDEF-4515-93A5-FE48EDCB4200}" destId="{C0590FB8-714B-4522-BA97-989C54126878}" srcOrd="1" destOrd="0" presId="urn:microsoft.com/office/officeart/2005/8/layout/cycle1"/>
    <dgm:cxn modelId="{B2ABE2DB-D6D3-42D8-B64E-F3756B389A26}" type="presParOf" srcId="{06EFF909-DDEF-4515-93A5-FE48EDCB4200}" destId="{AC91F25E-DDBF-437B-9FFE-5B9CAC749C61}" srcOrd="2" destOrd="0" presId="urn:microsoft.com/office/officeart/2005/8/layout/cycle1"/>
    <dgm:cxn modelId="{60141F03-5C53-4CF7-8D89-7F261E2EE812}" type="presParOf" srcId="{06EFF909-DDEF-4515-93A5-FE48EDCB4200}" destId="{653EF67A-834D-4F18-9DC6-00AFA14C62AE}" srcOrd="3" destOrd="0" presId="urn:microsoft.com/office/officeart/2005/8/layout/cycle1"/>
    <dgm:cxn modelId="{D9C18CD0-F368-4A29-BBC1-A5817FFECB5C}" type="presParOf" srcId="{06EFF909-DDEF-4515-93A5-FE48EDCB4200}" destId="{508389B2-0D19-4900-B9C9-66F95B20F2F1}" srcOrd="4" destOrd="0" presId="urn:microsoft.com/office/officeart/2005/8/layout/cycle1"/>
    <dgm:cxn modelId="{8DB3C285-A3E4-48CF-986E-8F6CC04999BA}" type="presParOf" srcId="{06EFF909-DDEF-4515-93A5-FE48EDCB4200}" destId="{1AD0943B-A1A6-4BDA-9062-80F39E7A1C7B}" srcOrd="5" destOrd="0" presId="urn:microsoft.com/office/officeart/2005/8/layout/cycle1"/>
    <dgm:cxn modelId="{3DD56884-39AA-4B9F-BC72-DDD15F833CDA}" type="presParOf" srcId="{06EFF909-DDEF-4515-93A5-FE48EDCB4200}" destId="{A4F3001E-0B9D-480E-8555-86F345ECA762}" srcOrd="6" destOrd="0" presId="urn:microsoft.com/office/officeart/2005/8/layout/cycle1"/>
    <dgm:cxn modelId="{A51A6F77-C936-4541-B6F4-F89038C26AAA}" type="presParOf" srcId="{06EFF909-DDEF-4515-93A5-FE48EDCB4200}" destId="{8E8544CC-D122-438F-8CFB-19B02956CE5A}" srcOrd="7" destOrd="0" presId="urn:microsoft.com/office/officeart/2005/8/layout/cycle1"/>
    <dgm:cxn modelId="{81A32057-A911-4A73-B271-26D092E9AFAF}" type="presParOf" srcId="{06EFF909-DDEF-4515-93A5-FE48EDCB4200}" destId="{7E4E7EF2-8419-4AC3-BC4A-FEBB76D26FCF}" srcOrd="8" destOrd="0" presId="urn:microsoft.com/office/officeart/2005/8/layout/cycle1"/>
    <dgm:cxn modelId="{9DE9B6A5-B58E-4848-9AC9-C55D723BB8C0}" type="presParOf" srcId="{06EFF909-DDEF-4515-93A5-FE48EDCB4200}" destId="{6AF17485-D839-4973-91CF-9A647E0CE8CE}" srcOrd="9" destOrd="0" presId="urn:microsoft.com/office/officeart/2005/8/layout/cycle1"/>
    <dgm:cxn modelId="{4245C17E-A354-415B-A42C-1BA5A9116652}" type="presParOf" srcId="{06EFF909-DDEF-4515-93A5-FE48EDCB4200}" destId="{C5D1478B-3DF9-4F88-9386-06D6F1D70D7C}" srcOrd="10" destOrd="0" presId="urn:microsoft.com/office/officeart/2005/8/layout/cycle1"/>
    <dgm:cxn modelId="{25BAB14F-157A-47E4-9006-8A8F6B9E6A62}" type="presParOf" srcId="{06EFF909-DDEF-4515-93A5-FE48EDCB4200}" destId="{CBEC7562-3EF2-438B-9B8E-B353ABC9D262}" srcOrd="11" destOrd="0" presId="urn:microsoft.com/office/officeart/2005/8/layout/cycle1"/>
    <dgm:cxn modelId="{38C7DDA0-20DA-4788-9EDF-BC828221B721}" type="presParOf" srcId="{06EFF909-DDEF-4515-93A5-FE48EDCB4200}" destId="{2E0CB526-68A6-4565-AFF9-A83BFC47EBD1}" srcOrd="12" destOrd="0" presId="urn:microsoft.com/office/officeart/2005/8/layout/cycle1"/>
    <dgm:cxn modelId="{763C565F-0A05-4FF6-9299-84C0BEF8DA9C}" type="presParOf" srcId="{06EFF909-DDEF-4515-93A5-FE48EDCB4200}" destId="{A716A197-9A4D-4EBE-9F4D-40044665010E}" srcOrd="13" destOrd="0" presId="urn:microsoft.com/office/officeart/2005/8/layout/cycle1"/>
    <dgm:cxn modelId="{5709A878-3467-4146-AD69-16AABC3B04E8}" type="presParOf" srcId="{06EFF909-DDEF-4515-93A5-FE48EDCB4200}" destId="{6B4827B4-378F-4DED-B815-A396804F439C}" srcOrd="14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8B261E96-2B8F-43BF-BD5C-0C4912B98776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B7FE8CD3-AEC0-411E-B74A-001D323F3AC9}">
      <dgm:prSet phldrT="[Text]"/>
      <dgm:spPr>
        <a:solidFill>
          <a:schemeClr val="bg2">
            <a:lumMod val="25000"/>
          </a:schemeClr>
        </a:solidFill>
      </dgm:spPr>
      <dgm:t>
        <a:bodyPr/>
        <a:lstStyle/>
        <a:p>
          <a:r>
            <a:rPr lang="en-US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gm:t>
    </dgm:pt>
    <dgm:pt modelId="{4A773196-8155-48AC-8E13-E5F09228253C}" type="par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A2E692-B5BE-4606-8C3A-457AFD02982C}" type="sib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AE1EBA0-0F6A-447D-B9AA-B79D696950AB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gm:t>
    </dgm:pt>
    <dgm:pt modelId="{12DF1FEB-E23C-4131-BF68-7CA5FC571772}" type="sib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881C3BC-C9D9-4F26-B36D-4C18A4BE5197}" type="par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1B478C-9EAA-4288-95CF-FF2106F146BE}">
      <dgm:prSet phldrT="[Text]"/>
      <dgm:spPr>
        <a:solidFill>
          <a:schemeClr val="bg2"/>
        </a:solidFill>
      </dgm:spPr>
      <dgm:t>
        <a:bodyPr/>
        <a:lstStyle/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gm:t>
    </dgm:pt>
    <dgm:pt modelId="{317B51FF-BC69-4E04-81AB-6DA1B7FDAA9F}" type="sib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3CBD108-C3CA-46C0-884D-12E68342F261}" type="par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6B5D8C0-AB7C-4D34-A856-2F3F8474D79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gm:t>
    </dgm:pt>
    <dgm:pt modelId="{63A76733-7ABD-4520-88E4-D24FFB74F67F}" type="sib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7891D8-089E-4CD5-B30F-1B01264AA27D}" type="par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04C54B-3D46-4DF9-91E5-0B5989AD910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gm:t>
    </dgm:pt>
    <dgm:pt modelId="{6E845E7A-E8FD-48B8-A9C7-062FF0666164}" type="sib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82B2ADD-E3DA-4146-A2FA-929056F93521}" type="par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EFF909-DDEF-4515-93A5-FE48EDCB4200}" type="pres">
      <dgm:prSet presAssocID="{8B261E96-2B8F-43BF-BD5C-0C4912B98776}" presName="cycle" presStyleCnt="0">
        <dgm:presLayoutVars>
          <dgm:dir/>
          <dgm:resizeHandles val="exact"/>
        </dgm:presLayoutVars>
      </dgm:prSet>
      <dgm:spPr/>
    </dgm:pt>
    <dgm:pt modelId="{96D3859A-93FB-4B2D-821F-C5B3713ECD62}" type="pres">
      <dgm:prSet presAssocID="{3AE1EBA0-0F6A-447D-B9AA-B79D696950AB}" presName="dummy" presStyleCnt="0"/>
      <dgm:spPr/>
    </dgm:pt>
    <dgm:pt modelId="{C0590FB8-714B-4522-BA97-989C54126878}" type="pres">
      <dgm:prSet presAssocID="{3AE1EBA0-0F6A-447D-B9AA-B79D696950AB}" presName="node" presStyleLbl="revTx" presStyleIdx="0" presStyleCnt="5">
        <dgm:presLayoutVars>
          <dgm:bulletEnabled val="1"/>
        </dgm:presLayoutVars>
      </dgm:prSet>
      <dgm:spPr/>
    </dgm:pt>
    <dgm:pt modelId="{AC91F25E-DDBF-437B-9FFE-5B9CAC749C61}" type="pres">
      <dgm:prSet presAssocID="{12DF1FEB-E23C-4131-BF68-7CA5FC571772}" presName="sibTrans" presStyleLbl="node1" presStyleIdx="0" presStyleCnt="5"/>
      <dgm:spPr/>
    </dgm:pt>
    <dgm:pt modelId="{653EF67A-834D-4F18-9DC6-00AFA14C62AE}" type="pres">
      <dgm:prSet presAssocID="{4A1B478C-9EAA-4288-95CF-FF2106F146BE}" presName="dummy" presStyleCnt="0"/>
      <dgm:spPr/>
    </dgm:pt>
    <dgm:pt modelId="{508389B2-0D19-4900-B9C9-66F95B20F2F1}" type="pres">
      <dgm:prSet presAssocID="{4A1B478C-9EAA-4288-95CF-FF2106F146BE}" presName="node" presStyleLbl="revTx" presStyleIdx="1" presStyleCnt="5">
        <dgm:presLayoutVars>
          <dgm:bulletEnabled val="1"/>
        </dgm:presLayoutVars>
      </dgm:prSet>
      <dgm:spPr/>
    </dgm:pt>
    <dgm:pt modelId="{1AD0943B-A1A6-4BDA-9062-80F39E7A1C7B}" type="pres">
      <dgm:prSet presAssocID="{317B51FF-BC69-4E04-81AB-6DA1B7FDAA9F}" presName="sibTrans" presStyleLbl="node1" presStyleIdx="1" presStyleCnt="5"/>
      <dgm:spPr/>
    </dgm:pt>
    <dgm:pt modelId="{A4F3001E-0B9D-480E-8555-86F345ECA762}" type="pres">
      <dgm:prSet presAssocID="{26B5D8C0-AB7C-4D34-A856-2F3F8474D796}" presName="dummy" presStyleCnt="0"/>
      <dgm:spPr/>
    </dgm:pt>
    <dgm:pt modelId="{8E8544CC-D122-438F-8CFB-19B02956CE5A}" type="pres">
      <dgm:prSet presAssocID="{26B5D8C0-AB7C-4D34-A856-2F3F8474D796}" presName="node" presStyleLbl="revTx" presStyleIdx="2" presStyleCnt="5">
        <dgm:presLayoutVars>
          <dgm:bulletEnabled val="1"/>
        </dgm:presLayoutVars>
      </dgm:prSet>
      <dgm:spPr/>
    </dgm:pt>
    <dgm:pt modelId="{7E4E7EF2-8419-4AC3-BC4A-FEBB76D26FCF}" type="pres">
      <dgm:prSet presAssocID="{63A76733-7ABD-4520-88E4-D24FFB74F67F}" presName="sibTrans" presStyleLbl="node1" presStyleIdx="2" presStyleCnt="5"/>
      <dgm:spPr/>
    </dgm:pt>
    <dgm:pt modelId="{6AF17485-D839-4973-91CF-9A647E0CE8CE}" type="pres">
      <dgm:prSet presAssocID="{3C04C54B-3D46-4DF9-91E5-0B5989AD9106}" presName="dummy" presStyleCnt="0"/>
      <dgm:spPr/>
    </dgm:pt>
    <dgm:pt modelId="{C5D1478B-3DF9-4F88-9386-06D6F1D70D7C}" type="pres">
      <dgm:prSet presAssocID="{3C04C54B-3D46-4DF9-91E5-0B5989AD9106}" presName="node" presStyleLbl="revTx" presStyleIdx="3" presStyleCnt="5">
        <dgm:presLayoutVars>
          <dgm:bulletEnabled val="1"/>
        </dgm:presLayoutVars>
      </dgm:prSet>
      <dgm:spPr/>
    </dgm:pt>
    <dgm:pt modelId="{CBEC7562-3EF2-438B-9B8E-B353ABC9D262}" type="pres">
      <dgm:prSet presAssocID="{6E845E7A-E8FD-48B8-A9C7-062FF0666164}" presName="sibTrans" presStyleLbl="node1" presStyleIdx="3" presStyleCnt="5"/>
      <dgm:spPr/>
    </dgm:pt>
    <dgm:pt modelId="{2E0CB526-68A6-4565-AFF9-A83BFC47EBD1}" type="pres">
      <dgm:prSet presAssocID="{B7FE8CD3-AEC0-411E-B74A-001D323F3AC9}" presName="dummy" presStyleCnt="0"/>
      <dgm:spPr/>
    </dgm:pt>
    <dgm:pt modelId="{A716A197-9A4D-4EBE-9F4D-40044665010E}" type="pres">
      <dgm:prSet presAssocID="{B7FE8CD3-AEC0-411E-B74A-001D323F3AC9}" presName="node" presStyleLbl="revTx" presStyleIdx="4" presStyleCnt="5">
        <dgm:presLayoutVars>
          <dgm:bulletEnabled val="1"/>
        </dgm:presLayoutVars>
      </dgm:prSet>
      <dgm:spPr/>
    </dgm:pt>
    <dgm:pt modelId="{6B4827B4-378F-4DED-B815-A396804F439C}" type="pres">
      <dgm:prSet presAssocID="{70A2E692-B5BE-4606-8C3A-457AFD02982C}" presName="sibTrans" presStyleLbl="node1" presStyleIdx="4" presStyleCnt="5"/>
      <dgm:spPr/>
    </dgm:pt>
  </dgm:ptLst>
  <dgm:cxnLst>
    <dgm:cxn modelId="{1635C810-649C-409B-8DA5-473E195D4E14}" srcId="{8B261E96-2B8F-43BF-BD5C-0C4912B98776}" destId="{4A1B478C-9EAA-4288-95CF-FF2106F146BE}" srcOrd="1" destOrd="0" parTransId="{83CBD108-C3CA-46C0-884D-12E68342F261}" sibTransId="{317B51FF-BC69-4E04-81AB-6DA1B7FDAA9F}"/>
    <dgm:cxn modelId="{E2E1C015-53CE-440C-A9CE-3F4ECCBCF219}" type="presOf" srcId="{3AE1EBA0-0F6A-447D-B9AA-B79D696950AB}" destId="{C0590FB8-714B-4522-BA97-989C54126878}" srcOrd="0" destOrd="0" presId="urn:microsoft.com/office/officeart/2005/8/layout/cycle1"/>
    <dgm:cxn modelId="{3094581E-2B8F-443F-94EE-1FAF01F27546}" type="presOf" srcId="{8B261E96-2B8F-43BF-BD5C-0C4912B98776}" destId="{06EFF909-DDEF-4515-93A5-FE48EDCB4200}" srcOrd="0" destOrd="0" presId="urn:microsoft.com/office/officeart/2005/8/layout/cycle1"/>
    <dgm:cxn modelId="{8C6D034A-F0C0-4555-B87E-FF77FAC5E487}" srcId="{8B261E96-2B8F-43BF-BD5C-0C4912B98776}" destId="{3C04C54B-3D46-4DF9-91E5-0B5989AD9106}" srcOrd="3" destOrd="0" parTransId="{882B2ADD-E3DA-4146-A2FA-929056F93521}" sibTransId="{6E845E7A-E8FD-48B8-A9C7-062FF0666164}"/>
    <dgm:cxn modelId="{8EFBD85E-73EC-46BA-BC90-1CC88DF69CCF}" type="presOf" srcId="{3C04C54B-3D46-4DF9-91E5-0B5989AD9106}" destId="{C5D1478B-3DF9-4F88-9386-06D6F1D70D7C}" srcOrd="0" destOrd="0" presId="urn:microsoft.com/office/officeart/2005/8/layout/cycle1"/>
    <dgm:cxn modelId="{21F59369-655C-43D0-A69D-CAE33E025C1A}" srcId="{8B261E96-2B8F-43BF-BD5C-0C4912B98776}" destId="{3AE1EBA0-0F6A-447D-B9AA-B79D696950AB}" srcOrd="0" destOrd="0" parTransId="{4881C3BC-C9D9-4F26-B36D-4C18A4BE5197}" sibTransId="{12DF1FEB-E23C-4131-BF68-7CA5FC571772}"/>
    <dgm:cxn modelId="{66258F82-B33B-4B84-81BF-6AACF240E972}" type="presOf" srcId="{317B51FF-BC69-4E04-81AB-6DA1B7FDAA9F}" destId="{1AD0943B-A1A6-4BDA-9062-80F39E7A1C7B}" srcOrd="0" destOrd="0" presId="urn:microsoft.com/office/officeart/2005/8/layout/cycle1"/>
    <dgm:cxn modelId="{C01078A0-21A0-47D6-B6E8-CA050C9592A4}" type="presOf" srcId="{6E845E7A-E8FD-48B8-A9C7-062FF0666164}" destId="{CBEC7562-3EF2-438B-9B8E-B353ABC9D262}" srcOrd="0" destOrd="0" presId="urn:microsoft.com/office/officeart/2005/8/layout/cycle1"/>
    <dgm:cxn modelId="{7AFB57B9-4C28-4DA6-B80B-9A2FEE2C45E8}" srcId="{8B261E96-2B8F-43BF-BD5C-0C4912B98776}" destId="{B7FE8CD3-AEC0-411E-B74A-001D323F3AC9}" srcOrd="4" destOrd="0" parTransId="{4A773196-8155-48AC-8E13-E5F09228253C}" sibTransId="{70A2E692-B5BE-4606-8C3A-457AFD02982C}"/>
    <dgm:cxn modelId="{2148AABE-C736-4970-BAC0-212550455B4C}" type="presOf" srcId="{26B5D8C0-AB7C-4D34-A856-2F3F8474D796}" destId="{8E8544CC-D122-438F-8CFB-19B02956CE5A}" srcOrd="0" destOrd="0" presId="urn:microsoft.com/office/officeart/2005/8/layout/cycle1"/>
    <dgm:cxn modelId="{5DE79AD6-9B6F-4689-A196-E4BCCC91CDEF}" srcId="{8B261E96-2B8F-43BF-BD5C-0C4912B98776}" destId="{26B5D8C0-AB7C-4D34-A856-2F3F8474D796}" srcOrd="2" destOrd="0" parTransId="{AD7891D8-089E-4CD5-B30F-1B01264AA27D}" sibTransId="{63A76733-7ABD-4520-88E4-D24FFB74F67F}"/>
    <dgm:cxn modelId="{2A809EDE-7A28-4548-9990-16452B478BF4}" type="presOf" srcId="{4A1B478C-9EAA-4288-95CF-FF2106F146BE}" destId="{508389B2-0D19-4900-B9C9-66F95B20F2F1}" srcOrd="0" destOrd="0" presId="urn:microsoft.com/office/officeart/2005/8/layout/cycle1"/>
    <dgm:cxn modelId="{4D69D5E5-68AF-4777-87B1-81A324E3C3C1}" type="presOf" srcId="{12DF1FEB-E23C-4131-BF68-7CA5FC571772}" destId="{AC91F25E-DDBF-437B-9FFE-5B9CAC749C61}" srcOrd="0" destOrd="0" presId="urn:microsoft.com/office/officeart/2005/8/layout/cycle1"/>
    <dgm:cxn modelId="{551E3DED-16AE-4C77-B3F7-38378C0B9459}" type="presOf" srcId="{70A2E692-B5BE-4606-8C3A-457AFD02982C}" destId="{6B4827B4-378F-4DED-B815-A396804F439C}" srcOrd="0" destOrd="0" presId="urn:microsoft.com/office/officeart/2005/8/layout/cycle1"/>
    <dgm:cxn modelId="{22C838EF-D9C6-4FB0-8FEA-4A293A299CB5}" type="presOf" srcId="{63A76733-7ABD-4520-88E4-D24FFB74F67F}" destId="{7E4E7EF2-8419-4AC3-BC4A-FEBB76D26FCF}" srcOrd="0" destOrd="0" presId="urn:microsoft.com/office/officeart/2005/8/layout/cycle1"/>
    <dgm:cxn modelId="{4B6149FA-CDCD-4075-B0D9-F047EA8D9EE9}" type="presOf" srcId="{B7FE8CD3-AEC0-411E-B74A-001D323F3AC9}" destId="{A716A197-9A4D-4EBE-9F4D-40044665010E}" srcOrd="0" destOrd="0" presId="urn:microsoft.com/office/officeart/2005/8/layout/cycle1"/>
    <dgm:cxn modelId="{4263E2D5-8950-4525-9310-8736C49AD2EA}" type="presParOf" srcId="{06EFF909-DDEF-4515-93A5-FE48EDCB4200}" destId="{96D3859A-93FB-4B2D-821F-C5B3713ECD62}" srcOrd="0" destOrd="0" presId="urn:microsoft.com/office/officeart/2005/8/layout/cycle1"/>
    <dgm:cxn modelId="{CD814C8D-FF63-4C57-88E4-AFF373793E36}" type="presParOf" srcId="{06EFF909-DDEF-4515-93A5-FE48EDCB4200}" destId="{C0590FB8-714B-4522-BA97-989C54126878}" srcOrd="1" destOrd="0" presId="urn:microsoft.com/office/officeart/2005/8/layout/cycle1"/>
    <dgm:cxn modelId="{B2ABE2DB-D6D3-42D8-B64E-F3756B389A26}" type="presParOf" srcId="{06EFF909-DDEF-4515-93A5-FE48EDCB4200}" destId="{AC91F25E-DDBF-437B-9FFE-5B9CAC749C61}" srcOrd="2" destOrd="0" presId="urn:microsoft.com/office/officeart/2005/8/layout/cycle1"/>
    <dgm:cxn modelId="{60141F03-5C53-4CF7-8D89-7F261E2EE812}" type="presParOf" srcId="{06EFF909-DDEF-4515-93A5-FE48EDCB4200}" destId="{653EF67A-834D-4F18-9DC6-00AFA14C62AE}" srcOrd="3" destOrd="0" presId="urn:microsoft.com/office/officeart/2005/8/layout/cycle1"/>
    <dgm:cxn modelId="{D9C18CD0-F368-4A29-BBC1-A5817FFECB5C}" type="presParOf" srcId="{06EFF909-DDEF-4515-93A5-FE48EDCB4200}" destId="{508389B2-0D19-4900-B9C9-66F95B20F2F1}" srcOrd="4" destOrd="0" presId="urn:microsoft.com/office/officeart/2005/8/layout/cycle1"/>
    <dgm:cxn modelId="{8DB3C285-A3E4-48CF-986E-8F6CC04999BA}" type="presParOf" srcId="{06EFF909-DDEF-4515-93A5-FE48EDCB4200}" destId="{1AD0943B-A1A6-4BDA-9062-80F39E7A1C7B}" srcOrd="5" destOrd="0" presId="urn:microsoft.com/office/officeart/2005/8/layout/cycle1"/>
    <dgm:cxn modelId="{3DD56884-39AA-4B9F-BC72-DDD15F833CDA}" type="presParOf" srcId="{06EFF909-DDEF-4515-93A5-FE48EDCB4200}" destId="{A4F3001E-0B9D-480E-8555-86F345ECA762}" srcOrd="6" destOrd="0" presId="urn:microsoft.com/office/officeart/2005/8/layout/cycle1"/>
    <dgm:cxn modelId="{A51A6F77-C936-4541-B6F4-F89038C26AAA}" type="presParOf" srcId="{06EFF909-DDEF-4515-93A5-FE48EDCB4200}" destId="{8E8544CC-D122-438F-8CFB-19B02956CE5A}" srcOrd="7" destOrd="0" presId="urn:microsoft.com/office/officeart/2005/8/layout/cycle1"/>
    <dgm:cxn modelId="{81A32057-A911-4A73-B271-26D092E9AFAF}" type="presParOf" srcId="{06EFF909-DDEF-4515-93A5-FE48EDCB4200}" destId="{7E4E7EF2-8419-4AC3-BC4A-FEBB76D26FCF}" srcOrd="8" destOrd="0" presId="urn:microsoft.com/office/officeart/2005/8/layout/cycle1"/>
    <dgm:cxn modelId="{9DE9B6A5-B58E-4848-9AC9-C55D723BB8C0}" type="presParOf" srcId="{06EFF909-DDEF-4515-93A5-FE48EDCB4200}" destId="{6AF17485-D839-4973-91CF-9A647E0CE8CE}" srcOrd="9" destOrd="0" presId="urn:microsoft.com/office/officeart/2005/8/layout/cycle1"/>
    <dgm:cxn modelId="{4245C17E-A354-415B-A42C-1BA5A9116652}" type="presParOf" srcId="{06EFF909-DDEF-4515-93A5-FE48EDCB4200}" destId="{C5D1478B-3DF9-4F88-9386-06D6F1D70D7C}" srcOrd="10" destOrd="0" presId="urn:microsoft.com/office/officeart/2005/8/layout/cycle1"/>
    <dgm:cxn modelId="{25BAB14F-157A-47E4-9006-8A8F6B9E6A62}" type="presParOf" srcId="{06EFF909-DDEF-4515-93A5-FE48EDCB4200}" destId="{CBEC7562-3EF2-438B-9B8E-B353ABC9D262}" srcOrd="11" destOrd="0" presId="urn:microsoft.com/office/officeart/2005/8/layout/cycle1"/>
    <dgm:cxn modelId="{38C7DDA0-20DA-4788-9EDF-BC828221B721}" type="presParOf" srcId="{06EFF909-DDEF-4515-93A5-FE48EDCB4200}" destId="{2E0CB526-68A6-4565-AFF9-A83BFC47EBD1}" srcOrd="12" destOrd="0" presId="urn:microsoft.com/office/officeart/2005/8/layout/cycle1"/>
    <dgm:cxn modelId="{763C565F-0A05-4FF6-9299-84C0BEF8DA9C}" type="presParOf" srcId="{06EFF909-DDEF-4515-93A5-FE48EDCB4200}" destId="{A716A197-9A4D-4EBE-9F4D-40044665010E}" srcOrd="13" destOrd="0" presId="urn:microsoft.com/office/officeart/2005/8/layout/cycle1"/>
    <dgm:cxn modelId="{5709A878-3467-4146-AD69-16AABC3B04E8}" type="presParOf" srcId="{06EFF909-DDEF-4515-93A5-FE48EDCB4200}" destId="{6B4827B4-378F-4DED-B815-A396804F439C}" srcOrd="14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8B261E96-2B8F-43BF-BD5C-0C4912B98776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3AE1EBA0-0F6A-447D-B9AA-B79D696950AB}">
      <dgm:prSet phldrT="[Text]"/>
      <dgm:spPr>
        <a:solidFill>
          <a:schemeClr val="bg2">
            <a:lumMod val="25000"/>
          </a:schemeClr>
        </a:solidFill>
      </dgm:spPr>
      <dgm:t>
        <a:bodyPr/>
        <a:lstStyle/>
        <a:p>
          <a:r>
            <a:rPr lang="en-US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gm:t>
    </dgm:pt>
    <dgm:pt modelId="{4881C3BC-C9D9-4F26-B36D-4C18A4BE5197}" type="par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2DF1FEB-E23C-4131-BF68-7CA5FC571772}" type="sib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1B478C-9EAA-4288-95CF-FF2106F146BE}">
      <dgm:prSet phldrT="[Text]"/>
      <dgm:spPr>
        <a:solidFill>
          <a:schemeClr val="bg2"/>
        </a:solidFill>
      </dgm:spPr>
      <dgm:t>
        <a:bodyPr/>
        <a:lstStyle/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gm:t>
    </dgm:pt>
    <dgm:pt modelId="{83CBD108-C3CA-46C0-884D-12E68342F261}" type="par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17B51FF-BC69-4E04-81AB-6DA1B7FDAA9F}" type="sib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6B5D8C0-AB7C-4D34-A856-2F3F8474D79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gm:t>
    </dgm:pt>
    <dgm:pt modelId="{AD7891D8-089E-4CD5-B30F-1B01264AA27D}" type="par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3A76733-7ABD-4520-88E4-D24FFB74F67F}" type="sib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04C54B-3D46-4DF9-91E5-0B5989AD910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gm:t>
    </dgm:pt>
    <dgm:pt modelId="{882B2ADD-E3DA-4146-A2FA-929056F93521}" type="par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845E7A-E8FD-48B8-A9C7-062FF0666164}" type="sib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7FE8CD3-AEC0-411E-B74A-001D323F3AC9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gm:t>
    </dgm:pt>
    <dgm:pt modelId="{4A773196-8155-48AC-8E13-E5F09228253C}" type="par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A2E692-B5BE-4606-8C3A-457AFD02982C}" type="sib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EFF909-DDEF-4515-93A5-FE48EDCB4200}" type="pres">
      <dgm:prSet presAssocID="{8B261E96-2B8F-43BF-BD5C-0C4912B98776}" presName="cycle" presStyleCnt="0">
        <dgm:presLayoutVars>
          <dgm:dir/>
          <dgm:resizeHandles val="exact"/>
        </dgm:presLayoutVars>
      </dgm:prSet>
      <dgm:spPr/>
    </dgm:pt>
    <dgm:pt modelId="{96D3859A-93FB-4B2D-821F-C5B3713ECD62}" type="pres">
      <dgm:prSet presAssocID="{3AE1EBA0-0F6A-447D-B9AA-B79D696950AB}" presName="dummy" presStyleCnt="0"/>
      <dgm:spPr/>
    </dgm:pt>
    <dgm:pt modelId="{C0590FB8-714B-4522-BA97-989C54126878}" type="pres">
      <dgm:prSet presAssocID="{3AE1EBA0-0F6A-447D-B9AA-B79D696950AB}" presName="node" presStyleLbl="revTx" presStyleIdx="0" presStyleCnt="5">
        <dgm:presLayoutVars>
          <dgm:bulletEnabled val="1"/>
        </dgm:presLayoutVars>
      </dgm:prSet>
      <dgm:spPr/>
    </dgm:pt>
    <dgm:pt modelId="{AC91F25E-DDBF-437B-9FFE-5B9CAC749C61}" type="pres">
      <dgm:prSet presAssocID="{12DF1FEB-E23C-4131-BF68-7CA5FC571772}" presName="sibTrans" presStyleLbl="node1" presStyleIdx="0" presStyleCnt="5"/>
      <dgm:spPr/>
    </dgm:pt>
    <dgm:pt modelId="{653EF67A-834D-4F18-9DC6-00AFA14C62AE}" type="pres">
      <dgm:prSet presAssocID="{4A1B478C-9EAA-4288-95CF-FF2106F146BE}" presName="dummy" presStyleCnt="0"/>
      <dgm:spPr/>
    </dgm:pt>
    <dgm:pt modelId="{508389B2-0D19-4900-B9C9-66F95B20F2F1}" type="pres">
      <dgm:prSet presAssocID="{4A1B478C-9EAA-4288-95CF-FF2106F146BE}" presName="node" presStyleLbl="revTx" presStyleIdx="1" presStyleCnt="5">
        <dgm:presLayoutVars>
          <dgm:bulletEnabled val="1"/>
        </dgm:presLayoutVars>
      </dgm:prSet>
      <dgm:spPr/>
    </dgm:pt>
    <dgm:pt modelId="{1AD0943B-A1A6-4BDA-9062-80F39E7A1C7B}" type="pres">
      <dgm:prSet presAssocID="{317B51FF-BC69-4E04-81AB-6DA1B7FDAA9F}" presName="sibTrans" presStyleLbl="node1" presStyleIdx="1" presStyleCnt="5"/>
      <dgm:spPr/>
    </dgm:pt>
    <dgm:pt modelId="{A4F3001E-0B9D-480E-8555-86F345ECA762}" type="pres">
      <dgm:prSet presAssocID="{26B5D8C0-AB7C-4D34-A856-2F3F8474D796}" presName="dummy" presStyleCnt="0"/>
      <dgm:spPr/>
    </dgm:pt>
    <dgm:pt modelId="{8E8544CC-D122-438F-8CFB-19B02956CE5A}" type="pres">
      <dgm:prSet presAssocID="{26B5D8C0-AB7C-4D34-A856-2F3F8474D796}" presName="node" presStyleLbl="revTx" presStyleIdx="2" presStyleCnt="5">
        <dgm:presLayoutVars>
          <dgm:bulletEnabled val="1"/>
        </dgm:presLayoutVars>
      </dgm:prSet>
      <dgm:spPr/>
    </dgm:pt>
    <dgm:pt modelId="{7E4E7EF2-8419-4AC3-BC4A-FEBB76D26FCF}" type="pres">
      <dgm:prSet presAssocID="{63A76733-7ABD-4520-88E4-D24FFB74F67F}" presName="sibTrans" presStyleLbl="node1" presStyleIdx="2" presStyleCnt="5"/>
      <dgm:spPr/>
    </dgm:pt>
    <dgm:pt modelId="{6AF17485-D839-4973-91CF-9A647E0CE8CE}" type="pres">
      <dgm:prSet presAssocID="{3C04C54B-3D46-4DF9-91E5-0B5989AD9106}" presName="dummy" presStyleCnt="0"/>
      <dgm:spPr/>
    </dgm:pt>
    <dgm:pt modelId="{C5D1478B-3DF9-4F88-9386-06D6F1D70D7C}" type="pres">
      <dgm:prSet presAssocID="{3C04C54B-3D46-4DF9-91E5-0B5989AD9106}" presName="node" presStyleLbl="revTx" presStyleIdx="3" presStyleCnt="5">
        <dgm:presLayoutVars>
          <dgm:bulletEnabled val="1"/>
        </dgm:presLayoutVars>
      </dgm:prSet>
      <dgm:spPr/>
    </dgm:pt>
    <dgm:pt modelId="{CBEC7562-3EF2-438B-9B8E-B353ABC9D262}" type="pres">
      <dgm:prSet presAssocID="{6E845E7A-E8FD-48B8-A9C7-062FF0666164}" presName="sibTrans" presStyleLbl="node1" presStyleIdx="3" presStyleCnt="5"/>
      <dgm:spPr/>
    </dgm:pt>
    <dgm:pt modelId="{2E0CB526-68A6-4565-AFF9-A83BFC47EBD1}" type="pres">
      <dgm:prSet presAssocID="{B7FE8CD3-AEC0-411E-B74A-001D323F3AC9}" presName="dummy" presStyleCnt="0"/>
      <dgm:spPr/>
    </dgm:pt>
    <dgm:pt modelId="{A716A197-9A4D-4EBE-9F4D-40044665010E}" type="pres">
      <dgm:prSet presAssocID="{B7FE8CD3-AEC0-411E-B74A-001D323F3AC9}" presName="node" presStyleLbl="revTx" presStyleIdx="4" presStyleCnt="5">
        <dgm:presLayoutVars>
          <dgm:bulletEnabled val="1"/>
        </dgm:presLayoutVars>
      </dgm:prSet>
      <dgm:spPr/>
    </dgm:pt>
    <dgm:pt modelId="{6B4827B4-378F-4DED-B815-A396804F439C}" type="pres">
      <dgm:prSet presAssocID="{70A2E692-B5BE-4606-8C3A-457AFD02982C}" presName="sibTrans" presStyleLbl="node1" presStyleIdx="4" presStyleCnt="5"/>
      <dgm:spPr/>
    </dgm:pt>
  </dgm:ptLst>
  <dgm:cxnLst>
    <dgm:cxn modelId="{1635C810-649C-409B-8DA5-473E195D4E14}" srcId="{8B261E96-2B8F-43BF-BD5C-0C4912B98776}" destId="{4A1B478C-9EAA-4288-95CF-FF2106F146BE}" srcOrd="1" destOrd="0" parTransId="{83CBD108-C3CA-46C0-884D-12E68342F261}" sibTransId="{317B51FF-BC69-4E04-81AB-6DA1B7FDAA9F}"/>
    <dgm:cxn modelId="{E2E1C015-53CE-440C-A9CE-3F4ECCBCF219}" type="presOf" srcId="{3AE1EBA0-0F6A-447D-B9AA-B79D696950AB}" destId="{C0590FB8-714B-4522-BA97-989C54126878}" srcOrd="0" destOrd="0" presId="urn:microsoft.com/office/officeart/2005/8/layout/cycle1"/>
    <dgm:cxn modelId="{3094581E-2B8F-443F-94EE-1FAF01F27546}" type="presOf" srcId="{8B261E96-2B8F-43BF-BD5C-0C4912B98776}" destId="{06EFF909-DDEF-4515-93A5-FE48EDCB4200}" srcOrd="0" destOrd="0" presId="urn:microsoft.com/office/officeart/2005/8/layout/cycle1"/>
    <dgm:cxn modelId="{8C6D034A-F0C0-4555-B87E-FF77FAC5E487}" srcId="{8B261E96-2B8F-43BF-BD5C-0C4912B98776}" destId="{3C04C54B-3D46-4DF9-91E5-0B5989AD9106}" srcOrd="3" destOrd="0" parTransId="{882B2ADD-E3DA-4146-A2FA-929056F93521}" sibTransId="{6E845E7A-E8FD-48B8-A9C7-062FF0666164}"/>
    <dgm:cxn modelId="{8EFBD85E-73EC-46BA-BC90-1CC88DF69CCF}" type="presOf" srcId="{3C04C54B-3D46-4DF9-91E5-0B5989AD9106}" destId="{C5D1478B-3DF9-4F88-9386-06D6F1D70D7C}" srcOrd="0" destOrd="0" presId="urn:microsoft.com/office/officeart/2005/8/layout/cycle1"/>
    <dgm:cxn modelId="{21F59369-655C-43D0-A69D-CAE33E025C1A}" srcId="{8B261E96-2B8F-43BF-BD5C-0C4912B98776}" destId="{3AE1EBA0-0F6A-447D-B9AA-B79D696950AB}" srcOrd="0" destOrd="0" parTransId="{4881C3BC-C9D9-4F26-B36D-4C18A4BE5197}" sibTransId="{12DF1FEB-E23C-4131-BF68-7CA5FC571772}"/>
    <dgm:cxn modelId="{66258F82-B33B-4B84-81BF-6AACF240E972}" type="presOf" srcId="{317B51FF-BC69-4E04-81AB-6DA1B7FDAA9F}" destId="{1AD0943B-A1A6-4BDA-9062-80F39E7A1C7B}" srcOrd="0" destOrd="0" presId="urn:microsoft.com/office/officeart/2005/8/layout/cycle1"/>
    <dgm:cxn modelId="{C01078A0-21A0-47D6-B6E8-CA050C9592A4}" type="presOf" srcId="{6E845E7A-E8FD-48B8-A9C7-062FF0666164}" destId="{CBEC7562-3EF2-438B-9B8E-B353ABC9D262}" srcOrd="0" destOrd="0" presId="urn:microsoft.com/office/officeart/2005/8/layout/cycle1"/>
    <dgm:cxn modelId="{7AFB57B9-4C28-4DA6-B80B-9A2FEE2C45E8}" srcId="{8B261E96-2B8F-43BF-BD5C-0C4912B98776}" destId="{B7FE8CD3-AEC0-411E-B74A-001D323F3AC9}" srcOrd="4" destOrd="0" parTransId="{4A773196-8155-48AC-8E13-E5F09228253C}" sibTransId="{70A2E692-B5BE-4606-8C3A-457AFD02982C}"/>
    <dgm:cxn modelId="{2148AABE-C736-4970-BAC0-212550455B4C}" type="presOf" srcId="{26B5D8C0-AB7C-4D34-A856-2F3F8474D796}" destId="{8E8544CC-D122-438F-8CFB-19B02956CE5A}" srcOrd="0" destOrd="0" presId="urn:microsoft.com/office/officeart/2005/8/layout/cycle1"/>
    <dgm:cxn modelId="{5DE79AD6-9B6F-4689-A196-E4BCCC91CDEF}" srcId="{8B261E96-2B8F-43BF-BD5C-0C4912B98776}" destId="{26B5D8C0-AB7C-4D34-A856-2F3F8474D796}" srcOrd="2" destOrd="0" parTransId="{AD7891D8-089E-4CD5-B30F-1B01264AA27D}" sibTransId="{63A76733-7ABD-4520-88E4-D24FFB74F67F}"/>
    <dgm:cxn modelId="{2A809EDE-7A28-4548-9990-16452B478BF4}" type="presOf" srcId="{4A1B478C-9EAA-4288-95CF-FF2106F146BE}" destId="{508389B2-0D19-4900-B9C9-66F95B20F2F1}" srcOrd="0" destOrd="0" presId="urn:microsoft.com/office/officeart/2005/8/layout/cycle1"/>
    <dgm:cxn modelId="{4D69D5E5-68AF-4777-87B1-81A324E3C3C1}" type="presOf" srcId="{12DF1FEB-E23C-4131-BF68-7CA5FC571772}" destId="{AC91F25E-DDBF-437B-9FFE-5B9CAC749C61}" srcOrd="0" destOrd="0" presId="urn:microsoft.com/office/officeart/2005/8/layout/cycle1"/>
    <dgm:cxn modelId="{551E3DED-16AE-4C77-B3F7-38378C0B9459}" type="presOf" srcId="{70A2E692-B5BE-4606-8C3A-457AFD02982C}" destId="{6B4827B4-378F-4DED-B815-A396804F439C}" srcOrd="0" destOrd="0" presId="urn:microsoft.com/office/officeart/2005/8/layout/cycle1"/>
    <dgm:cxn modelId="{22C838EF-D9C6-4FB0-8FEA-4A293A299CB5}" type="presOf" srcId="{63A76733-7ABD-4520-88E4-D24FFB74F67F}" destId="{7E4E7EF2-8419-4AC3-BC4A-FEBB76D26FCF}" srcOrd="0" destOrd="0" presId="urn:microsoft.com/office/officeart/2005/8/layout/cycle1"/>
    <dgm:cxn modelId="{4B6149FA-CDCD-4075-B0D9-F047EA8D9EE9}" type="presOf" srcId="{B7FE8CD3-AEC0-411E-B74A-001D323F3AC9}" destId="{A716A197-9A4D-4EBE-9F4D-40044665010E}" srcOrd="0" destOrd="0" presId="urn:microsoft.com/office/officeart/2005/8/layout/cycle1"/>
    <dgm:cxn modelId="{4263E2D5-8950-4525-9310-8736C49AD2EA}" type="presParOf" srcId="{06EFF909-DDEF-4515-93A5-FE48EDCB4200}" destId="{96D3859A-93FB-4B2D-821F-C5B3713ECD62}" srcOrd="0" destOrd="0" presId="urn:microsoft.com/office/officeart/2005/8/layout/cycle1"/>
    <dgm:cxn modelId="{CD814C8D-FF63-4C57-88E4-AFF373793E36}" type="presParOf" srcId="{06EFF909-DDEF-4515-93A5-FE48EDCB4200}" destId="{C0590FB8-714B-4522-BA97-989C54126878}" srcOrd="1" destOrd="0" presId="urn:microsoft.com/office/officeart/2005/8/layout/cycle1"/>
    <dgm:cxn modelId="{B2ABE2DB-D6D3-42D8-B64E-F3756B389A26}" type="presParOf" srcId="{06EFF909-DDEF-4515-93A5-FE48EDCB4200}" destId="{AC91F25E-DDBF-437B-9FFE-5B9CAC749C61}" srcOrd="2" destOrd="0" presId="urn:microsoft.com/office/officeart/2005/8/layout/cycle1"/>
    <dgm:cxn modelId="{60141F03-5C53-4CF7-8D89-7F261E2EE812}" type="presParOf" srcId="{06EFF909-DDEF-4515-93A5-FE48EDCB4200}" destId="{653EF67A-834D-4F18-9DC6-00AFA14C62AE}" srcOrd="3" destOrd="0" presId="urn:microsoft.com/office/officeart/2005/8/layout/cycle1"/>
    <dgm:cxn modelId="{D9C18CD0-F368-4A29-BBC1-A5817FFECB5C}" type="presParOf" srcId="{06EFF909-DDEF-4515-93A5-FE48EDCB4200}" destId="{508389B2-0D19-4900-B9C9-66F95B20F2F1}" srcOrd="4" destOrd="0" presId="urn:microsoft.com/office/officeart/2005/8/layout/cycle1"/>
    <dgm:cxn modelId="{8DB3C285-A3E4-48CF-986E-8F6CC04999BA}" type="presParOf" srcId="{06EFF909-DDEF-4515-93A5-FE48EDCB4200}" destId="{1AD0943B-A1A6-4BDA-9062-80F39E7A1C7B}" srcOrd="5" destOrd="0" presId="urn:microsoft.com/office/officeart/2005/8/layout/cycle1"/>
    <dgm:cxn modelId="{3DD56884-39AA-4B9F-BC72-DDD15F833CDA}" type="presParOf" srcId="{06EFF909-DDEF-4515-93A5-FE48EDCB4200}" destId="{A4F3001E-0B9D-480E-8555-86F345ECA762}" srcOrd="6" destOrd="0" presId="urn:microsoft.com/office/officeart/2005/8/layout/cycle1"/>
    <dgm:cxn modelId="{A51A6F77-C936-4541-B6F4-F89038C26AAA}" type="presParOf" srcId="{06EFF909-DDEF-4515-93A5-FE48EDCB4200}" destId="{8E8544CC-D122-438F-8CFB-19B02956CE5A}" srcOrd="7" destOrd="0" presId="urn:microsoft.com/office/officeart/2005/8/layout/cycle1"/>
    <dgm:cxn modelId="{81A32057-A911-4A73-B271-26D092E9AFAF}" type="presParOf" srcId="{06EFF909-DDEF-4515-93A5-FE48EDCB4200}" destId="{7E4E7EF2-8419-4AC3-BC4A-FEBB76D26FCF}" srcOrd="8" destOrd="0" presId="urn:microsoft.com/office/officeart/2005/8/layout/cycle1"/>
    <dgm:cxn modelId="{9DE9B6A5-B58E-4848-9AC9-C55D723BB8C0}" type="presParOf" srcId="{06EFF909-DDEF-4515-93A5-FE48EDCB4200}" destId="{6AF17485-D839-4973-91CF-9A647E0CE8CE}" srcOrd="9" destOrd="0" presId="urn:microsoft.com/office/officeart/2005/8/layout/cycle1"/>
    <dgm:cxn modelId="{4245C17E-A354-415B-A42C-1BA5A9116652}" type="presParOf" srcId="{06EFF909-DDEF-4515-93A5-FE48EDCB4200}" destId="{C5D1478B-3DF9-4F88-9386-06D6F1D70D7C}" srcOrd="10" destOrd="0" presId="urn:microsoft.com/office/officeart/2005/8/layout/cycle1"/>
    <dgm:cxn modelId="{25BAB14F-157A-47E4-9006-8A8F6B9E6A62}" type="presParOf" srcId="{06EFF909-DDEF-4515-93A5-FE48EDCB4200}" destId="{CBEC7562-3EF2-438B-9B8E-B353ABC9D262}" srcOrd="11" destOrd="0" presId="urn:microsoft.com/office/officeart/2005/8/layout/cycle1"/>
    <dgm:cxn modelId="{38C7DDA0-20DA-4788-9EDF-BC828221B721}" type="presParOf" srcId="{06EFF909-DDEF-4515-93A5-FE48EDCB4200}" destId="{2E0CB526-68A6-4565-AFF9-A83BFC47EBD1}" srcOrd="12" destOrd="0" presId="urn:microsoft.com/office/officeart/2005/8/layout/cycle1"/>
    <dgm:cxn modelId="{763C565F-0A05-4FF6-9299-84C0BEF8DA9C}" type="presParOf" srcId="{06EFF909-DDEF-4515-93A5-FE48EDCB4200}" destId="{A716A197-9A4D-4EBE-9F4D-40044665010E}" srcOrd="13" destOrd="0" presId="urn:microsoft.com/office/officeart/2005/8/layout/cycle1"/>
    <dgm:cxn modelId="{5709A878-3467-4146-AD69-16AABC3B04E8}" type="presParOf" srcId="{06EFF909-DDEF-4515-93A5-FE48EDCB4200}" destId="{6B4827B4-378F-4DED-B815-A396804F439C}" srcOrd="14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8B261E96-2B8F-43BF-BD5C-0C4912B98776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3AE1EBA0-0F6A-447D-B9AA-B79D696950AB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gm:t>
    </dgm:pt>
    <dgm:pt modelId="{4881C3BC-C9D9-4F26-B36D-4C18A4BE5197}" type="par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2DF1FEB-E23C-4131-BF68-7CA5FC571772}" type="sib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1B478C-9EAA-4288-95CF-FF2106F146BE}">
      <dgm:prSet phldrT="[Text]"/>
      <dgm:spPr>
        <a:solidFill>
          <a:schemeClr val="bg2">
            <a:lumMod val="25000"/>
          </a:schemeClr>
        </a:solidFill>
      </dgm:spPr>
      <dgm:t>
        <a:bodyPr/>
        <a:lstStyle/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gm:t>
    </dgm:pt>
    <dgm:pt modelId="{83CBD108-C3CA-46C0-884D-12E68342F261}" type="par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17B51FF-BC69-4E04-81AB-6DA1B7FDAA9F}" type="sib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6B5D8C0-AB7C-4D34-A856-2F3F8474D79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gm:t>
    </dgm:pt>
    <dgm:pt modelId="{AD7891D8-089E-4CD5-B30F-1B01264AA27D}" type="par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3A76733-7ABD-4520-88E4-D24FFB74F67F}" type="sib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04C54B-3D46-4DF9-91E5-0B5989AD910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gm:t>
    </dgm:pt>
    <dgm:pt modelId="{882B2ADD-E3DA-4146-A2FA-929056F93521}" type="par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845E7A-E8FD-48B8-A9C7-062FF0666164}" type="sib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7FE8CD3-AEC0-411E-B74A-001D323F3AC9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gm:t>
    </dgm:pt>
    <dgm:pt modelId="{4A773196-8155-48AC-8E13-E5F09228253C}" type="par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A2E692-B5BE-4606-8C3A-457AFD02982C}" type="sib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EFF909-DDEF-4515-93A5-FE48EDCB4200}" type="pres">
      <dgm:prSet presAssocID="{8B261E96-2B8F-43BF-BD5C-0C4912B98776}" presName="cycle" presStyleCnt="0">
        <dgm:presLayoutVars>
          <dgm:dir/>
          <dgm:resizeHandles val="exact"/>
        </dgm:presLayoutVars>
      </dgm:prSet>
      <dgm:spPr/>
    </dgm:pt>
    <dgm:pt modelId="{96D3859A-93FB-4B2D-821F-C5B3713ECD62}" type="pres">
      <dgm:prSet presAssocID="{3AE1EBA0-0F6A-447D-B9AA-B79D696950AB}" presName="dummy" presStyleCnt="0"/>
      <dgm:spPr/>
    </dgm:pt>
    <dgm:pt modelId="{C0590FB8-714B-4522-BA97-989C54126878}" type="pres">
      <dgm:prSet presAssocID="{3AE1EBA0-0F6A-447D-B9AA-B79D696950AB}" presName="node" presStyleLbl="revTx" presStyleIdx="0" presStyleCnt="5">
        <dgm:presLayoutVars>
          <dgm:bulletEnabled val="1"/>
        </dgm:presLayoutVars>
      </dgm:prSet>
      <dgm:spPr/>
    </dgm:pt>
    <dgm:pt modelId="{AC91F25E-DDBF-437B-9FFE-5B9CAC749C61}" type="pres">
      <dgm:prSet presAssocID="{12DF1FEB-E23C-4131-BF68-7CA5FC571772}" presName="sibTrans" presStyleLbl="node1" presStyleIdx="0" presStyleCnt="5"/>
      <dgm:spPr/>
    </dgm:pt>
    <dgm:pt modelId="{653EF67A-834D-4F18-9DC6-00AFA14C62AE}" type="pres">
      <dgm:prSet presAssocID="{4A1B478C-9EAA-4288-95CF-FF2106F146BE}" presName="dummy" presStyleCnt="0"/>
      <dgm:spPr/>
    </dgm:pt>
    <dgm:pt modelId="{508389B2-0D19-4900-B9C9-66F95B20F2F1}" type="pres">
      <dgm:prSet presAssocID="{4A1B478C-9EAA-4288-95CF-FF2106F146BE}" presName="node" presStyleLbl="revTx" presStyleIdx="1" presStyleCnt="5">
        <dgm:presLayoutVars>
          <dgm:bulletEnabled val="1"/>
        </dgm:presLayoutVars>
      </dgm:prSet>
      <dgm:spPr/>
    </dgm:pt>
    <dgm:pt modelId="{1AD0943B-A1A6-4BDA-9062-80F39E7A1C7B}" type="pres">
      <dgm:prSet presAssocID="{317B51FF-BC69-4E04-81AB-6DA1B7FDAA9F}" presName="sibTrans" presStyleLbl="node1" presStyleIdx="1" presStyleCnt="5"/>
      <dgm:spPr/>
    </dgm:pt>
    <dgm:pt modelId="{A4F3001E-0B9D-480E-8555-86F345ECA762}" type="pres">
      <dgm:prSet presAssocID="{26B5D8C0-AB7C-4D34-A856-2F3F8474D796}" presName="dummy" presStyleCnt="0"/>
      <dgm:spPr/>
    </dgm:pt>
    <dgm:pt modelId="{8E8544CC-D122-438F-8CFB-19B02956CE5A}" type="pres">
      <dgm:prSet presAssocID="{26B5D8C0-AB7C-4D34-A856-2F3F8474D796}" presName="node" presStyleLbl="revTx" presStyleIdx="2" presStyleCnt="5">
        <dgm:presLayoutVars>
          <dgm:bulletEnabled val="1"/>
        </dgm:presLayoutVars>
      </dgm:prSet>
      <dgm:spPr/>
    </dgm:pt>
    <dgm:pt modelId="{7E4E7EF2-8419-4AC3-BC4A-FEBB76D26FCF}" type="pres">
      <dgm:prSet presAssocID="{63A76733-7ABD-4520-88E4-D24FFB74F67F}" presName="sibTrans" presStyleLbl="node1" presStyleIdx="2" presStyleCnt="5"/>
      <dgm:spPr/>
    </dgm:pt>
    <dgm:pt modelId="{6AF17485-D839-4973-91CF-9A647E0CE8CE}" type="pres">
      <dgm:prSet presAssocID="{3C04C54B-3D46-4DF9-91E5-0B5989AD9106}" presName="dummy" presStyleCnt="0"/>
      <dgm:spPr/>
    </dgm:pt>
    <dgm:pt modelId="{C5D1478B-3DF9-4F88-9386-06D6F1D70D7C}" type="pres">
      <dgm:prSet presAssocID="{3C04C54B-3D46-4DF9-91E5-0B5989AD9106}" presName="node" presStyleLbl="revTx" presStyleIdx="3" presStyleCnt="5">
        <dgm:presLayoutVars>
          <dgm:bulletEnabled val="1"/>
        </dgm:presLayoutVars>
      </dgm:prSet>
      <dgm:spPr/>
    </dgm:pt>
    <dgm:pt modelId="{CBEC7562-3EF2-438B-9B8E-B353ABC9D262}" type="pres">
      <dgm:prSet presAssocID="{6E845E7A-E8FD-48B8-A9C7-062FF0666164}" presName="sibTrans" presStyleLbl="node1" presStyleIdx="3" presStyleCnt="5"/>
      <dgm:spPr/>
    </dgm:pt>
    <dgm:pt modelId="{2E0CB526-68A6-4565-AFF9-A83BFC47EBD1}" type="pres">
      <dgm:prSet presAssocID="{B7FE8CD3-AEC0-411E-B74A-001D323F3AC9}" presName="dummy" presStyleCnt="0"/>
      <dgm:spPr/>
    </dgm:pt>
    <dgm:pt modelId="{A716A197-9A4D-4EBE-9F4D-40044665010E}" type="pres">
      <dgm:prSet presAssocID="{B7FE8CD3-AEC0-411E-B74A-001D323F3AC9}" presName="node" presStyleLbl="revTx" presStyleIdx="4" presStyleCnt="5">
        <dgm:presLayoutVars>
          <dgm:bulletEnabled val="1"/>
        </dgm:presLayoutVars>
      </dgm:prSet>
      <dgm:spPr/>
    </dgm:pt>
    <dgm:pt modelId="{6B4827B4-378F-4DED-B815-A396804F439C}" type="pres">
      <dgm:prSet presAssocID="{70A2E692-B5BE-4606-8C3A-457AFD02982C}" presName="sibTrans" presStyleLbl="node1" presStyleIdx="4" presStyleCnt="5"/>
      <dgm:spPr/>
    </dgm:pt>
  </dgm:ptLst>
  <dgm:cxnLst>
    <dgm:cxn modelId="{1635C810-649C-409B-8DA5-473E195D4E14}" srcId="{8B261E96-2B8F-43BF-BD5C-0C4912B98776}" destId="{4A1B478C-9EAA-4288-95CF-FF2106F146BE}" srcOrd="1" destOrd="0" parTransId="{83CBD108-C3CA-46C0-884D-12E68342F261}" sibTransId="{317B51FF-BC69-4E04-81AB-6DA1B7FDAA9F}"/>
    <dgm:cxn modelId="{E2E1C015-53CE-440C-A9CE-3F4ECCBCF219}" type="presOf" srcId="{3AE1EBA0-0F6A-447D-B9AA-B79D696950AB}" destId="{C0590FB8-714B-4522-BA97-989C54126878}" srcOrd="0" destOrd="0" presId="urn:microsoft.com/office/officeart/2005/8/layout/cycle1"/>
    <dgm:cxn modelId="{3094581E-2B8F-443F-94EE-1FAF01F27546}" type="presOf" srcId="{8B261E96-2B8F-43BF-BD5C-0C4912B98776}" destId="{06EFF909-DDEF-4515-93A5-FE48EDCB4200}" srcOrd="0" destOrd="0" presId="urn:microsoft.com/office/officeart/2005/8/layout/cycle1"/>
    <dgm:cxn modelId="{8C6D034A-F0C0-4555-B87E-FF77FAC5E487}" srcId="{8B261E96-2B8F-43BF-BD5C-0C4912B98776}" destId="{3C04C54B-3D46-4DF9-91E5-0B5989AD9106}" srcOrd="3" destOrd="0" parTransId="{882B2ADD-E3DA-4146-A2FA-929056F93521}" sibTransId="{6E845E7A-E8FD-48B8-A9C7-062FF0666164}"/>
    <dgm:cxn modelId="{8EFBD85E-73EC-46BA-BC90-1CC88DF69CCF}" type="presOf" srcId="{3C04C54B-3D46-4DF9-91E5-0B5989AD9106}" destId="{C5D1478B-3DF9-4F88-9386-06D6F1D70D7C}" srcOrd="0" destOrd="0" presId="urn:microsoft.com/office/officeart/2005/8/layout/cycle1"/>
    <dgm:cxn modelId="{21F59369-655C-43D0-A69D-CAE33E025C1A}" srcId="{8B261E96-2B8F-43BF-BD5C-0C4912B98776}" destId="{3AE1EBA0-0F6A-447D-B9AA-B79D696950AB}" srcOrd="0" destOrd="0" parTransId="{4881C3BC-C9D9-4F26-B36D-4C18A4BE5197}" sibTransId="{12DF1FEB-E23C-4131-BF68-7CA5FC571772}"/>
    <dgm:cxn modelId="{66258F82-B33B-4B84-81BF-6AACF240E972}" type="presOf" srcId="{317B51FF-BC69-4E04-81AB-6DA1B7FDAA9F}" destId="{1AD0943B-A1A6-4BDA-9062-80F39E7A1C7B}" srcOrd="0" destOrd="0" presId="urn:microsoft.com/office/officeart/2005/8/layout/cycle1"/>
    <dgm:cxn modelId="{C01078A0-21A0-47D6-B6E8-CA050C9592A4}" type="presOf" srcId="{6E845E7A-E8FD-48B8-A9C7-062FF0666164}" destId="{CBEC7562-3EF2-438B-9B8E-B353ABC9D262}" srcOrd="0" destOrd="0" presId="urn:microsoft.com/office/officeart/2005/8/layout/cycle1"/>
    <dgm:cxn modelId="{7AFB57B9-4C28-4DA6-B80B-9A2FEE2C45E8}" srcId="{8B261E96-2B8F-43BF-BD5C-0C4912B98776}" destId="{B7FE8CD3-AEC0-411E-B74A-001D323F3AC9}" srcOrd="4" destOrd="0" parTransId="{4A773196-8155-48AC-8E13-E5F09228253C}" sibTransId="{70A2E692-B5BE-4606-8C3A-457AFD02982C}"/>
    <dgm:cxn modelId="{2148AABE-C736-4970-BAC0-212550455B4C}" type="presOf" srcId="{26B5D8C0-AB7C-4D34-A856-2F3F8474D796}" destId="{8E8544CC-D122-438F-8CFB-19B02956CE5A}" srcOrd="0" destOrd="0" presId="urn:microsoft.com/office/officeart/2005/8/layout/cycle1"/>
    <dgm:cxn modelId="{5DE79AD6-9B6F-4689-A196-E4BCCC91CDEF}" srcId="{8B261E96-2B8F-43BF-BD5C-0C4912B98776}" destId="{26B5D8C0-AB7C-4D34-A856-2F3F8474D796}" srcOrd="2" destOrd="0" parTransId="{AD7891D8-089E-4CD5-B30F-1B01264AA27D}" sibTransId="{63A76733-7ABD-4520-88E4-D24FFB74F67F}"/>
    <dgm:cxn modelId="{2A809EDE-7A28-4548-9990-16452B478BF4}" type="presOf" srcId="{4A1B478C-9EAA-4288-95CF-FF2106F146BE}" destId="{508389B2-0D19-4900-B9C9-66F95B20F2F1}" srcOrd="0" destOrd="0" presId="urn:microsoft.com/office/officeart/2005/8/layout/cycle1"/>
    <dgm:cxn modelId="{4D69D5E5-68AF-4777-87B1-81A324E3C3C1}" type="presOf" srcId="{12DF1FEB-E23C-4131-BF68-7CA5FC571772}" destId="{AC91F25E-DDBF-437B-9FFE-5B9CAC749C61}" srcOrd="0" destOrd="0" presId="urn:microsoft.com/office/officeart/2005/8/layout/cycle1"/>
    <dgm:cxn modelId="{551E3DED-16AE-4C77-B3F7-38378C0B9459}" type="presOf" srcId="{70A2E692-B5BE-4606-8C3A-457AFD02982C}" destId="{6B4827B4-378F-4DED-B815-A396804F439C}" srcOrd="0" destOrd="0" presId="urn:microsoft.com/office/officeart/2005/8/layout/cycle1"/>
    <dgm:cxn modelId="{22C838EF-D9C6-4FB0-8FEA-4A293A299CB5}" type="presOf" srcId="{63A76733-7ABD-4520-88E4-D24FFB74F67F}" destId="{7E4E7EF2-8419-4AC3-BC4A-FEBB76D26FCF}" srcOrd="0" destOrd="0" presId="urn:microsoft.com/office/officeart/2005/8/layout/cycle1"/>
    <dgm:cxn modelId="{4B6149FA-CDCD-4075-B0D9-F047EA8D9EE9}" type="presOf" srcId="{B7FE8CD3-AEC0-411E-B74A-001D323F3AC9}" destId="{A716A197-9A4D-4EBE-9F4D-40044665010E}" srcOrd="0" destOrd="0" presId="urn:microsoft.com/office/officeart/2005/8/layout/cycle1"/>
    <dgm:cxn modelId="{4263E2D5-8950-4525-9310-8736C49AD2EA}" type="presParOf" srcId="{06EFF909-DDEF-4515-93A5-FE48EDCB4200}" destId="{96D3859A-93FB-4B2D-821F-C5B3713ECD62}" srcOrd="0" destOrd="0" presId="urn:microsoft.com/office/officeart/2005/8/layout/cycle1"/>
    <dgm:cxn modelId="{CD814C8D-FF63-4C57-88E4-AFF373793E36}" type="presParOf" srcId="{06EFF909-DDEF-4515-93A5-FE48EDCB4200}" destId="{C0590FB8-714B-4522-BA97-989C54126878}" srcOrd="1" destOrd="0" presId="urn:microsoft.com/office/officeart/2005/8/layout/cycle1"/>
    <dgm:cxn modelId="{B2ABE2DB-D6D3-42D8-B64E-F3756B389A26}" type="presParOf" srcId="{06EFF909-DDEF-4515-93A5-FE48EDCB4200}" destId="{AC91F25E-DDBF-437B-9FFE-5B9CAC749C61}" srcOrd="2" destOrd="0" presId="urn:microsoft.com/office/officeart/2005/8/layout/cycle1"/>
    <dgm:cxn modelId="{60141F03-5C53-4CF7-8D89-7F261E2EE812}" type="presParOf" srcId="{06EFF909-DDEF-4515-93A5-FE48EDCB4200}" destId="{653EF67A-834D-4F18-9DC6-00AFA14C62AE}" srcOrd="3" destOrd="0" presId="urn:microsoft.com/office/officeart/2005/8/layout/cycle1"/>
    <dgm:cxn modelId="{D9C18CD0-F368-4A29-BBC1-A5817FFECB5C}" type="presParOf" srcId="{06EFF909-DDEF-4515-93A5-FE48EDCB4200}" destId="{508389B2-0D19-4900-B9C9-66F95B20F2F1}" srcOrd="4" destOrd="0" presId="urn:microsoft.com/office/officeart/2005/8/layout/cycle1"/>
    <dgm:cxn modelId="{8DB3C285-A3E4-48CF-986E-8F6CC04999BA}" type="presParOf" srcId="{06EFF909-DDEF-4515-93A5-FE48EDCB4200}" destId="{1AD0943B-A1A6-4BDA-9062-80F39E7A1C7B}" srcOrd="5" destOrd="0" presId="urn:microsoft.com/office/officeart/2005/8/layout/cycle1"/>
    <dgm:cxn modelId="{3DD56884-39AA-4B9F-BC72-DDD15F833CDA}" type="presParOf" srcId="{06EFF909-DDEF-4515-93A5-FE48EDCB4200}" destId="{A4F3001E-0B9D-480E-8555-86F345ECA762}" srcOrd="6" destOrd="0" presId="urn:microsoft.com/office/officeart/2005/8/layout/cycle1"/>
    <dgm:cxn modelId="{A51A6F77-C936-4541-B6F4-F89038C26AAA}" type="presParOf" srcId="{06EFF909-DDEF-4515-93A5-FE48EDCB4200}" destId="{8E8544CC-D122-438F-8CFB-19B02956CE5A}" srcOrd="7" destOrd="0" presId="urn:microsoft.com/office/officeart/2005/8/layout/cycle1"/>
    <dgm:cxn modelId="{81A32057-A911-4A73-B271-26D092E9AFAF}" type="presParOf" srcId="{06EFF909-DDEF-4515-93A5-FE48EDCB4200}" destId="{7E4E7EF2-8419-4AC3-BC4A-FEBB76D26FCF}" srcOrd="8" destOrd="0" presId="urn:microsoft.com/office/officeart/2005/8/layout/cycle1"/>
    <dgm:cxn modelId="{9DE9B6A5-B58E-4848-9AC9-C55D723BB8C0}" type="presParOf" srcId="{06EFF909-DDEF-4515-93A5-FE48EDCB4200}" destId="{6AF17485-D839-4973-91CF-9A647E0CE8CE}" srcOrd="9" destOrd="0" presId="urn:microsoft.com/office/officeart/2005/8/layout/cycle1"/>
    <dgm:cxn modelId="{4245C17E-A354-415B-A42C-1BA5A9116652}" type="presParOf" srcId="{06EFF909-DDEF-4515-93A5-FE48EDCB4200}" destId="{C5D1478B-3DF9-4F88-9386-06D6F1D70D7C}" srcOrd="10" destOrd="0" presId="urn:microsoft.com/office/officeart/2005/8/layout/cycle1"/>
    <dgm:cxn modelId="{25BAB14F-157A-47E4-9006-8A8F6B9E6A62}" type="presParOf" srcId="{06EFF909-DDEF-4515-93A5-FE48EDCB4200}" destId="{CBEC7562-3EF2-438B-9B8E-B353ABC9D262}" srcOrd="11" destOrd="0" presId="urn:microsoft.com/office/officeart/2005/8/layout/cycle1"/>
    <dgm:cxn modelId="{38C7DDA0-20DA-4788-9EDF-BC828221B721}" type="presParOf" srcId="{06EFF909-DDEF-4515-93A5-FE48EDCB4200}" destId="{2E0CB526-68A6-4565-AFF9-A83BFC47EBD1}" srcOrd="12" destOrd="0" presId="urn:microsoft.com/office/officeart/2005/8/layout/cycle1"/>
    <dgm:cxn modelId="{763C565F-0A05-4FF6-9299-84C0BEF8DA9C}" type="presParOf" srcId="{06EFF909-DDEF-4515-93A5-FE48EDCB4200}" destId="{A716A197-9A4D-4EBE-9F4D-40044665010E}" srcOrd="13" destOrd="0" presId="urn:microsoft.com/office/officeart/2005/8/layout/cycle1"/>
    <dgm:cxn modelId="{5709A878-3467-4146-AD69-16AABC3B04E8}" type="presParOf" srcId="{06EFF909-DDEF-4515-93A5-FE48EDCB4200}" destId="{6B4827B4-378F-4DED-B815-A396804F439C}" srcOrd="14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8B261E96-2B8F-43BF-BD5C-0C4912B98776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3AE1EBA0-0F6A-447D-B9AA-B79D696950AB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gm:t>
    </dgm:pt>
    <dgm:pt modelId="{4881C3BC-C9D9-4F26-B36D-4C18A4BE5197}" type="par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2DF1FEB-E23C-4131-BF68-7CA5FC571772}" type="sib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1B478C-9EAA-4288-95CF-FF2106F146BE}">
      <dgm:prSet phldrT="[Text]"/>
      <dgm:spPr>
        <a:solidFill>
          <a:schemeClr val="bg2"/>
        </a:solidFill>
      </dgm:spPr>
      <dgm:t>
        <a:bodyPr/>
        <a:lstStyle/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gm:t>
    </dgm:pt>
    <dgm:pt modelId="{83CBD108-C3CA-46C0-884D-12E68342F261}" type="par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17B51FF-BC69-4E04-81AB-6DA1B7FDAA9F}" type="sib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6B5D8C0-AB7C-4D34-A856-2F3F8474D796}">
      <dgm:prSet phldrT="[Text]"/>
      <dgm:spPr>
        <a:solidFill>
          <a:schemeClr val="bg2">
            <a:lumMod val="25000"/>
          </a:schemeClr>
        </a:solidFill>
      </dgm:spPr>
      <dgm:t>
        <a:bodyPr/>
        <a:lstStyle/>
        <a:p>
          <a:r>
            <a:rPr lang="en-US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gm:t>
    </dgm:pt>
    <dgm:pt modelId="{AD7891D8-089E-4CD5-B30F-1B01264AA27D}" type="par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3A76733-7ABD-4520-88E4-D24FFB74F67F}" type="sib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04C54B-3D46-4DF9-91E5-0B5989AD910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gm:t>
    </dgm:pt>
    <dgm:pt modelId="{882B2ADD-E3DA-4146-A2FA-929056F93521}" type="par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845E7A-E8FD-48B8-A9C7-062FF0666164}" type="sib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7FE8CD3-AEC0-411E-B74A-001D323F3AC9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gm:t>
    </dgm:pt>
    <dgm:pt modelId="{4A773196-8155-48AC-8E13-E5F09228253C}" type="par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A2E692-B5BE-4606-8C3A-457AFD02982C}" type="sib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EFF909-DDEF-4515-93A5-FE48EDCB4200}" type="pres">
      <dgm:prSet presAssocID="{8B261E96-2B8F-43BF-BD5C-0C4912B98776}" presName="cycle" presStyleCnt="0">
        <dgm:presLayoutVars>
          <dgm:dir/>
          <dgm:resizeHandles val="exact"/>
        </dgm:presLayoutVars>
      </dgm:prSet>
      <dgm:spPr/>
    </dgm:pt>
    <dgm:pt modelId="{96D3859A-93FB-4B2D-821F-C5B3713ECD62}" type="pres">
      <dgm:prSet presAssocID="{3AE1EBA0-0F6A-447D-B9AA-B79D696950AB}" presName="dummy" presStyleCnt="0"/>
      <dgm:spPr/>
    </dgm:pt>
    <dgm:pt modelId="{C0590FB8-714B-4522-BA97-989C54126878}" type="pres">
      <dgm:prSet presAssocID="{3AE1EBA0-0F6A-447D-B9AA-B79D696950AB}" presName="node" presStyleLbl="revTx" presStyleIdx="0" presStyleCnt="5">
        <dgm:presLayoutVars>
          <dgm:bulletEnabled val="1"/>
        </dgm:presLayoutVars>
      </dgm:prSet>
      <dgm:spPr/>
    </dgm:pt>
    <dgm:pt modelId="{AC91F25E-DDBF-437B-9FFE-5B9CAC749C61}" type="pres">
      <dgm:prSet presAssocID="{12DF1FEB-E23C-4131-BF68-7CA5FC571772}" presName="sibTrans" presStyleLbl="node1" presStyleIdx="0" presStyleCnt="5"/>
      <dgm:spPr/>
    </dgm:pt>
    <dgm:pt modelId="{653EF67A-834D-4F18-9DC6-00AFA14C62AE}" type="pres">
      <dgm:prSet presAssocID="{4A1B478C-9EAA-4288-95CF-FF2106F146BE}" presName="dummy" presStyleCnt="0"/>
      <dgm:spPr/>
    </dgm:pt>
    <dgm:pt modelId="{508389B2-0D19-4900-B9C9-66F95B20F2F1}" type="pres">
      <dgm:prSet presAssocID="{4A1B478C-9EAA-4288-95CF-FF2106F146BE}" presName="node" presStyleLbl="revTx" presStyleIdx="1" presStyleCnt="5">
        <dgm:presLayoutVars>
          <dgm:bulletEnabled val="1"/>
        </dgm:presLayoutVars>
      </dgm:prSet>
      <dgm:spPr/>
    </dgm:pt>
    <dgm:pt modelId="{1AD0943B-A1A6-4BDA-9062-80F39E7A1C7B}" type="pres">
      <dgm:prSet presAssocID="{317B51FF-BC69-4E04-81AB-6DA1B7FDAA9F}" presName="sibTrans" presStyleLbl="node1" presStyleIdx="1" presStyleCnt="5"/>
      <dgm:spPr/>
    </dgm:pt>
    <dgm:pt modelId="{A4F3001E-0B9D-480E-8555-86F345ECA762}" type="pres">
      <dgm:prSet presAssocID="{26B5D8C0-AB7C-4D34-A856-2F3F8474D796}" presName="dummy" presStyleCnt="0"/>
      <dgm:spPr/>
    </dgm:pt>
    <dgm:pt modelId="{8E8544CC-D122-438F-8CFB-19B02956CE5A}" type="pres">
      <dgm:prSet presAssocID="{26B5D8C0-AB7C-4D34-A856-2F3F8474D796}" presName="node" presStyleLbl="revTx" presStyleIdx="2" presStyleCnt="5">
        <dgm:presLayoutVars>
          <dgm:bulletEnabled val="1"/>
        </dgm:presLayoutVars>
      </dgm:prSet>
      <dgm:spPr/>
    </dgm:pt>
    <dgm:pt modelId="{7E4E7EF2-8419-4AC3-BC4A-FEBB76D26FCF}" type="pres">
      <dgm:prSet presAssocID="{63A76733-7ABD-4520-88E4-D24FFB74F67F}" presName="sibTrans" presStyleLbl="node1" presStyleIdx="2" presStyleCnt="5"/>
      <dgm:spPr/>
    </dgm:pt>
    <dgm:pt modelId="{6AF17485-D839-4973-91CF-9A647E0CE8CE}" type="pres">
      <dgm:prSet presAssocID="{3C04C54B-3D46-4DF9-91E5-0B5989AD9106}" presName="dummy" presStyleCnt="0"/>
      <dgm:spPr/>
    </dgm:pt>
    <dgm:pt modelId="{C5D1478B-3DF9-4F88-9386-06D6F1D70D7C}" type="pres">
      <dgm:prSet presAssocID="{3C04C54B-3D46-4DF9-91E5-0B5989AD9106}" presName="node" presStyleLbl="revTx" presStyleIdx="3" presStyleCnt="5">
        <dgm:presLayoutVars>
          <dgm:bulletEnabled val="1"/>
        </dgm:presLayoutVars>
      </dgm:prSet>
      <dgm:spPr/>
    </dgm:pt>
    <dgm:pt modelId="{CBEC7562-3EF2-438B-9B8E-B353ABC9D262}" type="pres">
      <dgm:prSet presAssocID="{6E845E7A-E8FD-48B8-A9C7-062FF0666164}" presName="sibTrans" presStyleLbl="node1" presStyleIdx="3" presStyleCnt="5"/>
      <dgm:spPr/>
    </dgm:pt>
    <dgm:pt modelId="{2E0CB526-68A6-4565-AFF9-A83BFC47EBD1}" type="pres">
      <dgm:prSet presAssocID="{B7FE8CD3-AEC0-411E-B74A-001D323F3AC9}" presName="dummy" presStyleCnt="0"/>
      <dgm:spPr/>
    </dgm:pt>
    <dgm:pt modelId="{A716A197-9A4D-4EBE-9F4D-40044665010E}" type="pres">
      <dgm:prSet presAssocID="{B7FE8CD3-AEC0-411E-B74A-001D323F3AC9}" presName="node" presStyleLbl="revTx" presStyleIdx="4" presStyleCnt="5">
        <dgm:presLayoutVars>
          <dgm:bulletEnabled val="1"/>
        </dgm:presLayoutVars>
      </dgm:prSet>
      <dgm:spPr/>
    </dgm:pt>
    <dgm:pt modelId="{6B4827B4-378F-4DED-B815-A396804F439C}" type="pres">
      <dgm:prSet presAssocID="{70A2E692-B5BE-4606-8C3A-457AFD02982C}" presName="sibTrans" presStyleLbl="node1" presStyleIdx="4" presStyleCnt="5"/>
      <dgm:spPr/>
    </dgm:pt>
  </dgm:ptLst>
  <dgm:cxnLst>
    <dgm:cxn modelId="{1635C810-649C-409B-8DA5-473E195D4E14}" srcId="{8B261E96-2B8F-43BF-BD5C-0C4912B98776}" destId="{4A1B478C-9EAA-4288-95CF-FF2106F146BE}" srcOrd="1" destOrd="0" parTransId="{83CBD108-C3CA-46C0-884D-12E68342F261}" sibTransId="{317B51FF-BC69-4E04-81AB-6DA1B7FDAA9F}"/>
    <dgm:cxn modelId="{E2E1C015-53CE-440C-A9CE-3F4ECCBCF219}" type="presOf" srcId="{3AE1EBA0-0F6A-447D-B9AA-B79D696950AB}" destId="{C0590FB8-714B-4522-BA97-989C54126878}" srcOrd="0" destOrd="0" presId="urn:microsoft.com/office/officeart/2005/8/layout/cycle1"/>
    <dgm:cxn modelId="{3094581E-2B8F-443F-94EE-1FAF01F27546}" type="presOf" srcId="{8B261E96-2B8F-43BF-BD5C-0C4912B98776}" destId="{06EFF909-DDEF-4515-93A5-FE48EDCB4200}" srcOrd="0" destOrd="0" presId="urn:microsoft.com/office/officeart/2005/8/layout/cycle1"/>
    <dgm:cxn modelId="{8C6D034A-F0C0-4555-B87E-FF77FAC5E487}" srcId="{8B261E96-2B8F-43BF-BD5C-0C4912B98776}" destId="{3C04C54B-3D46-4DF9-91E5-0B5989AD9106}" srcOrd="3" destOrd="0" parTransId="{882B2ADD-E3DA-4146-A2FA-929056F93521}" sibTransId="{6E845E7A-E8FD-48B8-A9C7-062FF0666164}"/>
    <dgm:cxn modelId="{8EFBD85E-73EC-46BA-BC90-1CC88DF69CCF}" type="presOf" srcId="{3C04C54B-3D46-4DF9-91E5-0B5989AD9106}" destId="{C5D1478B-3DF9-4F88-9386-06D6F1D70D7C}" srcOrd="0" destOrd="0" presId="urn:microsoft.com/office/officeart/2005/8/layout/cycle1"/>
    <dgm:cxn modelId="{21F59369-655C-43D0-A69D-CAE33E025C1A}" srcId="{8B261E96-2B8F-43BF-BD5C-0C4912B98776}" destId="{3AE1EBA0-0F6A-447D-B9AA-B79D696950AB}" srcOrd="0" destOrd="0" parTransId="{4881C3BC-C9D9-4F26-B36D-4C18A4BE5197}" sibTransId="{12DF1FEB-E23C-4131-BF68-7CA5FC571772}"/>
    <dgm:cxn modelId="{66258F82-B33B-4B84-81BF-6AACF240E972}" type="presOf" srcId="{317B51FF-BC69-4E04-81AB-6DA1B7FDAA9F}" destId="{1AD0943B-A1A6-4BDA-9062-80F39E7A1C7B}" srcOrd="0" destOrd="0" presId="urn:microsoft.com/office/officeart/2005/8/layout/cycle1"/>
    <dgm:cxn modelId="{C01078A0-21A0-47D6-B6E8-CA050C9592A4}" type="presOf" srcId="{6E845E7A-E8FD-48B8-A9C7-062FF0666164}" destId="{CBEC7562-3EF2-438B-9B8E-B353ABC9D262}" srcOrd="0" destOrd="0" presId="urn:microsoft.com/office/officeart/2005/8/layout/cycle1"/>
    <dgm:cxn modelId="{7AFB57B9-4C28-4DA6-B80B-9A2FEE2C45E8}" srcId="{8B261E96-2B8F-43BF-BD5C-0C4912B98776}" destId="{B7FE8CD3-AEC0-411E-B74A-001D323F3AC9}" srcOrd="4" destOrd="0" parTransId="{4A773196-8155-48AC-8E13-E5F09228253C}" sibTransId="{70A2E692-B5BE-4606-8C3A-457AFD02982C}"/>
    <dgm:cxn modelId="{2148AABE-C736-4970-BAC0-212550455B4C}" type="presOf" srcId="{26B5D8C0-AB7C-4D34-A856-2F3F8474D796}" destId="{8E8544CC-D122-438F-8CFB-19B02956CE5A}" srcOrd="0" destOrd="0" presId="urn:microsoft.com/office/officeart/2005/8/layout/cycle1"/>
    <dgm:cxn modelId="{5DE79AD6-9B6F-4689-A196-E4BCCC91CDEF}" srcId="{8B261E96-2B8F-43BF-BD5C-0C4912B98776}" destId="{26B5D8C0-AB7C-4D34-A856-2F3F8474D796}" srcOrd="2" destOrd="0" parTransId="{AD7891D8-089E-4CD5-B30F-1B01264AA27D}" sibTransId="{63A76733-7ABD-4520-88E4-D24FFB74F67F}"/>
    <dgm:cxn modelId="{2A809EDE-7A28-4548-9990-16452B478BF4}" type="presOf" srcId="{4A1B478C-9EAA-4288-95CF-FF2106F146BE}" destId="{508389B2-0D19-4900-B9C9-66F95B20F2F1}" srcOrd="0" destOrd="0" presId="urn:microsoft.com/office/officeart/2005/8/layout/cycle1"/>
    <dgm:cxn modelId="{4D69D5E5-68AF-4777-87B1-81A324E3C3C1}" type="presOf" srcId="{12DF1FEB-E23C-4131-BF68-7CA5FC571772}" destId="{AC91F25E-DDBF-437B-9FFE-5B9CAC749C61}" srcOrd="0" destOrd="0" presId="urn:microsoft.com/office/officeart/2005/8/layout/cycle1"/>
    <dgm:cxn modelId="{551E3DED-16AE-4C77-B3F7-38378C0B9459}" type="presOf" srcId="{70A2E692-B5BE-4606-8C3A-457AFD02982C}" destId="{6B4827B4-378F-4DED-B815-A396804F439C}" srcOrd="0" destOrd="0" presId="urn:microsoft.com/office/officeart/2005/8/layout/cycle1"/>
    <dgm:cxn modelId="{22C838EF-D9C6-4FB0-8FEA-4A293A299CB5}" type="presOf" srcId="{63A76733-7ABD-4520-88E4-D24FFB74F67F}" destId="{7E4E7EF2-8419-4AC3-BC4A-FEBB76D26FCF}" srcOrd="0" destOrd="0" presId="urn:microsoft.com/office/officeart/2005/8/layout/cycle1"/>
    <dgm:cxn modelId="{4B6149FA-CDCD-4075-B0D9-F047EA8D9EE9}" type="presOf" srcId="{B7FE8CD3-AEC0-411E-B74A-001D323F3AC9}" destId="{A716A197-9A4D-4EBE-9F4D-40044665010E}" srcOrd="0" destOrd="0" presId="urn:microsoft.com/office/officeart/2005/8/layout/cycle1"/>
    <dgm:cxn modelId="{4263E2D5-8950-4525-9310-8736C49AD2EA}" type="presParOf" srcId="{06EFF909-DDEF-4515-93A5-FE48EDCB4200}" destId="{96D3859A-93FB-4B2D-821F-C5B3713ECD62}" srcOrd="0" destOrd="0" presId="urn:microsoft.com/office/officeart/2005/8/layout/cycle1"/>
    <dgm:cxn modelId="{CD814C8D-FF63-4C57-88E4-AFF373793E36}" type="presParOf" srcId="{06EFF909-DDEF-4515-93A5-FE48EDCB4200}" destId="{C0590FB8-714B-4522-BA97-989C54126878}" srcOrd="1" destOrd="0" presId="urn:microsoft.com/office/officeart/2005/8/layout/cycle1"/>
    <dgm:cxn modelId="{B2ABE2DB-D6D3-42D8-B64E-F3756B389A26}" type="presParOf" srcId="{06EFF909-DDEF-4515-93A5-FE48EDCB4200}" destId="{AC91F25E-DDBF-437B-9FFE-5B9CAC749C61}" srcOrd="2" destOrd="0" presId="urn:microsoft.com/office/officeart/2005/8/layout/cycle1"/>
    <dgm:cxn modelId="{60141F03-5C53-4CF7-8D89-7F261E2EE812}" type="presParOf" srcId="{06EFF909-DDEF-4515-93A5-FE48EDCB4200}" destId="{653EF67A-834D-4F18-9DC6-00AFA14C62AE}" srcOrd="3" destOrd="0" presId="urn:microsoft.com/office/officeart/2005/8/layout/cycle1"/>
    <dgm:cxn modelId="{D9C18CD0-F368-4A29-BBC1-A5817FFECB5C}" type="presParOf" srcId="{06EFF909-DDEF-4515-93A5-FE48EDCB4200}" destId="{508389B2-0D19-4900-B9C9-66F95B20F2F1}" srcOrd="4" destOrd="0" presId="urn:microsoft.com/office/officeart/2005/8/layout/cycle1"/>
    <dgm:cxn modelId="{8DB3C285-A3E4-48CF-986E-8F6CC04999BA}" type="presParOf" srcId="{06EFF909-DDEF-4515-93A5-FE48EDCB4200}" destId="{1AD0943B-A1A6-4BDA-9062-80F39E7A1C7B}" srcOrd="5" destOrd="0" presId="urn:microsoft.com/office/officeart/2005/8/layout/cycle1"/>
    <dgm:cxn modelId="{3DD56884-39AA-4B9F-BC72-DDD15F833CDA}" type="presParOf" srcId="{06EFF909-DDEF-4515-93A5-FE48EDCB4200}" destId="{A4F3001E-0B9D-480E-8555-86F345ECA762}" srcOrd="6" destOrd="0" presId="urn:microsoft.com/office/officeart/2005/8/layout/cycle1"/>
    <dgm:cxn modelId="{A51A6F77-C936-4541-B6F4-F89038C26AAA}" type="presParOf" srcId="{06EFF909-DDEF-4515-93A5-FE48EDCB4200}" destId="{8E8544CC-D122-438F-8CFB-19B02956CE5A}" srcOrd="7" destOrd="0" presId="urn:microsoft.com/office/officeart/2005/8/layout/cycle1"/>
    <dgm:cxn modelId="{81A32057-A911-4A73-B271-26D092E9AFAF}" type="presParOf" srcId="{06EFF909-DDEF-4515-93A5-FE48EDCB4200}" destId="{7E4E7EF2-8419-4AC3-BC4A-FEBB76D26FCF}" srcOrd="8" destOrd="0" presId="urn:microsoft.com/office/officeart/2005/8/layout/cycle1"/>
    <dgm:cxn modelId="{9DE9B6A5-B58E-4848-9AC9-C55D723BB8C0}" type="presParOf" srcId="{06EFF909-DDEF-4515-93A5-FE48EDCB4200}" destId="{6AF17485-D839-4973-91CF-9A647E0CE8CE}" srcOrd="9" destOrd="0" presId="urn:microsoft.com/office/officeart/2005/8/layout/cycle1"/>
    <dgm:cxn modelId="{4245C17E-A354-415B-A42C-1BA5A9116652}" type="presParOf" srcId="{06EFF909-DDEF-4515-93A5-FE48EDCB4200}" destId="{C5D1478B-3DF9-4F88-9386-06D6F1D70D7C}" srcOrd="10" destOrd="0" presId="urn:microsoft.com/office/officeart/2005/8/layout/cycle1"/>
    <dgm:cxn modelId="{25BAB14F-157A-47E4-9006-8A8F6B9E6A62}" type="presParOf" srcId="{06EFF909-DDEF-4515-93A5-FE48EDCB4200}" destId="{CBEC7562-3EF2-438B-9B8E-B353ABC9D262}" srcOrd="11" destOrd="0" presId="urn:microsoft.com/office/officeart/2005/8/layout/cycle1"/>
    <dgm:cxn modelId="{38C7DDA0-20DA-4788-9EDF-BC828221B721}" type="presParOf" srcId="{06EFF909-DDEF-4515-93A5-FE48EDCB4200}" destId="{2E0CB526-68A6-4565-AFF9-A83BFC47EBD1}" srcOrd="12" destOrd="0" presId="urn:microsoft.com/office/officeart/2005/8/layout/cycle1"/>
    <dgm:cxn modelId="{763C565F-0A05-4FF6-9299-84C0BEF8DA9C}" type="presParOf" srcId="{06EFF909-DDEF-4515-93A5-FE48EDCB4200}" destId="{A716A197-9A4D-4EBE-9F4D-40044665010E}" srcOrd="13" destOrd="0" presId="urn:microsoft.com/office/officeart/2005/8/layout/cycle1"/>
    <dgm:cxn modelId="{5709A878-3467-4146-AD69-16AABC3B04E8}" type="presParOf" srcId="{06EFF909-DDEF-4515-93A5-FE48EDCB4200}" destId="{6B4827B4-378F-4DED-B815-A396804F439C}" srcOrd="14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8B261E96-2B8F-43BF-BD5C-0C4912B98776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3AE1EBA0-0F6A-447D-B9AA-B79D696950AB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gm:t>
    </dgm:pt>
    <dgm:pt modelId="{4881C3BC-C9D9-4F26-B36D-4C18A4BE5197}" type="par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2DF1FEB-E23C-4131-BF68-7CA5FC571772}" type="sib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1B478C-9EAA-4288-95CF-FF2106F146BE}">
      <dgm:prSet phldrT="[Text]"/>
      <dgm:spPr>
        <a:solidFill>
          <a:schemeClr val="bg2"/>
        </a:solidFill>
      </dgm:spPr>
      <dgm:t>
        <a:bodyPr/>
        <a:lstStyle/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gm:t>
    </dgm:pt>
    <dgm:pt modelId="{83CBD108-C3CA-46C0-884D-12E68342F261}" type="par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17B51FF-BC69-4E04-81AB-6DA1B7FDAA9F}" type="sib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6B5D8C0-AB7C-4D34-A856-2F3F8474D79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Engage patients and providers</a:t>
          </a:r>
        </a:p>
      </dgm:t>
    </dgm:pt>
    <dgm:pt modelId="{AD7891D8-089E-4CD5-B30F-1B01264AA27D}" type="par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3A76733-7ABD-4520-88E4-D24FFB74F67F}" type="sib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04C54B-3D46-4DF9-91E5-0B5989AD9106}">
      <dgm:prSet phldrT="[Text]"/>
      <dgm:spPr>
        <a:solidFill>
          <a:schemeClr val="bg2">
            <a:lumMod val="25000"/>
          </a:schemeClr>
        </a:solidFill>
      </dgm:spPr>
      <dgm:t>
        <a:bodyPr/>
        <a:lstStyle/>
        <a:p>
          <a:r>
            <a:rPr lang="en-US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gm:t>
    </dgm:pt>
    <dgm:pt modelId="{882B2ADD-E3DA-4146-A2FA-929056F93521}" type="par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845E7A-E8FD-48B8-A9C7-062FF0666164}" type="sib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7FE8CD3-AEC0-411E-B74A-001D323F3AC9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gm:t>
    </dgm:pt>
    <dgm:pt modelId="{4A773196-8155-48AC-8E13-E5F09228253C}" type="par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A2E692-B5BE-4606-8C3A-457AFD02982C}" type="sib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EFF909-DDEF-4515-93A5-FE48EDCB4200}" type="pres">
      <dgm:prSet presAssocID="{8B261E96-2B8F-43BF-BD5C-0C4912B98776}" presName="cycle" presStyleCnt="0">
        <dgm:presLayoutVars>
          <dgm:dir/>
          <dgm:resizeHandles val="exact"/>
        </dgm:presLayoutVars>
      </dgm:prSet>
      <dgm:spPr/>
    </dgm:pt>
    <dgm:pt modelId="{96D3859A-93FB-4B2D-821F-C5B3713ECD62}" type="pres">
      <dgm:prSet presAssocID="{3AE1EBA0-0F6A-447D-B9AA-B79D696950AB}" presName="dummy" presStyleCnt="0"/>
      <dgm:spPr/>
    </dgm:pt>
    <dgm:pt modelId="{C0590FB8-714B-4522-BA97-989C54126878}" type="pres">
      <dgm:prSet presAssocID="{3AE1EBA0-0F6A-447D-B9AA-B79D696950AB}" presName="node" presStyleLbl="revTx" presStyleIdx="0" presStyleCnt="5">
        <dgm:presLayoutVars>
          <dgm:bulletEnabled val="1"/>
        </dgm:presLayoutVars>
      </dgm:prSet>
      <dgm:spPr/>
    </dgm:pt>
    <dgm:pt modelId="{AC91F25E-DDBF-437B-9FFE-5B9CAC749C61}" type="pres">
      <dgm:prSet presAssocID="{12DF1FEB-E23C-4131-BF68-7CA5FC571772}" presName="sibTrans" presStyleLbl="node1" presStyleIdx="0" presStyleCnt="5"/>
      <dgm:spPr/>
    </dgm:pt>
    <dgm:pt modelId="{653EF67A-834D-4F18-9DC6-00AFA14C62AE}" type="pres">
      <dgm:prSet presAssocID="{4A1B478C-9EAA-4288-95CF-FF2106F146BE}" presName="dummy" presStyleCnt="0"/>
      <dgm:spPr/>
    </dgm:pt>
    <dgm:pt modelId="{508389B2-0D19-4900-B9C9-66F95B20F2F1}" type="pres">
      <dgm:prSet presAssocID="{4A1B478C-9EAA-4288-95CF-FF2106F146BE}" presName="node" presStyleLbl="revTx" presStyleIdx="1" presStyleCnt="5">
        <dgm:presLayoutVars>
          <dgm:bulletEnabled val="1"/>
        </dgm:presLayoutVars>
      </dgm:prSet>
      <dgm:spPr/>
    </dgm:pt>
    <dgm:pt modelId="{1AD0943B-A1A6-4BDA-9062-80F39E7A1C7B}" type="pres">
      <dgm:prSet presAssocID="{317B51FF-BC69-4E04-81AB-6DA1B7FDAA9F}" presName="sibTrans" presStyleLbl="node1" presStyleIdx="1" presStyleCnt="5"/>
      <dgm:spPr/>
    </dgm:pt>
    <dgm:pt modelId="{A4F3001E-0B9D-480E-8555-86F345ECA762}" type="pres">
      <dgm:prSet presAssocID="{26B5D8C0-AB7C-4D34-A856-2F3F8474D796}" presName="dummy" presStyleCnt="0"/>
      <dgm:spPr/>
    </dgm:pt>
    <dgm:pt modelId="{8E8544CC-D122-438F-8CFB-19B02956CE5A}" type="pres">
      <dgm:prSet presAssocID="{26B5D8C0-AB7C-4D34-A856-2F3F8474D796}" presName="node" presStyleLbl="revTx" presStyleIdx="2" presStyleCnt="5">
        <dgm:presLayoutVars>
          <dgm:bulletEnabled val="1"/>
        </dgm:presLayoutVars>
      </dgm:prSet>
      <dgm:spPr/>
    </dgm:pt>
    <dgm:pt modelId="{7E4E7EF2-8419-4AC3-BC4A-FEBB76D26FCF}" type="pres">
      <dgm:prSet presAssocID="{63A76733-7ABD-4520-88E4-D24FFB74F67F}" presName="sibTrans" presStyleLbl="node1" presStyleIdx="2" presStyleCnt="5"/>
      <dgm:spPr/>
    </dgm:pt>
    <dgm:pt modelId="{6AF17485-D839-4973-91CF-9A647E0CE8CE}" type="pres">
      <dgm:prSet presAssocID="{3C04C54B-3D46-4DF9-91E5-0B5989AD9106}" presName="dummy" presStyleCnt="0"/>
      <dgm:spPr/>
    </dgm:pt>
    <dgm:pt modelId="{C5D1478B-3DF9-4F88-9386-06D6F1D70D7C}" type="pres">
      <dgm:prSet presAssocID="{3C04C54B-3D46-4DF9-91E5-0B5989AD9106}" presName="node" presStyleLbl="revTx" presStyleIdx="3" presStyleCnt="5">
        <dgm:presLayoutVars>
          <dgm:bulletEnabled val="1"/>
        </dgm:presLayoutVars>
      </dgm:prSet>
      <dgm:spPr/>
    </dgm:pt>
    <dgm:pt modelId="{CBEC7562-3EF2-438B-9B8E-B353ABC9D262}" type="pres">
      <dgm:prSet presAssocID="{6E845E7A-E8FD-48B8-A9C7-062FF0666164}" presName="sibTrans" presStyleLbl="node1" presStyleIdx="3" presStyleCnt="5"/>
      <dgm:spPr/>
    </dgm:pt>
    <dgm:pt modelId="{2E0CB526-68A6-4565-AFF9-A83BFC47EBD1}" type="pres">
      <dgm:prSet presAssocID="{B7FE8CD3-AEC0-411E-B74A-001D323F3AC9}" presName="dummy" presStyleCnt="0"/>
      <dgm:spPr/>
    </dgm:pt>
    <dgm:pt modelId="{A716A197-9A4D-4EBE-9F4D-40044665010E}" type="pres">
      <dgm:prSet presAssocID="{B7FE8CD3-AEC0-411E-B74A-001D323F3AC9}" presName="node" presStyleLbl="revTx" presStyleIdx="4" presStyleCnt="5">
        <dgm:presLayoutVars>
          <dgm:bulletEnabled val="1"/>
        </dgm:presLayoutVars>
      </dgm:prSet>
      <dgm:spPr/>
    </dgm:pt>
    <dgm:pt modelId="{6B4827B4-378F-4DED-B815-A396804F439C}" type="pres">
      <dgm:prSet presAssocID="{70A2E692-B5BE-4606-8C3A-457AFD02982C}" presName="sibTrans" presStyleLbl="node1" presStyleIdx="4" presStyleCnt="5"/>
      <dgm:spPr/>
    </dgm:pt>
  </dgm:ptLst>
  <dgm:cxnLst>
    <dgm:cxn modelId="{1635C810-649C-409B-8DA5-473E195D4E14}" srcId="{8B261E96-2B8F-43BF-BD5C-0C4912B98776}" destId="{4A1B478C-9EAA-4288-95CF-FF2106F146BE}" srcOrd="1" destOrd="0" parTransId="{83CBD108-C3CA-46C0-884D-12E68342F261}" sibTransId="{317B51FF-BC69-4E04-81AB-6DA1B7FDAA9F}"/>
    <dgm:cxn modelId="{E2E1C015-53CE-440C-A9CE-3F4ECCBCF219}" type="presOf" srcId="{3AE1EBA0-0F6A-447D-B9AA-B79D696950AB}" destId="{C0590FB8-714B-4522-BA97-989C54126878}" srcOrd="0" destOrd="0" presId="urn:microsoft.com/office/officeart/2005/8/layout/cycle1"/>
    <dgm:cxn modelId="{3094581E-2B8F-443F-94EE-1FAF01F27546}" type="presOf" srcId="{8B261E96-2B8F-43BF-BD5C-0C4912B98776}" destId="{06EFF909-DDEF-4515-93A5-FE48EDCB4200}" srcOrd="0" destOrd="0" presId="urn:microsoft.com/office/officeart/2005/8/layout/cycle1"/>
    <dgm:cxn modelId="{8C6D034A-F0C0-4555-B87E-FF77FAC5E487}" srcId="{8B261E96-2B8F-43BF-BD5C-0C4912B98776}" destId="{3C04C54B-3D46-4DF9-91E5-0B5989AD9106}" srcOrd="3" destOrd="0" parTransId="{882B2ADD-E3DA-4146-A2FA-929056F93521}" sibTransId="{6E845E7A-E8FD-48B8-A9C7-062FF0666164}"/>
    <dgm:cxn modelId="{8EFBD85E-73EC-46BA-BC90-1CC88DF69CCF}" type="presOf" srcId="{3C04C54B-3D46-4DF9-91E5-0B5989AD9106}" destId="{C5D1478B-3DF9-4F88-9386-06D6F1D70D7C}" srcOrd="0" destOrd="0" presId="urn:microsoft.com/office/officeart/2005/8/layout/cycle1"/>
    <dgm:cxn modelId="{21F59369-655C-43D0-A69D-CAE33E025C1A}" srcId="{8B261E96-2B8F-43BF-BD5C-0C4912B98776}" destId="{3AE1EBA0-0F6A-447D-B9AA-B79D696950AB}" srcOrd="0" destOrd="0" parTransId="{4881C3BC-C9D9-4F26-B36D-4C18A4BE5197}" sibTransId="{12DF1FEB-E23C-4131-BF68-7CA5FC571772}"/>
    <dgm:cxn modelId="{66258F82-B33B-4B84-81BF-6AACF240E972}" type="presOf" srcId="{317B51FF-BC69-4E04-81AB-6DA1B7FDAA9F}" destId="{1AD0943B-A1A6-4BDA-9062-80F39E7A1C7B}" srcOrd="0" destOrd="0" presId="urn:microsoft.com/office/officeart/2005/8/layout/cycle1"/>
    <dgm:cxn modelId="{C01078A0-21A0-47D6-B6E8-CA050C9592A4}" type="presOf" srcId="{6E845E7A-E8FD-48B8-A9C7-062FF0666164}" destId="{CBEC7562-3EF2-438B-9B8E-B353ABC9D262}" srcOrd="0" destOrd="0" presId="urn:microsoft.com/office/officeart/2005/8/layout/cycle1"/>
    <dgm:cxn modelId="{7AFB57B9-4C28-4DA6-B80B-9A2FEE2C45E8}" srcId="{8B261E96-2B8F-43BF-BD5C-0C4912B98776}" destId="{B7FE8CD3-AEC0-411E-B74A-001D323F3AC9}" srcOrd="4" destOrd="0" parTransId="{4A773196-8155-48AC-8E13-E5F09228253C}" sibTransId="{70A2E692-B5BE-4606-8C3A-457AFD02982C}"/>
    <dgm:cxn modelId="{2148AABE-C736-4970-BAC0-212550455B4C}" type="presOf" srcId="{26B5D8C0-AB7C-4D34-A856-2F3F8474D796}" destId="{8E8544CC-D122-438F-8CFB-19B02956CE5A}" srcOrd="0" destOrd="0" presId="urn:microsoft.com/office/officeart/2005/8/layout/cycle1"/>
    <dgm:cxn modelId="{5DE79AD6-9B6F-4689-A196-E4BCCC91CDEF}" srcId="{8B261E96-2B8F-43BF-BD5C-0C4912B98776}" destId="{26B5D8C0-AB7C-4D34-A856-2F3F8474D796}" srcOrd="2" destOrd="0" parTransId="{AD7891D8-089E-4CD5-B30F-1B01264AA27D}" sibTransId="{63A76733-7ABD-4520-88E4-D24FFB74F67F}"/>
    <dgm:cxn modelId="{2A809EDE-7A28-4548-9990-16452B478BF4}" type="presOf" srcId="{4A1B478C-9EAA-4288-95CF-FF2106F146BE}" destId="{508389B2-0D19-4900-B9C9-66F95B20F2F1}" srcOrd="0" destOrd="0" presId="urn:microsoft.com/office/officeart/2005/8/layout/cycle1"/>
    <dgm:cxn modelId="{4D69D5E5-68AF-4777-87B1-81A324E3C3C1}" type="presOf" srcId="{12DF1FEB-E23C-4131-BF68-7CA5FC571772}" destId="{AC91F25E-DDBF-437B-9FFE-5B9CAC749C61}" srcOrd="0" destOrd="0" presId="urn:microsoft.com/office/officeart/2005/8/layout/cycle1"/>
    <dgm:cxn modelId="{551E3DED-16AE-4C77-B3F7-38378C0B9459}" type="presOf" srcId="{70A2E692-B5BE-4606-8C3A-457AFD02982C}" destId="{6B4827B4-378F-4DED-B815-A396804F439C}" srcOrd="0" destOrd="0" presId="urn:microsoft.com/office/officeart/2005/8/layout/cycle1"/>
    <dgm:cxn modelId="{22C838EF-D9C6-4FB0-8FEA-4A293A299CB5}" type="presOf" srcId="{63A76733-7ABD-4520-88E4-D24FFB74F67F}" destId="{7E4E7EF2-8419-4AC3-BC4A-FEBB76D26FCF}" srcOrd="0" destOrd="0" presId="urn:microsoft.com/office/officeart/2005/8/layout/cycle1"/>
    <dgm:cxn modelId="{4B6149FA-CDCD-4075-B0D9-F047EA8D9EE9}" type="presOf" srcId="{B7FE8CD3-AEC0-411E-B74A-001D323F3AC9}" destId="{A716A197-9A4D-4EBE-9F4D-40044665010E}" srcOrd="0" destOrd="0" presId="urn:microsoft.com/office/officeart/2005/8/layout/cycle1"/>
    <dgm:cxn modelId="{4263E2D5-8950-4525-9310-8736C49AD2EA}" type="presParOf" srcId="{06EFF909-DDEF-4515-93A5-FE48EDCB4200}" destId="{96D3859A-93FB-4B2D-821F-C5B3713ECD62}" srcOrd="0" destOrd="0" presId="urn:microsoft.com/office/officeart/2005/8/layout/cycle1"/>
    <dgm:cxn modelId="{CD814C8D-FF63-4C57-88E4-AFF373793E36}" type="presParOf" srcId="{06EFF909-DDEF-4515-93A5-FE48EDCB4200}" destId="{C0590FB8-714B-4522-BA97-989C54126878}" srcOrd="1" destOrd="0" presId="urn:microsoft.com/office/officeart/2005/8/layout/cycle1"/>
    <dgm:cxn modelId="{B2ABE2DB-D6D3-42D8-B64E-F3756B389A26}" type="presParOf" srcId="{06EFF909-DDEF-4515-93A5-FE48EDCB4200}" destId="{AC91F25E-DDBF-437B-9FFE-5B9CAC749C61}" srcOrd="2" destOrd="0" presId="urn:microsoft.com/office/officeart/2005/8/layout/cycle1"/>
    <dgm:cxn modelId="{60141F03-5C53-4CF7-8D89-7F261E2EE812}" type="presParOf" srcId="{06EFF909-DDEF-4515-93A5-FE48EDCB4200}" destId="{653EF67A-834D-4F18-9DC6-00AFA14C62AE}" srcOrd="3" destOrd="0" presId="urn:microsoft.com/office/officeart/2005/8/layout/cycle1"/>
    <dgm:cxn modelId="{D9C18CD0-F368-4A29-BBC1-A5817FFECB5C}" type="presParOf" srcId="{06EFF909-DDEF-4515-93A5-FE48EDCB4200}" destId="{508389B2-0D19-4900-B9C9-66F95B20F2F1}" srcOrd="4" destOrd="0" presId="urn:microsoft.com/office/officeart/2005/8/layout/cycle1"/>
    <dgm:cxn modelId="{8DB3C285-A3E4-48CF-986E-8F6CC04999BA}" type="presParOf" srcId="{06EFF909-DDEF-4515-93A5-FE48EDCB4200}" destId="{1AD0943B-A1A6-4BDA-9062-80F39E7A1C7B}" srcOrd="5" destOrd="0" presId="urn:microsoft.com/office/officeart/2005/8/layout/cycle1"/>
    <dgm:cxn modelId="{3DD56884-39AA-4B9F-BC72-DDD15F833CDA}" type="presParOf" srcId="{06EFF909-DDEF-4515-93A5-FE48EDCB4200}" destId="{A4F3001E-0B9D-480E-8555-86F345ECA762}" srcOrd="6" destOrd="0" presId="urn:microsoft.com/office/officeart/2005/8/layout/cycle1"/>
    <dgm:cxn modelId="{A51A6F77-C936-4541-B6F4-F89038C26AAA}" type="presParOf" srcId="{06EFF909-DDEF-4515-93A5-FE48EDCB4200}" destId="{8E8544CC-D122-438F-8CFB-19B02956CE5A}" srcOrd="7" destOrd="0" presId="urn:microsoft.com/office/officeart/2005/8/layout/cycle1"/>
    <dgm:cxn modelId="{81A32057-A911-4A73-B271-26D092E9AFAF}" type="presParOf" srcId="{06EFF909-DDEF-4515-93A5-FE48EDCB4200}" destId="{7E4E7EF2-8419-4AC3-BC4A-FEBB76D26FCF}" srcOrd="8" destOrd="0" presId="urn:microsoft.com/office/officeart/2005/8/layout/cycle1"/>
    <dgm:cxn modelId="{9DE9B6A5-B58E-4848-9AC9-C55D723BB8C0}" type="presParOf" srcId="{06EFF909-DDEF-4515-93A5-FE48EDCB4200}" destId="{6AF17485-D839-4973-91CF-9A647E0CE8CE}" srcOrd="9" destOrd="0" presId="urn:microsoft.com/office/officeart/2005/8/layout/cycle1"/>
    <dgm:cxn modelId="{4245C17E-A354-415B-A42C-1BA5A9116652}" type="presParOf" srcId="{06EFF909-DDEF-4515-93A5-FE48EDCB4200}" destId="{C5D1478B-3DF9-4F88-9386-06D6F1D70D7C}" srcOrd="10" destOrd="0" presId="urn:microsoft.com/office/officeart/2005/8/layout/cycle1"/>
    <dgm:cxn modelId="{25BAB14F-157A-47E4-9006-8A8F6B9E6A62}" type="presParOf" srcId="{06EFF909-DDEF-4515-93A5-FE48EDCB4200}" destId="{CBEC7562-3EF2-438B-9B8E-B353ABC9D262}" srcOrd="11" destOrd="0" presId="urn:microsoft.com/office/officeart/2005/8/layout/cycle1"/>
    <dgm:cxn modelId="{38C7DDA0-20DA-4788-9EDF-BC828221B721}" type="presParOf" srcId="{06EFF909-DDEF-4515-93A5-FE48EDCB4200}" destId="{2E0CB526-68A6-4565-AFF9-A83BFC47EBD1}" srcOrd="12" destOrd="0" presId="urn:microsoft.com/office/officeart/2005/8/layout/cycle1"/>
    <dgm:cxn modelId="{763C565F-0A05-4FF6-9299-84C0BEF8DA9C}" type="presParOf" srcId="{06EFF909-DDEF-4515-93A5-FE48EDCB4200}" destId="{A716A197-9A4D-4EBE-9F4D-40044665010E}" srcOrd="13" destOrd="0" presId="urn:microsoft.com/office/officeart/2005/8/layout/cycle1"/>
    <dgm:cxn modelId="{5709A878-3467-4146-AD69-16AABC3B04E8}" type="presParOf" srcId="{06EFF909-DDEF-4515-93A5-FE48EDCB4200}" destId="{6B4827B4-378F-4DED-B815-A396804F439C}" srcOrd="14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8B261E96-2B8F-43BF-BD5C-0C4912B98776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3AE1EBA0-0F6A-447D-B9AA-B79D696950AB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gm:t>
    </dgm:pt>
    <dgm:pt modelId="{4881C3BC-C9D9-4F26-B36D-4C18A4BE5197}" type="par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2DF1FEB-E23C-4131-BF68-7CA5FC571772}" type="sibTrans" cxnId="{21F59369-655C-43D0-A69D-CAE33E025C1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A1B478C-9EAA-4288-95CF-FF2106F146BE}">
      <dgm:prSet phldrT="[Text]"/>
      <dgm:spPr>
        <a:solidFill>
          <a:schemeClr val="bg2"/>
        </a:solidFill>
      </dgm:spPr>
      <dgm:t>
        <a:bodyPr/>
        <a:lstStyle/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rtl="0">
            <a:lnSpc>
              <a:spcPct val="100000"/>
            </a:lnSpc>
            <a:spcAft>
              <a:spcPts val="0"/>
            </a:spcAft>
          </a:pPr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gm:t>
    </dgm:pt>
    <dgm:pt modelId="{83CBD108-C3CA-46C0-884D-12E68342F261}" type="par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17B51FF-BC69-4E04-81AB-6DA1B7FDAA9F}" type="sibTrans" cxnId="{1635C810-649C-409B-8DA5-473E195D4E1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6B5D8C0-AB7C-4D34-A856-2F3F8474D79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Engage patients and providers</a:t>
          </a:r>
        </a:p>
      </dgm:t>
    </dgm:pt>
    <dgm:pt modelId="{AD7891D8-089E-4CD5-B30F-1B01264AA27D}" type="par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3A76733-7ABD-4520-88E4-D24FFB74F67F}" type="sibTrans" cxnId="{5DE79AD6-9B6F-4689-A196-E4BCCC91CDEF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04C54B-3D46-4DF9-91E5-0B5989AD9106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gm:t>
    </dgm:pt>
    <dgm:pt modelId="{882B2ADD-E3DA-4146-A2FA-929056F93521}" type="par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845E7A-E8FD-48B8-A9C7-062FF0666164}" type="sibTrans" cxnId="{8C6D034A-F0C0-4555-B87E-FF77FAC5E48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7FE8CD3-AEC0-411E-B74A-001D323F3AC9}">
      <dgm:prSet phldrT="[Text]"/>
      <dgm:spPr>
        <a:solidFill>
          <a:schemeClr val="bg2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gm:t>
    </dgm:pt>
    <dgm:pt modelId="{4A773196-8155-48AC-8E13-E5F09228253C}" type="par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A2E692-B5BE-4606-8C3A-457AFD02982C}" type="sibTrans" cxnId="{7AFB57B9-4C28-4DA6-B80B-9A2FEE2C45E8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EFF909-DDEF-4515-93A5-FE48EDCB4200}" type="pres">
      <dgm:prSet presAssocID="{8B261E96-2B8F-43BF-BD5C-0C4912B98776}" presName="cycle" presStyleCnt="0">
        <dgm:presLayoutVars>
          <dgm:dir/>
          <dgm:resizeHandles val="exact"/>
        </dgm:presLayoutVars>
      </dgm:prSet>
      <dgm:spPr/>
    </dgm:pt>
    <dgm:pt modelId="{96D3859A-93FB-4B2D-821F-C5B3713ECD62}" type="pres">
      <dgm:prSet presAssocID="{3AE1EBA0-0F6A-447D-B9AA-B79D696950AB}" presName="dummy" presStyleCnt="0"/>
      <dgm:spPr/>
    </dgm:pt>
    <dgm:pt modelId="{C0590FB8-714B-4522-BA97-989C54126878}" type="pres">
      <dgm:prSet presAssocID="{3AE1EBA0-0F6A-447D-B9AA-B79D696950AB}" presName="node" presStyleLbl="revTx" presStyleIdx="0" presStyleCnt="5">
        <dgm:presLayoutVars>
          <dgm:bulletEnabled val="1"/>
        </dgm:presLayoutVars>
      </dgm:prSet>
      <dgm:spPr/>
    </dgm:pt>
    <dgm:pt modelId="{AC91F25E-DDBF-437B-9FFE-5B9CAC749C61}" type="pres">
      <dgm:prSet presAssocID="{12DF1FEB-E23C-4131-BF68-7CA5FC571772}" presName="sibTrans" presStyleLbl="node1" presStyleIdx="0" presStyleCnt="5"/>
      <dgm:spPr/>
    </dgm:pt>
    <dgm:pt modelId="{653EF67A-834D-4F18-9DC6-00AFA14C62AE}" type="pres">
      <dgm:prSet presAssocID="{4A1B478C-9EAA-4288-95CF-FF2106F146BE}" presName="dummy" presStyleCnt="0"/>
      <dgm:spPr/>
    </dgm:pt>
    <dgm:pt modelId="{508389B2-0D19-4900-B9C9-66F95B20F2F1}" type="pres">
      <dgm:prSet presAssocID="{4A1B478C-9EAA-4288-95CF-FF2106F146BE}" presName="node" presStyleLbl="revTx" presStyleIdx="1" presStyleCnt="5">
        <dgm:presLayoutVars>
          <dgm:bulletEnabled val="1"/>
        </dgm:presLayoutVars>
      </dgm:prSet>
      <dgm:spPr/>
    </dgm:pt>
    <dgm:pt modelId="{1AD0943B-A1A6-4BDA-9062-80F39E7A1C7B}" type="pres">
      <dgm:prSet presAssocID="{317B51FF-BC69-4E04-81AB-6DA1B7FDAA9F}" presName="sibTrans" presStyleLbl="node1" presStyleIdx="1" presStyleCnt="5"/>
      <dgm:spPr/>
    </dgm:pt>
    <dgm:pt modelId="{A4F3001E-0B9D-480E-8555-86F345ECA762}" type="pres">
      <dgm:prSet presAssocID="{26B5D8C0-AB7C-4D34-A856-2F3F8474D796}" presName="dummy" presStyleCnt="0"/>
      <dgm:spPr/>
    </dgm:pt>
    <dgm:pt modelId="{8E8544CC-D122-438F-8CFB-19B02956CE5A}" type="pres">
      <dgm:prSet presAssocID="{26B5D8C0-AB7C-4D34-A856-2F3F8474D796}" presName="node" presStyleLbl="revTx" presStyleIdx="2" presStyleCnt="5">
        <dgm:presLayoutVars>
          <dgm:bulletEnabled val="1"/>
        </dgm:presLayoutVars>
      </dgm:prSet>
      <dgm:spPr/>
    </dgm:pt>
    <dgm:pt modelId="{7E4E7EF2-8419-4AC3-BC4A-FEBB76D26FCF}" type="pres">
      <dgm:prSet presAssocID="{63A76733-7ABD-4520-88E4-D24FFB74F67F}" presName="sibTrans" presStyleLbl="node1" presStyleIdx="2" presStyleCnt="5"/>
      <dgm:spPr/>
    </dgm:pt>
    <dgm:pt modelId="{6AF17485-D839-4973-91CF-9A647E0CE8CE}" type="pres">
      <dgm:prSet presAssocID="{3C04C54B-3D46-4DF9-91E5-0B5989AD9106}" presName="dummy" presStyleCnt="0"/>
      <dgm:spPr/>
    </dgm:pt>
    <dgm:pt modelId="{C5D1478B-3DF9-4F88-9386-06D6F1D70D7C}" type="pres">
      <dgm:prSet presAssocID="{3C04C54B-3D46-4DF9-91E5-0B5989AD9106}" presName="node" presStyleLbl="revTx" presStyleIdx="3" presStyleCnt="5">
        <dgm:presLayoutVars>
          <dgm:bulletEnabled val="1"/>
        </dgm:presLayoutVars>
      </dgm:prSet>
      <dgm:spPr/>
    </dgm:pt>
    <dgm:pt modelId="{CBEC7562-3EF2-438B-9B8E-B353ABC9D262}" type="pres">
      <dgm:prSet presAssocID="{6E845E7A-E8FD-48B8-A9C7-062FF0666164}" presName="sibTrans" presStyleLbl="node1" presStyleIdx="3" presStyleCnt="5"/>
      <dgm:spPr/>
    </dgm:pt>
    <dgm:pt modelId="{2E0CB526-68A6-4565-AFF9-A83BFC47EBD1}" type="pres">
      <dgm:prSet presAssocID="{B7FE8CD3-AEC0-411E-B74A-001D323F3AC9}" presName="dummy" presStyleCnt="0"/>
      <dgm:spPr/>
    </dgm:pt>
    <dgm:pt modelId="{A716A197-9A4D-4EBE-9F4D-40044665010E}" type="pres">
      <dgm:prSet presAssocID="{B7FE8CD3-AEC0-411E-B74A-001D323F3AC9}" presName="node" presStyleLbl="revTx" presStyleIdx="4" presStyleCnt="5">
        <dgm:presLayoutVars>
          <dgm:bulletEnabled val="1"/>
        </dgm:presLayoutVars>
      </dgm:prSet>
      <dgm:spPr/>
    </dgm:pt>
    <dgm:pt modelId="{6B4827B4-378F-4DED-B815-A396804F439C}" type="pres">
      <dgm:prSet presAssocID="{70A2E692-B5BE-4606-8C3A-457AFD02982C}" presName="sibTrans" presStyleLbl="node1" presStyleIdx="4" presStyleCnt="5"/>
      <dgm:spPr/>
    </dgm:pt>
  </dgm:ptLst>
  <dgm:cxnLst>
    <dgm:cxn modelId="{1635C810-649C-409B-8DA5-473E195D4E14}" srcId="{8B261E96-2B8F-43BF-BD5C-0C4912B98776}" destId="{4A1B478C-9EAA-4288-95CF-FF2106F146BE}" srcOrd="1" destOrd="0" parTransId="{83CBD108-C3CA-46C0-884D-12E68342F261}" sibTransId="{317B51FF-BC69-4E04-81AB-6DA1B7FDAA9F}"/>
    <dgm:cxn modelId="{E2E1C015-53CE-440C-A9CE-3F4ECCBCF219}" type="presOf" srcId="{3AE1EBA0-0F6A-447D-B9AA-B79D696950AB}" destId="{C0590FB8-714B-4522-BA97-989C54126878}" srcOrd="0" destOrd="0" presId="urn:microsoft.com/office/officeart/2005/8/layout/cycle1"/>
    <dgm:cxn modelId="{3094581E-2B8F-443F-94EE-1FAF01F27546}" type="presOf" srcId="{8B261E96-2B8F-43BF-BD5C-0C4912B98776}" destId="{06EFF909-DDEF-4515-93A5-FE48EDCB4200}" srcOrd="0" destOrd="0" presId="urn:microsoft.com/office/officeart/2005/8/layout/cycle1"/>
    <dgm:cxn modelId="{8C6D034A-F0C0-4555-B87E-FF77FAC5E487}" srcId="{8B261E96-2B8F-43BF-BD5C-0C4912B98776}" destId="{3C04C54B-3D46-4DF9-91E5-0B5989AD9106}" srcOrd="3" destOrd="0" parTransId="{882B2ADD-E3DA-4146-A2FA-929056F93521}" sibTransId="{6E845E7A-E8FD-48B8-A9C7-062FF0666164}"/>
    <dgm:cxn modelId="{8EFBD85E-73EC-46BA-BC90-1CC88DF69CCF}" type="presOf" srcId="{3C04C54B-3D46-4DF9-91E5-0B5989AD9106}" destId="{C5D1478B-3DF9-4F88-9386-06D6F1D70D7C}" srcOrd="0" destOrd="0" presId="urn:microsoft.com/office/officeart/2005/8/layout/cycle1"/>
    <dgm:cxn modelId="{21F59369-655C-43D0-A69D-CAE33E025C1A}" srcId="{8B261E96-2B8F-43BF-BD5C-0C4912B98776}" destId="{3AE1EBA0-0F6A-447D-B9AA-B79D696950AB}" srcOrd="0" destOrd="0" parTransId="{4881C3BC-C9D9-4F26-B36D-4C18A4BE5197}" sibTransId="{12DF1FEB-E23C-4131-BF68-7CA5FC571772}"/>
    <dgm:cxn modelId="{66258F82-B33B-4B84-81BF-6AACF240E972}" type="presOf" srcId="{317B51FF-BC69-4E04-81AB-6DA1B7FDAA9F}" destId="{1AD0943B-A1A6-4BDA-9062-80F39E7A1C7B}" srcOrd="0" destOrd="0" presId="urn:microsoft.com/office/officeart/2005/8/layout/cycle1"/>
    <dgm:cxn modelId="{C01078A0-21A0-47D6-B6E8-CA050C9592A4}" type="presOf" srcId="{6E845E7A-E8FD-48B8-A9C7-062FF0666164}" destId="{CBEC7562-3EF2-438B-9B8E-B353ABC9D262}" srcOrd="0" destOrd="0" presId="urn:microsoft.com/office/officeart/2005/8/layout/cycle1"/>
    <dgm:cxn modelId="{7AFB57B9-4C28-4DA6-B80B-9A2FEE2C45E8}" srcId="{8B261E96-2B8F-43BF-BD5C-0C4912B98776}" destId="{B7FE8CD3-AEC0-411E-B74A-001D323F3AC9}" srcOrd="4" destOrd="0" parTransId="{4A773196-8155-48AC-8E13-E5F09228253C}" sibTransId="{70A2E692-B5BE-4606-8C3A-457AFD02982C}"/>
    <dgm:cxn modelId="{2148AABE-C736-4970-BAC0-212550455B4C}" type="presOf" srcId="{26B5D8C0-AB7C-4D34-A856-2F3F8474D796}" destId="{8E8544CC-D122-438F-8CFB-19B02956CE5A}" srcOrd="0" destOrd="0" presId="urn:microsoft.com/office/officeart/2005/8/layout/cycle1"/>
    <dgm:cxn modelId="{5DE79AD6-9B6F-4689-A196-E4BCCC91CDEF}" srcId="{8B261E96-2B8F-43BF-BD5C-0C4912B98776}" destId="{26B5D8C0-AB7C-4D34-A856-2F3F8474D796}" srcOrd="2" destOrd="0" parTransId="{AD7891D8-089E-4CD5-B30F-1B01264AA27D}" sibTransId="{63A76733-7ABD-4520-88E4-D24FFB74F67F}"/>
    <dgm:cxn modelId="{2A809EDE-7A28-4548-9990-16452B478BF4}" type="presOf" srcId="{4A1B478C-9EAA-4288-95CF-FF2106F146BE}" destId="{508389B2-0D19-4900-B9C9-66F95B20F2F1}" srcOrd="0" destOrd="0" presId="urn:microsoft.com/office/officeart/2005/8/layout/cycle1"/>
    <dgm:cxn modelId="{4D69D5E5-68AF-4777-87B1-81A324E3C3C1}" type="presOf" srcId="{12DF1FEB-E23C-4131-BF68-7CA5FC571772}" destId="{AC91F25E-DDBF-437B-9FFE-5B9CAC749C61}" srcOrd="0" destOrd="0" presId="urn:microsoft.com/office/officeart/2005/8/layout/cycle1"/>
    <dgm:cxn modelId="{551E3DED-16AE-4C77-B3F7-38378C0B9459}" type="presOf" srcId="{70A2E692-B5BE-4606-8C3A-457AFD02982C}" destId="{6B4827B4-378F-4DED-B815-A396804F439C}" srcOrd="0" destOrd="0" presId="urn:microsoft.com/office/officeart/2005/8/layout/cycle1"/>
    <dgm:cxn modelId="{22C838EF-D9C6-4FB0-8FEA-4A293A299CB5}" type="presOf" srcId="{63A76733-7ABD-4520-88E4-D24FFB74F67F}" destId="{7E4E7EF2-8419-4AC3-BC4A-FEBB76D26FCF}" srcOrd="0" destOrd="0" presId="urn:microsoft.com/office/officeart/2005/8/layout/cycle1"/>
    <dgm:cxn modelId="{4B6149FA-CDCD-4075-B0D9-F047EA8D9EE9}" type="presOf" srcId="{B7FE8CD3-AEC0-411E-B74A-001D323F3AC9}" destId="{A716A197-9A4D-4EBE-9F4D-40044665010E}" srcOrd="0" destOrd="0" presId="urn:microsoft.com/office/officeart/2005/8/layout/cycle1"/>
    <dgm:cxn modelId="{4263E2D5-8950-4525-9310-8736C49AD2EA}" type="presParOf" srcId="{06EFF909-DDEF-4515-93A5-FE48EDCB4200}" destId="{96D3859A-93FB-4B2D-821F-C5B3713ECD62}" srcOrd="0" destOrd="0" presId="urn:microsoft.com/office/officeart/2005/8/layout/cycle1"/>
    <dgm:cxn modelId="{CD814C8D-FF63-4C57-88E4-AFF373793E36}" type="presParOf" srcId="{06EFF909-DDEF-4515-93A5-FE48EDCB4200}" destId="{C0590FB8-714B-4522-BA97-989C54126878}" srcOrd="1" destOrd="0" presId="urn:microsoft.com/office/officeart/2005/8/layout/cycle1"/>
    <dgm:cxn modelId="{B2ABE2DB-D6D3-42D8-B64E-F3756B389A26}" type="presParOf" srcId="{06EFF909-DDEF-4515-93A5-FE48EDCB4200}" destId="{AC91F25E-DDBF-437B-9FFE-5B9CAC749C61}" srcOrd="2" destOrd="0" presId="urn:microsoft.com/office/officeart/2005/8/layout/cycle1"/>
    <dgm:cxn modelId="{60141F03-5C53-4CF7-8D89-7F261E2EE812}" type="presParOf" srcId="{06EFF909-DDEF-4515-93A5-FE48EDCB4200}" destId="{653EF67A-834D-4F18-9DC6-00AFA14C62AE}" srcOrd="3" destOrd="0" presId="urn:microsoft.com/office/officeart/2005/8/layout/cycle1"/>
    <dgm:cxn modelId="{D9C18CD0-F368-4A29-BBC1-A5817FFECB5C}" type="presParOf" srcId="{06EFF909-DDEF-4515-93A5-FE48EDCB4200}" destId="{508389B2-0D19-4900-B9C9-66F95B20F2F1}" srcOrd="4" destOrd="0" presId="urn:microsoft.com/office/officeart/2005/8/layout/cycle1"/>
    <dgm:cxn modelId="{8DB3C285-A3E4-48CF-986E-8F6CC04999BA}" type="presParOf" srcId="{06EFF909-DDEF-4515-93A5-FE48EDCB4200}" destId="{1AD0943B-A1A6-4BDA-9062-80F39E7A1C7B}" srcOrd="5" destOrd="0" presId="urn:microsoft.com/office/officeart/2005/8/layout/cycle1"/>
    <dgm:cxn modelId="{3DD56884-39AA-4B9F-BC72-DDD15F833CDA}" type="presParOf" srcId="{06EFF909-DDEF-4515-93A5-FE48EDCB4200}" destId="{A4F3001E-0B9D-480E-8555-86F345ECA762}" srcOrd="6" destOrd="0" presId="urn:microsoft.com/office/officeart/2005/8/layout/cycle1"/>
    <dgm:cxn modelId="{A51A6F77-C936-4541-B6F4-F89038C26AAA}" type="presParOf" srcId="{06EFF909-DDEF-4515-93A5-FE48EDCB4200}" destId="{8E8544CC-D122-438F-8CFB-19B02956CE5A}" srcOrd="7" destOrd="0" presId="urn:microsoft.com/office/officeart/2005/8/layout/cycle1"/>
    <dgm:cxn modelId="{81A32057-A911-4A73-B271-26D092E9AFAF}" type="presParOf" srcId="{06EFF909-DDEF-4515-93A5-FE48EDCB4200}" destId="{7E4E7EF2-8419-4AC3-BC4A-FEBB76D26FCF}" srcOrd="8" destOrd="0" presId="urn:microsoft.com/office/officeart/2005/8/layout/cycle1"/>
    <dgm:cxn modelId="{9DE9B6A5-B58E-4848-9AC9-C55D723BB8C0}" type="presParOf" srcId="{06EFF909-DDEF-4515-93A5-FE48EDCB4200}" destId="{6AF17485-D839-4973-91CF-9A647E0CE8CE}" srcOrd="9" destOrd="0" presId="urn:microsoft.com/office/officeart/2005/8/layout/cycle1"/>
    <dgm:cxn modelId="{4245C17E-A354-415B-A42C-1BA5A9116652}" type="presParOf" srcId="{06EFF909-DDEF-4515-93A5-FE48EDCB4200}" destId="{C5D1478B-3DF9-4F88-9386-06D6F1D70D7C}" srcOrd="10" destOrd="0" presId="urn:microsoft.com/office/officeart/2005/8/layout/cycle1"/>
    <dgm:cxn modelId="{25BAB14F-157A-47E4-9006-8A8F6B9E6A62}" type="presParOf" srcId="{06EFF909-DDEF-4515-93A5-FE48EDCB4200}" destId="{CBEC7562-3EF2-438B-9B8E-B353ABC9D262}" srcOrd="11" destOrd="0" presId="urn:microsoft.com/office/officeart/2005/8/layout/cycle1"/>
    <dgm:cxn modelId="{38C7DDA0-20DA-4788-9EDF-BC828221B721}" type="presParOf" srcId="{06EFF909-DDEF-4515-93A5-FE48EDCB4200}" destId="{2E0CB526-68A6-4565-AFF9-A83BFC47EBD1}" srcOrd="12" destOrd="0" presId="urn:microsoft.com/office/officeart/2005/8/layout/cycle1"/>
    <dgm:cxn modelId="{763C565F-0A05-4FF6-9299-84C0BEF8DA9C}" type="presParOf" srcId="{06EFF909-DDEF-4515-93A5-FE48EDCB4200}" destId="{A716A197-9A4D-4EBE-9F4D-40044665010E}" srcOrd="13" destOrd="0" presId="urn:microsoft.com/office/officeart/2005/8/layout/cycle1"/>
    <dgm:cxn modelId="{5709A878-3467-4146-AD69-16AABC3B04E8}" type="presParOf" srcId="{06EFF909-DDEF-4515-93A5-FE48EDCB4200}" destId="{6B4827B4-378F-4DED-B815-A396804F439C}" srcOrd="14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590FB8-714B-4522-BA97-989C54126878}">
      <dsp:nvSpPr>
        <dsp:cNvPr id="0" name=""/>
        <dsp:cNvSpPr/>
      </dsp:nvSpPr>
      <dsp:spPr>
        <a:xfrm>
          <a:off x="4692351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sp:txBody>
      <dsp:txXfrm>
        <a:off x="4692351" y="37617"/>
        <a:ext cx="1313656" cy="1313656"/>
      </dsp:txXfrm>
    </dsp:sp>
    <dsp:sp modelId="{AC91F25E-DDBF-437B-9FFE-5B9CAC749C61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21293841"/>
            <a:gd name="adj4" fmla="val 19765714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8389B2-0D19-4900-B9C9-66F95B20F2F1}">
      <dsp:nvSpPr>
        <dsp:cNvPr id="0" name=""/>
        <dsp:cNvSpPr/>
      </dsp:nvSpPr>
      <dsp:spPr>
        <a:xfrm>
          <a:off x="5486635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sp:txBody>
      <dsp:txXfrm>
        <a:off x="5486635" y="2482173"/>
        <a:ext cx="1313656" cy="1313656"/>
      </dsp:txXfrm>
    </dsp:sp>
    <dsp:sp modelId="{1AD0943B-A1A6-4BDA-9062-80F39E7A1C7B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4015319"/>
            <a:gd name="adj4" fmla="val 2252862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E8544CC-D122-438F-8CFB-19B02956CE5A}">
      <dsp:nvSpPr>
        <dsp:cNvPr id="0" name=""/>
        <dsp:cNvSpPr/>
      </dsp:nvSpPr>
      <dsp:spPr>
        <a:xfrm>
          <a:off x="3407171" y="3992992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sp:txBody>
      <dsp:txXfrm>
        <a:off x="3407171" y="3992992"/>
        <a:ext cx="1313656" cy="1313656"/>
      </dsp:txXfrm>
    </dsp:sp>
    <dsp:sp modelId="{7E4E7EF2-8419-4AC3-BC4A-FEBB76D26FCF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8211372"/>
            <a:gd name="adj4" fmla="val 6448915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5D1478B-3DF9-4F88-9386-06D6F1D70D7C}">
      <dsp:nvSpPr>
        <dsp:cNvPr id="0" name=""/>
        <dsp:cNvSpPr/>
      </dsp:nvSpPr>
      <dsp:spPr>
        <a:xfrm>
          <a:off x="1327708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sp:txBody>
      <dsp:txXfrm>
        <a:off x="1327708" y="2482173"/>
        <a:ext cx="1313656" cy="1313656"/>
      </dsp:txXfrm>
    </dsp:sp>
    <dsp:sp modelId="{CBEC7562-3EF2-438B-9B8E-B353ABC9D262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2298520"/>
            <a:gd name="adj4" fmla="val 10770393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16A197-9A4D-4EBE-9F4D-40044665010E}">
      <dsp:nvSpPr>
        <dsp:cNvPr id="0" name=""/>
        <dsp:cNvSpPr/>
      </dsp:nvSpPr>
      <dsp:spPr>
        <a:xfrm>
          <a:off x="2121992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sp:txBody>
      <dsp:txXfrm>
        <a:off x="2121992" y="37617"/>
        <a:ext cx="1313656" cy="1313656"/>
      </dsp:txXfrm>
    </dsp:sp>
    <dsp:sp modelId="{6B4827B4-378F-4DED-B815-A396804F439C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6866306"/>
            <a:gd name="adj4" fmla="val 15197928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590FB8-714B-4522-BA97-989C54126878}">
      <dsp:nvSpPr>
        <dsp:cNvPr id="0" name=""/>
        <dsp:cNvSpPr/>
      </dsp:nvSpPr>
      <dsp:spPr>
        <a:xfrm>
          <a:off x="4692351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sp:txBody>
      <dsp:txXfrm>
        <a:off x="4692351" y="37617"/>
        <a:ext cx="1313656" cy="1313656"/>
      </dsp:txXfrm>
    </dsp:sp>
    <dsp:sp modelId="{AC91F25E-DDBF-437B-9FFE-5B9CAC749C61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21293841"/>
            <a:gd name="adj4" fmla="val 19765714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8389B2-0D19-4900-B9C9-66F95B20F2F1}">
      <dsp:nvSpPr>
        <dsp:cNvPr id="0" name=""/>
        <dsp:cNvSpPr/>
      </dsp:nvSpPr>
      <dsp:spPr>
        <a:xfrm>
          <a:off x="5486635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sp:txBody>
      <dsp:txXfrm>
        <a:off x="5486635" y="2482173"/>
        <a:ext cx="1313656" cy="1313656"/>
      </dsp:txXfrm>
    </dsp:sp>
    <dsp:sp modelId="{1AD0943B-A1A6-4BDA-9062-80F39E7A1C7B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4015319"/>
            <a:gd name="adj4" fmla="val 2252862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E8544CC-D122-438F-8CFB-19B02956CE5A}">
      <dsp:nvSpPr>
        <dsp:cNvPr id="0" name=""/>
        <dsp:cNvSpPr/>
      </dsp:nvSpPr>
      <dsp:spPr>
        <a:xfrm>
          <a:off x="3407171" y="3992992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sp:txBody>
      <dsp:txXfrm>
        <a:off x="3407171" y="3992992"/>
        <a:ext cx="1313656" cy="1313656"/>
      </dsp:txXfrm>
    </dsp:sp>
    <dsp:sp modelId="{7E4E7EF2-8419-4AC3-BC4A-FEBB76D26FCF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8211372"/>
            <a:gd name="adj4" fmla="val 6448915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5D1478B-3DF9-4F88-9386-06D6F1D70D7C}">
      <dsp:nvSpPr>
        <dsp:cNvPr id="0" name=""/>
        <dsp:cNvSpPr/>
      </dsp:nvSpPr>
      <dsp:spPr>
        <a:xfrm>
          <a:off x="1327708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sp:txBody>
      <dsp:txXfrm>
        <a:off x="1327708" y="2482173"/>
        <a:ext cx="1313656" cy="1313656"/>
      </dsp:txXfrm>
    </dsp:sp>
    <dsp:sp modelId="{CBEC7562-3EF2-438B-9B8E-B353ABC9D262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2298520"/>
            <a:gd name="adj4" fmla="val 10770393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16A197-9A4D-4EBE-9F4D-40044665010E}">
      <dsp:nvSpPr>
        <dsp:cNvPr id="0" name=""/>
        <dsp:cNvSpPr/>
      </dsp:nvSpPr>
      <dsp:spPr>
        <a:xfrm>
          <a:off x="2121992" y="37617"/>
          <a:ext cx="1313656" cy="1313656"/>
        </a:xfrm>
        <a:prstGeom prst="rect">
          <a:avLst/>
        </a:prstGeom>
        <a:solidFill>
          <a:schemeClr val="bg2">
            <a:lumMod val="25000"/>
          </a:schemeClr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sp:txBody>
      <dsp:txXfrm>
        <a:off x="2121992" y="37617"/>
        <a:ext cx="1313656" cy="1313656"/>
      </dsp:txXfrm>
    </dsp:sp>
    <dsp:sp modelId="{6B4827B4-378F-4DED-B815-A396804F439C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6866306"/>
            <a:gd name="adj4" fmla="val 15197928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590FB8-714B-4522-BA97-989C54126878}">
      <dsp:nvSpPr>
        <dsp:cNvPr id="0" name=""/>
        <dsp:cNvSpPr/>
      </dsp:nvSpPr>
      <dsp:spPr>
        <a:xfrm>
          <a:off x="4692351" y="37617"/>
          <a:ext cx="1313656" cy="1313656"/>
        </a:xfrm>
        <a:prstGeom prst="rect">
          <a:avLst/>
        </a:prstGeom>
        <a:solidFill>
          <a:schemeClr val="bg2">
            <a:lumMod val="25000"/>
          </a:schemeClr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sp:txBody>
      <dsp:txXfrm>
        <a:off x="4692351" y="37617"/>
        <a:ext cx="1313656" cy="1313656"/>
      </dsp:txXfrm>
    </dsp:sp>
    <dsp:sp modelId="{AC91F25E-DDBF-437B-9FFE-5B9CAC749C61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21293841"/>
            <a:gd name="adj4" fmla="val 19765714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8389B2-0D19-4900-B9C9-66F95B20F2F1}">
      <dsp:nvSpPr>
        <dsp:cNvPr id="0" name=""/>
        <dsp:cNvSpPr/>
      </dsp:nvSpPr>
      <dsp:spPr>
        <a:xfrm>
          <a:off x="5486635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sp:txBody>
      <dsp:txXfrm>
        <a:off x="5486635" y="2482173"/>
        <a:ext cx="1313656" cy="1313656"/>
      </dsp:txXfrm>
    </dsp:sp>
    <dsp:sp modelId="{1AD0943B-A1A6-4BDA-9062-80F39E7A1C7B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4015319"/>
            <a:gd name="adj4" fmla="val 2252862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E8544CC-D122-438F-8CFB-19B02956CE5A}">
      <dsp:nvSpPr>
        <dsp:cNvPr id="0" name=""/>
        <dsp:cNvSpPr/>
      </dsp:nvSpPr>
      <dsp:spPr>
        <a:xfrm>
          <a:off x="3407171" y="3992992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sp:txBody>
      <dsp:txXfrm>
        <a:off x="3407171" y="3992992"/>
        <a:ext cx="1313656" cy="1313656"/>
      </dsp:txXfrm>
    </dsp:sp>
    <dsp:sp modelId="{7E4E7EF2-8419-4AC3-BC4A-FEBB76D26FCF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8211372"/>
            <a:gd name="adj4" fmla="val 6448915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5D1478B-3DF9-4F88-9386-06D6F1D70D7C}">
      <dsp:nvSpPr>
        <dsp:cNvPr id="0" name=""/>
        <dsp:cNvSpPr/>
      </dsp:nvSpPr>
      <dsp:spPr>
        <a:xfrm>
          <a:off x="1327708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sp:txBody>
      <dsp:txXfrm>
        <a:off x="1327708" y="2482173"/>
        <a:ext cx="1313656" cy="1313656"/>
      </dsp:txXfrm>
    </dsp:sp>
    <dsp:sp modelId="{CBEC7562-3EF2-438B-9B8E-B353ABC9D262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2298520"/>
            <a:gd name="adj4" fmla="val 10770393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16A197-9A4D-4EBE-9F4D-40044665010E}">
      <dsp:nvSpPr>
        <dsp:cNvPr id="0" name=""/>
        <dsp:cNvSpPr/>
      </dsp:nvSpPr>
      <dsp:spPr>
        <a:xfrm>
          <a:off x="2121992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sp:txBody>
      <dsp:txXfrm>
        <a:off x="2121992" y="37617"/>
        <a:ext cx="1313656" cy="1313656"/>
      </dsp:txXfrm>
    </dsp:sp>
    <dsp:sp modelId="{6B4827B4-378F-4DED-B815-A396804F439C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6866306"/>
            <a:gd name="adj4" fmla="val 15197928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590FB8-714B-4522-BA97-989C54126878}">
      <dsp:nvSpPr>
        <dsp:cNvPr id="0" name=""/>
        <dsp:cNvSpPr/>
      </dsp:nvSpPr>
      <dsp:spPr>
        <a:xfrm>
          <a:off x="4692351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sp:txBody>
      <dsp:txXfrm>
        <a:off x="4692351" y="37617"/>
        <a:ext cx="1313656" cy="1313656"/>
      </dsp:txXfrm>
    </dsp:sp>
    <dsp:sp modelId="{AC91F25E-DDBF-437B-9FFE-5B9CAC749C61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21293841"/>
            <a:gd name="adj4" fmla="val 19765714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8389B2-0D19-4900-B9C9-66F95B20F2F1}">
      <dsp:nvSpPr>
        <dsp:cNvPr id="0" name=""/>
        <dsp:cNvSpPr/>
      </dsp:nvSpPr>
      <dsp:spPr>
        <a:xfrm>
          <a:off x="5486635" y="2482173"/>
          <a:ext cx="1313656" cy="1313656"/>
        </a:xfrm>
        <a:prstGeom prst="rect">
          <a:avLst/>
        </a:prstGeom>
        <a:solidFill>
          <a:schemeClr val="bg2">
            <a:lumMod val="25000"/>
          </a:schemeClr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sp:txBody>
      <dsp:txXfrm>
        <a:off x="5486635" y="2482173"/>
        <a:ext cx="1313656" cy="1313656"/>
      </dsp:txXfrm>
    </dsp:sp>
    <dsp:sp modelId="{1AD0943B-A1A6-4BDA-9062-80F39E7A1C7B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4015319"/>
            <a:gd name="adj4" fmla="val 2252862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E8544CC-D122-438F-8CFB-19B02956CE5A}">
      <dsp:nvSpPr>
        <dsp:cNvPr id="0" name=""/>
        <dsp:cNvSpPr/>
      </dsp:nvSpPr>
      <dsp:spPr>
        <a:xfrm>
          <a:off x="3407171" y="3992992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sp:txBody>
      <dsp:txXfrm>
        <a:off x="3407171" y="3992992"/>
        <a:ext cx="1313656" cy="1313656"/>
      </dsp:txXfrm>
    </dsp:sp>
    <dsp:sp modelId="{7E4E7EF2-8419-4AC3-BC4A-FEBB76D26FCF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8211372"/>
            <a:gd name="adj4" fmla="val 6448915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5D1478B-3DF9-4F88-9386-06D6F1D70D7C}">
      <dsp:nvSpPr>
        <dsp:cNvPr id="0" name=""/>
        <dsp:cNvSpPr/>
      </dsp:nvSpPr>
      <dsp:spPr>
        <a:xfrm>
          <a:off x="1327708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sp:txBody>
      <dsp:txXfrm>
        <a:off x="1327708" y="2482173"/>
        <a:ext cx="1313656" cy="1313656"/>
      </dsp:txXfrm>
    </dsp:sp>
    <dsp:sp modelId="{CBEC7562-3EF2-438B-9B8E-B353ABC9D262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2298520"/>
            <a:gd name="adj4" fmla="val 10770393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16A197-9A4D-4EBE-9F4D-40044665010E}">
      <dsp:nvSpPr>
        <dsp:cNvPr id="0" name=""/>
        <dsp:cNvSpPr/>
      </dsp:nvSpPr>
      <dsp:spPr>
        <a:xfrm>
          <a:off x="2121992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sp:txBody>
      <dsp:txXfrm>
        <a:off x="2121992" y="37617"/>
        <a:ext cx="1313656" cy="1313656"/>
      </dsp:txXfrm>
    </dsp:sp>
    <dsp:sp modelId="{6B4827B4-378F-4DED-B815-A396804F439C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6866306"/>
            <a:gd name="adj4" fmla="val 15197928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590FB8-714B-4522-BA97-989C54126878}">
      <dsp:nvSpPr>
        <dsp:cNvPr id="0" name=""/>
        <dsp:cNvSpPr/>
      </dsp:nvSpPr>
      <dsp:spPr>
        <a:xfrm>
          <a:off x="4692351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sp:txBody>
      <dsp:txXfrm>
        <a:off x="4692351" y="37617"/>
        <a:ext cx="1313656" cy="1313656"/>
      </dsp:txXfrm>
    </dsp:sp>
    <dsp:sp modelId="{AC91F25E-DDBF-437B-9FFE-5B9CAC749C61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21293841"/>
            <a:gd name="adj4" fmla="val 19765714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8389B2-0D19-4900-B9C9-66F95B20F2F1}">
      <dsp:nvSpPr>
        <dsp:cNvPr id="0" name=""/>
        <dsp:cNvSpPr/>
      </dsp:nvSpPr>
      <dsp:spPr>
        <a:xfrm>
          <a:off x="5486635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sp:txBody>
      <dsp:txXfrm>
        <a:off x="5486635" y="2482173"/>
        <a:ext cx="1313656" cy="1313656"/>
      </dsp:txXfrm>
    </dsp:sp>
    <dsp:sp modelId="{1AD0943B-A1A6-4BDA-9062-80F39E7A1C7B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4015319"/>
            <a:gd name="adj4" fmla="val 2252862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E8544CC-D122-438F-8CFB-19B02956CE5A}">
      <dsp:nvSpPr>
        <dsp:cNvPr id="0" name=""/>
        <dsp:cNvSpPr/>
      </dsp:nvSpPr>
      <dsp:spPr>
        <a:xfrm>
          <a:off x="3407171" y="3992992"/>
          <a:ext cx="1313656" cy="1313656"/>
        </a:xfrm>
        <a:prstGeom prst="rect">
          <a:avLst/>
        </a:prstGeom>
        <a:solidFill>
          <a:schemeClr val="bg2">
            <a:lumMod val="25000"/>
          </a:schemeClr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Engage patients and clinicians</a:t>
          </a:r>
        </a:p>
      </dsp:txBody>
      <dsp:txXfrm>
        <a:off x="3407171" y="3992992"/>
        <a:ext cx="1313656" cy="1313656"/>
      </dsp:txXfrm>
    </dsp:sp>
    <dsp:sp modelId="{7E4E7EF2-8419-4AC3-BC4A-FEBB76D26FCF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8211372"/>
            <a:gd name="adj4" fmla="val 6448915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5D1478B-3DF9-4F88-9386-06D6F1D70D7C}">
      <dsp:nvSpPr>
        <dsp:cNvPr id="0" name=""/>
        <dsp:cNvSpPr/>
      </dsp:nvSpPr>
      <dsp:spPr>
        <a:xfrm>
          <a:off x="1327708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sp:txBody>
      <dsp:txXfrm>
        <a:off x="1327708" y="2482173"/>
        <a:ext cx="1313656" cy="1313656"/>
      </dsp:txXfrm>
    </dsp:sp>
    <dsp:sp modelId="{CBEC7562-3EF2-438B-9B8E-B353ABC9D262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2298520"/>
            <a:gd name="adj4" fmla="val 10770393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16A197-9A4D-4EBE-9F4D-40044665010E}">
      <dsp:nvSpPr>
        <dsp:cNvPr id="0" name=""/>
        <dsp:cNvSpPr/>
      </dsp:nvSpPr>
      <dsp:spPr>
        <a:xfrm>
          <a:off x="2121992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sp:txBody>
      <dsp:txXfrm>
        <a:off x="2121992" y="37617"/>
        <a:ext cx="1313656" cy="1313656"/>
      </dsp:txXfrm>
    </dsp:sp>
    <dsp:sp modelId="{6B4827B4-378F-4DED-B815-A396804F439C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6866306"/>
            <a:gd name="adj4" fmla="val 15197928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590FB8-714B-4522-BA97-989C54126878}">
      <dsp:nvSpPr>
        <dsp:cNvPr id="0" name=""/>
        <dsp:cNvSpPr/>
      </dsp:nvSpPr>
      <dsp:spPr>
        <a:xfrm>
          <a:off x="4692351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sp:txBody>
      <dsp:txXfrm>
        <a:off x="4692351" y="37617"/>
        <a:ext cx="1313656" cy="1313656"/>
      </dsp:txXfrm>
    </dsp:sp>
    <dsp:sp modelId="{AC91F25E-DDBF-437B-9FFE-5B9CAC749C61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21293841"/>
            <a:gd name="adj4" fmla="val 19765714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8389B2-0D19-4900-B9C9-66F95B20F2F1}">
      <dsp:nvSpPr>
        <dsp:cNvPr id="0" name=""/>
        <dsp:cNvSpPr/>
      </dsp:nvSpPr>
      <dsp:spPr>
        <a:xfrm>
          <a:off x="5486635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sp:txBody>
      <dsp:txXfrm>
        <a:off x="5486635" y="2482173"/>
        <a:ext cx="1313656" cy="1313656"/>
      </dsp:txXfrm>
    </dsp:sp>
    <dsp:sp modelId="{1AD0943B-A1A6-4BDA-9062-80F39E7A1C7B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4015319"/>
            <a:gd name="adj4" fmla="val 2252862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E8544CC-D122-438F-8CFB-19B02956CE5A}">
      <dsp:nvSpPr>
        <dsp:cNvPr id="0" name=""/>
        <dsp:cNvSpPr/>
      </dsp:nvSpPr>
      <dsp:spPr>
        <a:xfrm>
          <a:off x="3407171" y="3992992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Engage patients and providers</a:t>
          </a:r>
        </a:p>
      </dsp:txBody>
      <dsp:txXfrm>
        <a:off x="3407171" y="3992992"/>
        <a:ext cx="1313656" cy="1313656"/>
      </dsp:txXfrm>
    </dsp:sp>
    <dsp:sp modelId="{7E4E7EF2-8419-4AC3-BC4A-FEBB76D26FCF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8211372"/>
            <a:gd name="adj4" fmla="val 6448915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5D1478B-3DF9-4F88-9386-06D6F1D70D7C}">
      <dsp:nvSpPr>
        <dsp:cNvPr id="0" name=""/>
        <dsp:cNvSpPr/>
      </dsp:nvSpPr>
      <dsp:spPr>
        <a:xfrm>
          <a:off x="1327708" y="2482173"/>
          <a:ext cx="1313656" cy="1313656"/>
        </a:xfrm>
        <a:prstGeom prst="rect">
          <a:avLst/>
        </a:prstGeom>
        <a:solidFill>
          <a:schemeClr val="bg2">
            <a:lumMod val="25000"/>
          </a:schemeClr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sp:txBody>
      <dsp:txXfrm>
        <a:off x="1327708" y="2482173"/>
        <a:ext cx="1313656" cy="1313656"/>
      </dsp:txXfrm>
    </dsp:sp>
    <dsp:sp modelId="{CBEC7562-3EF2-438B-9B8E-B353ABC9D262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2298520"/>
            <a:gd name="adj4" fmla="val 10770393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16A197-9A4D-4EBE-9F4D-40044665010E}">
      <dsp:nvSpPr>
        <dsp:cNvPr id="0" name=""/>
        <dsp:cNvSpPr/>
      </dsp:nvSpPr>
      <dsp:spPr>
        <a:xfrm>
          <a:off x="2121992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sp:txBody>
      <dsp:txXfrm>
        <a:off x="2121992" y="37617"/>
        <a:ext cx="1313656" cy="1313656"/>
      </dsp:txXfrm>
    </dsp:sp>
    <dsp:sp modelId="{6B4827B4-378F-4DED-B815-A396804F439C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6866306"/>
            <a:gd name="adj4" fmla="val 15197928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590FB8-714B-4522-BA97-989C54126878}">
      <dsp:nvSpPr>
        <dsp:cNvPr id="0" name=""/>
        <dsp:cNvSpPr/>
      </dsp:nvSpPr>
      <dsp:spPr>
        <a:xfrm>
          <a:off x="4692351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ggregate / analyze data</a:t>
          </a:r>
        </a:p>
      </dsp:txBody>
      <dsp:txXfrm>
        <a:off x="4692351" y="37617"/>
        <a:ext cx="1313656" cy="1313656"/>
      </dsp:txXfrm>
    </dsp:sp>
    <dsp:sp modelId="{AC91F25E-DDBF-437B-9FFE-5B9CAC749C61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21293841"/>
            <a:gd name="adj4" fmla="val 19765714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8389B2-0D19-4900-B9C9-66F95B20F2F1}">
      <dsp:nvSpPr>
        <dsp:cNvPr id="0" name=""/>
        <dsp:cNvSpPr/>
      </dsp:nvSpPr>
      <dsp:spPr>
        <a:xfrm>
          <a:off x="5486635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Use data to risk stratify + identify improvement</a:t>
          </a:r>
        </a:p>
        <a:p>
          <a:pPr marL="0" lvl="0" indent="0" algn="ctr" defTabSz="666750" rtl="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areas</a:t>
          </a:r>
        </a:p>
      </dsp:txBody>
      <dsp:txXfrm>
        <a:off x="5486635" y="2482173"/>
        <a:ext cx="1313656" cy="1313656"/>
      </dsp:txXfrm>
    </dsp:sp>
    <dsp:sp modelId="{1AD0943B-A1A6-4BDA-9062-80F39E7A1C7B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4015319"/>
            <a:gd name="adj4" fmla="val 2252862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E8544CC-D122-438F-8CFB-19B02956CE5A}">
      <dsp:nvSpPr>
        <dsp:cNvPr id="0" name=""/>
        <dsp:cNvSpPr/>
      </dsp:nvSpPr>
      <dsp:spPr>
        <a:xfrm>
          <a:off x="3407171" y="3992992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Engage patients and providers</a:t>
          </a:r>
        </a:p>
      </dsp:txBody>
      <dsp:txXfrm>
        <a:off x="3407171" y="3992992"/>
        <a:ext cx="1313656" cy="1313656"/>
      </dsp:txXfrm>
    </dsp:sp>
    <dsp:sp modelId="{7E4E7EF2-8419-4AC3-BC4A-FEBB76D26FCF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8211372"/>
            <a:gd name="adj4" fmla="val 6448915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5D1478B-3DF9-4F88-9386-06D6F1D70D7C}">
      <dsp:nvSpPr>
        <dsp:cNvPr id="0" name=""/>
        <dsp:cNvSpPr/>
      </dsp:nvSpPr>
      <dsp:spPr>
        <a:xfrm>
          <a:off x="1327708" y="2482173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Implement strategies to improve pain management safety</a:t>
          </a:r>
        </a:p>
      </dsp:txBody>
      <dsp:txXfrm>
        <a:off x="1327708" y="2482173"/>
        <a:ext cx="1313656" cy="1313656"/>
      </dsp:txXfrm>
    </dsp:sp>
    <dsp:sp modelId="{CBEC7562-3EF2-438B-9B8E-B353ABC9D262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2298520"/>
            <a:gd name="adj4" fmla="val 10770393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716A197-9A4D-4EBE-9F4D-40044665010E}">
      <dsp:nvSpPr>
        <dsp:cNvPr id="0" name=""/>
        <dsp:cNvSpPr/>
      </dsp:nvSpPr>
      <dsp:spPr>
        <a:xfrm>
          <a:off x="2121992" y="37617"/>
          <a:ext cx="1313656" cy="1313656"/>
        </a:xfrm>
        <a:prstGeom prst="rect">
          <a:avLst/>
        </a:prstGeom>
        <a:solidFill>
          <a:schemeClr val="bg2"/>
        </a:solidFill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b="1" kern="1200">
              <a:latin typeface="Arial" panose="020B0604020202020204" pitchFamily="34" charset="0"/>
              <a:cs typeface="Arial" panose="020B0604020202020204" pitchFamily="34" charset="0"/>
            </a:rPr>
            <a:t>Collect opioid use data</a:t>
          </a:r>
        </a:p>
      </dsp:txBody>
      <dsp:txXfrm>
        <a:off x="2121992" y="37617"/>
        <a:ext cx="1313656" cy="1313656"/>
      </dsp:txXfrm>
    </dsp:sp>
    <dsp:sp modelId="{6B4827B4-378F-4DED-B815-A396804F439C}">
      <dsp:nvSpPr>
        <dsp:cNvPr id="0" name=""/>
        <dsp:cNvSpPr/>
      </dsp:nvSpPr>
      <dsp:spPr>
        <a:xfrm>
          <a:off x="1600012" y="-644"/>
          <a:ext cx="4927974" cy="4927974"/>
        </a:xfrm>
        <a:prstGeom prst="circularArrow">
          <a:avLst>
            <a:gd name="adj1" fmla="val 5198"/>
            <a:gd name="adj2" fmla="val 335766"/>
            <a:gd name="adj3" fmla="val 16866306"/>
            <a:gd name="adj4" fmla="val 15197928"/>
            <a:gd name="adj5" fmla="val 6064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E6D1952-4C8C-594A-8D47-CC3EBD31CD69}" type="datetimeFigureOut">
              <a:rPr lang="en-US" smtClean="0"/>
              <a:t>1/27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0632E9FD-FA40-FC48-8917-175ED0BCC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2048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AE82BA9-193E-D440-8A2C-9653656F2AE3}" type="datetimeFigureOut">
              <a:rPr lang="en-US" smtClean="0"/>
              <a:t>1/27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6400" y="696913"/>
            <a:ext cx="61976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6363C63D-0C1A-0E4C-A0BD-8D65A954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705614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7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76025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06400" y="696913"/>
            <a:ext cx="61976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83454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06400" y="696913"/>
            <a:ext cx="61976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26083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06400" y="696913"/>
            <a:ext cx="61976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23281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06400" y="696913"/>
            <a:ext cx="61976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60803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06400" y="696913"/>
            <a:ext cx="61976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07474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06400" y="696913"/>
            <a:ext cx="61976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403811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567094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 typeface="Symbol" panose="05050102010706020507" pitchFamily="18" charset="2"/>
              <a:buNone/>
              <a:tabLst/>
              <a:defRPr/>
            </a:pPr>
            <a:endParaRPr lang="en-US" sz="180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39041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idea</a:t>
            </a:r>
            <a:r>
              <a:rPr lang="en-US" sz="12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ere is that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uman-centered design will assure the active engagement of patients, caregivers, and clinicians, and will facilitate development of a feasible</a:t>
            </a:r>
            <a:r>
              <a:rPr lang="en-US" sz="12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ol that makes it easier for these stakeholders to systematically and longitudinally monitor risk for conversion to chronic opioid use.</a:t>
            </a:r>
          </a:p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859087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lication of human-centered design will assure the active engagement of patients, caregivers, and clinicians, and will facilitate development of a feasible, effective, and sustainable tool that makes it easier for these stakeholders to systematically and longitudinally monitor risk for conversion to chronic opioid use.</a:t>
            </a:r>
          </a:p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4587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067119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lication of human-centered design will assure the active engagement of patients, caregivers, and clinicians, and will facilitate development of a feasible, effective, and sustainable tool that makes it easier for these stakeholders to systematically and longitudinally monitor risk for conversion to chronic opioid use.</a:t>
            </a:r>
          </a:p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076994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lication of human-centered design will assure the active engagement of patients, caregivers, and clinicians, and will facilitate development of a feasible, effective, and sustainable tool that makes it easier for these stakeholders to systematically and longitudinally monitor risk for conversion to chronic opioid use.</a:t>
            </a:r>
          </a:p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638973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lication of human-centered design will assure the active engagement of patients, caregivers, and clinicians, and will facilitate development of a feasible, effective, and sustainable tool that makes it easier for these stakeholders to systematically and longitudinally monitor risk for conversion to chronic opioid use.</a:t>
            </a:r>
          </a:p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040799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lication of human-centered design will assure the active engagement of patients, caregivers, and clinicians, and will facilitate development of a feasible, effective, and sustainable tool that makes it easier for these stakeholders to systematically and longitudinally monitor risk for conversion to chronic opioid use.</a:t>
            </a:r>
          </a:p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274135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lication of human-centered design will assure the active engagement of patients, caregivers, and clinicians, and will facilitate development of a feasible, effective, and sustainable tool that makes it easier for these stakeholders to systematically and longitudinally monitor risk for conversion to chronic opioid use.</a:t>
            </a:r>
          </a:p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810965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848362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As we learn the language of the world we live and work in, a metaphorical valley is created in the mind to hold concepts that tend to flow together in our thinking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b="0">
              <a:solidFill>
                <a:srgbClr val="211E1E"/>
              </a:solidFill>
              <a:effectLst/>
              <a:latin typeface="Frutiger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-mental valley of “ER” we hold and link together the concepts of a physical space: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	-with a parking garage and separate ambulance bays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	-with a main entrance and reception desk where you must register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	-with waiting areas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	-with examination rooms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	-where the nurse does an initial triage and tells you that the doctor will see you later... etc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b="0">
              <a:solidFill>
                <a:srgbClr val="211E1E"/>
              </a:solidFill>
              <a:effectLst/>
              <a:latin typeface="Frutiger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We’ve learned these concepts naturally go together – “That is just the way it is”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it is the “usual” way to think about the ER - simply saying “ER” naturally puts us in this mental valley and activates the stream of thought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The same thing happens when we think of a “Pediatrician’s Office”, “Patient”, “Medical Record” or any other of the many words that are common in the language of health care. </a:t>
            </a:r>
            <a:endParaRPr lang="en-US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549479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Thinking differently is about making “</a:t>
            </a:r>
            <a:r>
              <a:rPr lang="en-US" sz="1800" b="1" i="1">
                <a:solidFill>
                  <a:srgbClr val="211E1E"/>
                </a:solidFill>
                <a:effectLst/>
                <a:latin typeface="Frutiger"/>
              </a:rPr>
              <a:t>creative connections</a:t>
            </a: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”. It involves challenging, connecting and rearranging information in our mental valleys. </a:t>
            </a:r>
          </a:p>
          <a:p>
            <a:endParaRPr lang="en-US" sz="1800" b="0">
              <a:solidFill>
                <a:srgbClr val="211E1E"/>
              </a:solidFill>
              <a:effectLst/>
              <a:latin typeface="Frutiger"/>
            </a:endParaRPr>
          </a:p>
          <a:p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We might challenge the usual stream of thought that uses reception and triage as “control gates” before gaining access to a doctor, and simply have a process where a doctor sees everyone who comes into the ER immediately to begin care.</a:t>
            </a:r>
          </a:p>
          <a:p>
            <a:endParaRPr lang="en-US" sz="1800" b="0">
              <a:solidFill>
                <a:srgbClr val="211E1E"/>
              </a:solidFill>
              <a:effectLst/>
              <a:latin typeface="Frutiger"/>
            </a:endParaRPr>
          </a:p>
          <a:p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We might connect to the valley of “fast food restaurants” and rearrange our thinking by borrowing the idea of a drive-through window as a way to provide some hospital services.</a:t>
            </a:r>
            <a:r>
              <a:rPr lang="en-US" sz="1800" b="0">
                <a:solidFill>
                  <a:srgbClr val="F2721E"/>
                </a:solidFill>
                <a:effectLst/>
                <a:latin typeface="ZapfDingbatsITC"/>
              </a:rPr>
              <a:t> </a:t>
            </a:r>
          </a:p>
          <a:p>
            <a:endParaRPr lang="en-US" sz="1800" b="0">
              <a:solidFill>
                <a:srgbClr val="211E1E"/>
              </a:solidFill>
              <a:effectLst/>
              <a:latin typeface="Frutiger"/>
            </a:endParaRPr>
          </a:p>
          <a:p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Or we might imagine some sort of hand-held GPS device to guide patients through our physical space because someone has suggested that we think for a moment about the randomly selected word “automobile”.</a:t>
            </a:r>
            <a:endParaRPr lang="en-US" sz="2800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036259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How do we think differently?</a:t>
            </a:r>
          </a:p>
          <a:p>
            <a:r>
              <a:rPr lang="en-US" sz="3500">
                <a:latin typeface="Poppins" pitchFamily="2" charset="77"/>
                <a:cs typeface="Poppins" pitchFamily="2" charset="77"/>
              </a:rPr>
              <a:t>3 main contributing mental actions: </a:t>
            </a:r>
            <a:r>
              <a:rPr lang="en-US" sz="3500" b="1">
                <a:latin typeface="Poppins" pitchFamily="2" charset="77"/>
                <a:cs typeface="Poppins" pitchFamily="2" charset="77"/>
              </a:rPr>
              <a:t>attention, escape, and movement</a:t>
            </a:r>
          </a:p>
          <a:p>
            <a:r>
              <a:rPr lang="en-US" sz="3500">
                <a:latin typeface="Poppins" pitchFamily="2" charset="77"/>
                <a:cs typeface="Poppins" pitchFamily="2" charset="77"/>
              </a:rPr>
              <a:t>Break it down: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020363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3500">
                <a:latin typeface="Poppins" pitchFamily="2" charset="77"/>
                <a:cs typeface="Poppins" pitchFamily="2" charset="77"/>
              </a:rPr>
              <a:t>Attention</a:t>
            </a:r>
          </a:p>
          <a:p>
            <a:pPr lvl="1"/>
            <a:r>
              <a:rPr lang="en-US" sz="14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Taking the time to list some of the current assumptions or  simple rules in the system</a:t>
            </a:r>
          </a:p>
          <a:p>
            <a:pPr lvl="1"/>
            <a:r>
              <a:rPr lang="en-US" sz="1400">
                <a:solidFill>
                  <a:srgbClr val="211E1E"/>
                </a:solidFill>
                <a:latin typeface="Poppins" pitchFamily="2" charset="77"/>
                <a:cs typeface="Poppins" pitchFamily="2" charset="77"/>
              </a:rPr>
              <a:t>I</a:t>
            </a:r>
            <a:r>
              <a:rPr lang="en-US" sz="14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nvolves looking closely, observing with fresh perspective, and really noticing things. </a:t>
            </a:r>
          </a:p>
          <a:p>
            <a:pPr lvl="1"/>
            <a:r>
              <a:rPr lang="en-US" sz="1400" b="0" i="1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“Patients who come to ER must first report to reception”</a:t>
            </a:r>
            <a:r>
              <a:rPr lang="en-US" sz="14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 </a:t>
            </a:r>
            <a:endParaRPr lang="en-US">
              <a:latin typeface="Poppins" pitchFamily="2" charset="77"/>
              <a:cs typeface="Poppins" pitchFamily="2" charset="77"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1697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284576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3500">
                <a:latin typeface="Poppins" pitchFamily="2" charset="77"/>
                <a:cs typeface="Poppins" pitchFamily="2" charset="77"/>
              </a:rPr>
              <a:t>Escape</a:t>
            </a:r>
          </a:p>
          <a:p>
            <a:pPr lvl="1"/>
            <a:r>
              <a:rPr lang="en-US" sz="18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When you challenge or block an existing rule, you are encouraging escape from the current mental valley. </a:t>
            </a:r>
          </a:p>
          <a:p>
            <a:pPr lvl="1"/>
            <a:r>
              <a:rPr lang="en-US" sz="18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We often describe this as “blue sky thinking” or “thinking outside the box” that </a:t>
            </a:r>
            <a:r>
              <a:rPr lang="en-US" sz="1800" b="1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purposefully</a:t>
            </a:r>
            <a:r>
              <a:rPr lang="en-US" sz="18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 moves away from the existing situation.</a:t>
            </a:r>
            <a:endParaRPr lang="en-US" sz="1800" b="0" i="1">
              <a:solidFill>
                <a:srgbClr val="211E1E"/>
              </a:solidFill>
              <a:effectLst/>
              <a:latin typeface="Poppins" pitchFamily="2" charset="77"/>
              <a:cs typeface="Poppins" pitchFamily="2" charset="77"/>
            </a:endParaRPr>
          </a:p>
          <a:p>
            <a:pPr lvl="1"/>
            <a:r>
              <a:rPr lang="en-US" sz="1800" b="0" i="1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“The government has made it illegal to have a receptionist and desk in the ER!”</a:t>
            </a:r>
            <a:endParaRPr lang="en-US">
              <a:latin typeface="Poppins" pitchFamily="2" charset="77"/>
              <a:cs typeface="Poppins" pitchFamily="2" charset="77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886380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3500">
                <a:latin typeface="Poppins" pitchFamily="2" charset="77"/>
                <a:cs typeface="Poppins" pitchFamily="2" charset="77"/>
              </a:rPr>
              <a:t>Movement</a:t>
            </a:r>
          </a:p>
          <a:p>
            <a:pPr lvl="1"/>
            <a:r>
              <a:rPr lang="en-US" sz="18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IDEA GENERATION!</a:t>
            </a:r>
          </a:p>
          <a:p>
            <a:pPr lvl="1"/>
            <a:r>
              <a:rPr lang="en-US" sz="18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When you then play imaginatively with this suggestion and generate several ideas from it without judgement or criticism</a:t>
            </a:r>
          </a:p>
          <a:p>
            <a:pPr marL="457200" marR="0" lvl="1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Mental movement is free association that is just allowed to flow in any direction it wishes without constraints for the moment. </a:t>
            </a:r>
          </a:p>
          <a:p>
            <a:pPr lvl="1"/>
            <a:r>
              <a:rPr lang="en-US" sz="1800" b="0" i="1">
                <a:solidFill>
                  <a:srgbClr val="211E1E"/>
                </a:solidFill>
                <a:effectLst/>
                <a:latin typeface="Poppins" pitchFamily="2" charset="77"/>
                <a:cs typeface="Poppins" pitchFamily="2" charset="77"/>
              </a:rPr>
              <a:t>(“Let’s try to generate at least seven ideas for ways to manage patient arrivals in the ER without a receptionist and a desk”)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139063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A common set of rules that have been restated and enhanced by psychologists, advertising heads, and the chief exec at design studio IDE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There are no bad ideas at this point. There will be plenty of time to judge later. </a:t>
            </a:r>
            <a:endParaRPr lang="en-US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045812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Don’t settle for 3 or 4 ideas; aim for 10-20. </a:t>
            </a:r>
            <a:endParaRPr lang="en-US">
              <a:effectLst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375854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It’s the wild ideas that often provide the breakthrough insights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These insights might lead to further ideas that are not so far fetched. </a:t>
            </a:r>
            <a:endParaRPr lang="en-US">
              <a:effectLst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859022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What can you add? What else? What other ideas does it bring to mind? </a:t>
            </a:r>
            <a:endParaRPr lang="en-US">
              <a:effectLst/>
            </a:endParaRP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4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223876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>
                <a:solidFill>
                  <a:srgbClr val="211E1E"/>
                </a:solidFill>
                <a:effectLst/>
                <a:latin typeface="Frutiger"/>
              </a:rPr>
              <a:t>This way all ideas can be heard and built upon. </a:t>
            </a:r>
            <a:endParaRPr lang="en-US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4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913783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4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4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8678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869317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4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144317"/>
      </p:ext>
    </p:extLst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4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610504"/>
      </p:ext>
    </p:extLst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4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921189"/>
      </p:ext>
    </p:extLst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4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937736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4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993308"/>
      </p:ext>
    </p:extLst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4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96981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20935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7266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690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24664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63C63D-0C1A-0E4C-A0BD-8D65A9542426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5083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parator Page">
    <p:bg>
      <p:bgPr>
        <a:blipFill rotWithShape="1">
          <a:blip r:embed="rId2"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0" y="2056080"/>
            <a:ext cx="12192000" cy="2738880"/>
          </a:xfrm>
        </p:spPr>
        <p:txBody>
          <a:bodyPr/>
          <a:lstStyle>
            <a:lvl1pPr algn="ctr">
              <a:defRPr>
                <a:solidFill>
                  <a:srgbClr val="404040"/>
                </a:solidFill>
                <a:latin typeface="Arial"/>
              </a:defRPr>
            </a:lvl1pPr>
          </a:lstStyle>
          <a:p>
            <a:r>
              <a:rPr lang="en-US"/>
              <a:t>Separator </a:t>
            </a:r>
          </a:p>
        </p:txBody>
      </p:sp>
    </p:spTree>
    <p:extLst>
      <p:ext uri="{BB962C8B-B14F-4D97-AF65-F5344CB8AC3E}">
        <p14:creationId xmlns:p14="http://schemas.microsoft.com/office/powerpoint/2010/main" val="611773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>
                <a:latin typeface="Arial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>
                <a:latin typeface="Arial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B362BA78-8688-C546-A03A-2A39F84C0B58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278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>
                <a:latin typeface="Arial"/>
              </a:defRPr>
            </a:lvl1pPr>
            <a:lvl2pPr>
              <a:defRPr>
                <a:latin typeface="Arial"/>
              </a:defRPr>
            </a:lvl2pPr>
            <a:lvl3pPr>
              <a:defRPr>
                <a:latin typeface="Arial"/>
              </a:defRPr>
            </a:lvl3pPr>
            <a:lvl4pPr>
              <a:defRPr>
                <a:latin typeface="Arial"/>
              </a:defRPr>
            </a:lvl4pPr>
            <a:lvl5pPr>
              <a:defRPr>
                <a:latin typeface="Arial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EF5B9135-15EF-DE46-84CC-16626B0FAF7F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/>
          <p:cNvSpPr txBox="1"/>
          <p:nvPr userDrawn="1"/>
        </p:nvSpPr>
        <p:spPr>
          <a:xfrm>
            <a:off x="4181596" y="-40608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800"/>
          </a:p>
        </p:txBody>
      </p:sp>
      <p:sp>
        <p:nvSpPr>
          <p:cNvPr id="8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165600" y="6356351"/>
            <a:ext cx="3860800" cy="365125"/>
          </a:xfrm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0293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>
            <a:lvl1pPr>
              <a:defRPr>
                <a:latin typeface="Arial"/>
              </a:defRPr>
            </a:lvl1pPr>
            <a:lvl2pPr>
              <a:defRPr>
                <a:latin typeface="Arial"/>
              </a:defRPr>
            </a:lvl2pPr>
            <a:lvl3pPr>
              <a:defRPr>
                <a:latin typeface="Arial"/>
              </a:defRPr>
            </a:lvl3pPr>
            <a:lvl4pPr>
              <a:defRPr>
                <a:latin typeface="Arial"/>
              </a:defRPr>
            </a:lvl4pPr>
            <a:lvl5pPr>
              <a:defRPr>
                <a:latin typeface="Arial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77ADD-011F-3541-9724-9C7FC92455D5}" type="datetime1">
              <a:rPr lang="en-US" smtClean="0"/>
              <a:t>1/27/26</a:t>
            </a:fld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165600" y="6356351"/>
            <a:ext cx="3860800" cy="365125"/>
          </a:xfrm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23212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+ 1 Column">
  <p:cSld name="Title + 1 Column">
    <p:spTree>
      <p:nvGrpSpPr>
        <p:cNvPr id="1" name="Shape 26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7" name="Google Shape;2657;p115"/>
          <p:cNvSpPr txBox="1">
            <a:spLocks noGrp="1"/>
          </p:cNvSpPr>
          <p:nvPr>
            <p:ph type="title"/>
          </p:nvPr>
        </p:nvSpPr>
        <p:spPr>
          <a:xfrm>
            <a:off x="618067" y="1117600"/>
            <a:ext cx="10354800" cy="132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>
            <a:lvl1pPr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658" name="Google Shape;2658;p115"/>
          <p:cNvSpPr txBox="1">
            <a:spLocks noGrp="1"/>
          </p:cNvSpPr>
          <p:nvPr>
            <p:ph type="body" idx="1"/>
          </p:nvPr>
        </p:nvSpPr>
        <p:spPr>
          <a:xfrm>
            <a:off x="618067" y="2438400"/>
            <a:ext cx="10354800" cy="381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>
            <a:lvl1pPr marL="609585" lvl="0" indent="-304792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98A2AB"/>
              </a:buClr>
              <a:buSzPts val="900"/>
              <a:buNone/>
              <a:defRPr>
                <a:solidFill>
                  <a:srgbClr val="98A2AB"/>
                </a:solidFill>
              </a:defRPr>
            </a:lvl1pPr>
            <a:lvl2pPr marL="1219170" lvl="1" indent="-380990" algn="l" rtl="0">
              <a:lnSpc>
                <a:spcPct val="115000"/>
              </a:lnSpc>
              <a:spcBef>
                <a:spcPts val="2133"/>
              </a:spcBef>
              <a:spcAft>
                <a:spcPts val="0"/>
              </a:spcAft>
              <a:buClr>
                <a:srgbClr val="98A2AB"/>
              </a:buClr>
              <a:buSzPts val="900"/>
              <a:buChar char="○"/>
              <a:defRPr>
                <a:solidFill>
                  <a:srgbClr val="98A2AB"/>
                </a:solidFill>
              </a:defRPr>
            </a:lvl2pPr>
            <a:lvl3pPr marL="1828754" lvl="2" indent="-380990" algn="l" rtl="0">
              <a:lnSpc>
                <a:spcPct val="115000"/>
              </a:lnSpc>
              <a:spcBef>
                <a:spcPts val="2133"/>
              </a:spcBef>
              <a:spcAft>
                <a:spcPts val="0"/>
              </a:spcAft>
              <a:buClr>
                <a:srgbClr val="98A2AB"/>
              </a:buClr>
              <a:buSzPts val="900"/>
              <a:buChar char="■"/>
              <a:defRPr>
                <a:solidFill>
                  <a:srgbClr val="98A2AB"/>
                </a:solidFill>
              </a:defRPr>
            </a:lvl3pPr>
            <a:lvl4pPr marL="2438339" lvl="3" indent="-380990" algn="l" rtl="0">
              <a:lnSpc>
                <a:spcPct val="115000"/>
              </a:lnSpc>
              <a:spcBef>
                <a:spcPts val="2133"/>
              </a:spcBef>
              <a:spcAft>
                <a:spcPts val="0"/>
              </a:spcAft>
              <a:buClr>
                <a:srgbClr val="98A2AB"/>
              </a:buClr>
              <a:buSzPts val="900"/>
              <a:buChar char="●"/>
              <a:defRPr>
                <a:solidFill>
                  <a:srgbClr val="98A2AB"/>
                </a:solidFill>
              </a:defRPr>
            </a:lvl4pPr>
            <a:lvl5pPr marL="3047924" lvl="4" indent="-380990" algn="l" rtl="0">
              <a:lnSpc>
                <a:spcPct val="115000"/>
              </a:lnSpc>
              <a:spcBef>
                <a:spcPts val="2133"/>
              </a:spcBef>
              <a:spcAft>
                <a:spcPts val="0"/>
              </a:spcAft>
              <a:buClr>
                <a:srgbClr val="98A2AB"/>
              </a:buClr>
              <a:buSzPts val="900"/>
              <a:buChar char="○"/>
              <a:defRPr>
                <a:solidFill>
                  <a:srgbClr val="98A2AB"/>
                </a:solidFill>
              </a:defRPr>
            </a:lvl5pPr>
            <a:lvl6pPr marL="3657509" lvl="5" indent="-380990" algn="l" rtl="0">
              <a:lnSpc>
                <a:spcPct val="115000"/>
              </a:lnSpc>
              <a:spcBef>
                <a:spcPts val="2133"/>
              </a:spcBef>
              <a:spcAft>
                <a:spcPts val="0"/>
              </a:spcAft>
              <a:buClr>
                <a:srgbClr val="98A2AB"/>
              </a:buClr>
              <a:buSzPts val="900"/>
              <a:buChar char="■"/>
              <a:defRPr>
                <a:solidFill>
                  <a:srgbClr val="98A2AB"/>
                </a:solidFill>
              </a:defRPr>
            </a:lvl6pPr>
            <a:lvl7pPr marL="4267093" lvl="6" indent="-380990" algn="l" rtl="0">
              <a:lnSpc>
                <a:spcPct val="115000"/>
              </a:lnSpc>
              <a:spcBef>
                <a:spcPts val="2133"/>
              </a:spcBef>
              <a:spcAft>
                <a:spcPts val="0"/>
              </a:spcAft>
              <a:buClr>
                <a:srgbClr val="98A2AB"/>
              </a:buClr>
              <a:buSzPts val="900"/>
              <a:buChar char="●"/>
              <a:defRPr>
                <a:solidFill>
                  <a:srgbClr val="98A2AB"/>
                </a:solidFill>
              </a:defRPr>
            </a:lvl7pPr>
            <a:lvl8pPr marL="4876678" lvl="7" indent="-380990" algn="l" rtl="0">
              <a:lnSpc>
                <a:spcPct val="115000"/>
              </a:lnSpc>
              <a:spcBef>
                <a:spcPts val="2133"/>
              </a:spcBef>
              <a:spcAft>
                <a:spcPts val="0"/>
              </a:spcAft>
              <a:buClr>
                <a:srgbClr val="98A2AB"/>
              </a:buClr>
              <a:buSzPts val="900"/>
              <a:buChar char="○"/>
              <a:defRPr>
                <a:solidFill>
                  <a:srgbClr val="98A2AB"/>
                </a:solidFill>
              </a:defRPr>
            </a:lvl8pPr>
            <a:lvl9pPr marL="5486263" lvl="8" indent="-380990" algn="l" rtl="0">
              <a:lnSpc>
                <a:spcPct val="115000"/>
              </a:lnSpc>
              <a:spcBef>
                <a:spcPts val="2133"/>
              </a:spcBef>
              <a:spcAft>
                <a:spcPts val="2133"/>
              </a:spcAft>
              <a:buClr>
                <a:srgbClr val="98A2AB"/>
              </a:buClr>
              <a:buSzPts val="900"/>
              <a:buChar char="■"/>
              <a:defRPr>
                <a:solidFill>
                  <a:srgbClr val="98A2AB"/>
                </a:solidFill>
              </a:defRPr>
            </a:lvl9pPr>
          </a:lstStyle>
          <a:p>
            <a:endParaRPr/>
          </a:p>
        </p:txBody>
      </p:sp>
      <p:sp>
        <p:nvSpPr>
          <p:cNvPr id="2659" name="Google Shape;2659;p115"/>
          <p:cNvSpPr txBox="1">
            <a:spLocks noGrp="1"/>
          </p:cNvSpPr>
          <p:nvPr>
            <p:ph type="sldNum" idx="12"/>
          </p:nvPr>
        </p:nvSpPr>
        <p:spPr>
          <a:xfrm>
            <a:off x="11582400" y="6258167"/>
            <a:ext cx="609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  <p:sp>
        <p:nvSpPr>
          <p:cNvPr id="2660" name="Google Shape;2660;p115"/>
          <p:cNvSpPr txBox="1">
            <a:spLocks noGrp="1"/>
          </p:cNvSpPr>
          <p:nvPr>
            <p:ph type="sldNum" idx="2"/>
          </p:nvPr>
        </p:nvSpPr>
        <p:spPr>
          <a:xfrm>
            <a:off x="11582400" y="6258167"/>
            <a:ext cx="609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600" b="0" i="0" u="none" strike="noStrike" cap="none">
                <a:solidFill>
                  <a:srgbClr val="98A4AF"/>
                </a:solidFill>
                <a:latin typeface="Karla"/>
                <a:ea typeface="Karla"/>
                <a:cs typeface="Karla"/>
                <a:sym typeface="Karla"/>
              </a:defRPr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65293751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73094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D3421027-4EC0-9C48-8CFB-B8A3104CB056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200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FA5DAB8B-8178-D047-869E-5A62AF236443}" type="datetime1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408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  <a:lvl2pPr>
              <a:defRPr>
                <a:latin typeface="Arial"/>
              </a:defRPr>
            </a:lvl2pPr>
            <a:lvl3pPr>
              <a:defRPr>
                <a:latin typeface="Arial"/>
              </a:defRPr>
            </a:lvl3pPr>
            <a:lvl4pPr>
              <a:defRPr>
                <a:latin typeface="Arial"/>
              </a:defRPr>
            </a:lvl4pPr>
            <a:lvl5pPr>
              <a:defRPr>
                <a:latin typeface="Arial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B9AB8213-A564-3C44-8CA0-968996562138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566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>
            <a:normAutofit/>
          </a:bodyPr>
          <a:lstStyle>
            <a:lvl1pPr algn="l">
              <a:defRPr sz="3200" b="1" cap="all"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0A83DA12-03A5-114A-ABAE-78CD6BB6AC19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636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>
                <a:latin typeface="Arial"/>
              </a:defRPr>
            </a:lvl1pPr>
            <a:lvl2pPr>
              <a:defRPr sz="2400">
                <a:latin typeface="Arial"/>
              </a:defRPr>
            </a:lvl2pPr>
            <a:lvl3pPr>
              <a:defRPr sz="2000">
                <a:latin typeface="Arial"/>
              </a:defRPr>
            </a:lvl3pPr>
            <a:lvl4pPr>
              <a:defRPr sz="1800">
                <a:latin typeface="Arial"/>
              </a:defRPr>
            </a:lvl4pPr>
            <a:lvl5pPr>
              <a:defRPr sz="1800">
                <a:latin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>
                <a:latin typeface="Arial"/>
              </a:defRPr>
            </a:lvl1pPr>
            <a:lvl2pPr>
              <a:defRPr sz="2400">
                <a:latin typeface="Arial"/>
              </a:defRPr>
            </a:lvl2pPr>
            <a:lvl3pPr>
              <a:defRPr sz="2000">
                <a:latin typeface="Arial"/>
              </a:defRPr>
            </a:lvl3pPr>
            <a:lvl4pPr>
              <a:defRPr sz="1800">
                <a:latin typeface="Arial"/>
              </a:defRPr>
            </a:lvl4pPr>
            <a:lvl5pPr>
              <a:defRPr sz="1800">
                <a:latin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FFF386F-14E4-954A-9EC2-E277FFD66D49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727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>
            <a:normAutofit/>
          </a:bodyPr>
          <a:lstStyle>
            <a:lvl1pPr marL="0" indent="0">
              <a:buNone/>
              <a:defRPr sz="2000" b="1">
                <a:latin typeface="Arial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>
                <a:latin typeface="Arial"/>
              </a:defRPr>
            </a:lvl1pPr>
            <a:lvl2pPr>
              <a:defRPr sz="2000">
                <a:latin typeface="Arial"/>
              </a:defRPr>
            </a:lvl2pPr>
            <a:lvl3pPr>
              <a:defRPr sz="1800">
                <a:latin typeface="Arial"/>
              </a:defRPr>
            </a:lvl3pPr>
            <a:lvl4pPr>
              <a:defRPr sz="1600">
                <a:latin typeface="Arial"/>
              </a:defRPr>
            </a:lvl4pPr>
            <a:lvl5pPr>
              <a:defRPr sz="1600">
                <a:latin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>
            <a:normAutofit/>
          </a:bodyPr>
          <a:lstStyle>
            <a:lvl1pPr marL="0" indent="0">
              <a:buNone/>
              <a:defRPr sz="2000" b="1">
                <a:latin typeface="Arial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>
                <a:latin typeface="Arial"/>
              </a:defRPr>
            </a:lvl1pPr>
            <a:lvl2pPr>
              <a:defRPr sz="2000">
                <a:latin typeface="Arial"/>
              </a:defRPr>
            </a:lvl2pPr>
            <a:lvl3pPr>
              <a:defRPr sz="1800">
                <a:latin typeface="Arial"/>
              </a:defRPr>
            </a:lvl3pPr>
            <a:lvl4pPr>
              <a:defRPr sz="1600">
                <a:latin typeface="Arial"/>
              </a:defRPr>
            </a:lvl4pPr>
            <a:lvl5pPr>
              <a:defRPr sz="1600">
                <a:latin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D8FFCF06-3344-8345-BEA6-DDAEFCC6ECCE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770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84C6D879-35D4-554E-9D6D-93E8130AA922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20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>
                <a:latin typeface="Arial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>
                <a:latin typeface="Arial"/>
              </a:defRPr>
            </a:lvl1pPr>
            <a:lvl2pPr>
              <a:defRPr sz="2800">
                <a:latin typeface="Arial"/>
              </a:defRPr>
            </a:lvl2pPr>
            <a:lvl3pPr>
              <a:defRPr sz="2400">
                <a:latin typeface="Arial"/>
              </a:defRPr>
            </a:lvl3pPr>
            <a:lvl4pPr>
              <a:defRPr sz="2000">
                <a:latin typeface="Arial"/>
              </a:defRPr>
            </a:lvl4pPr>
            <a:lvl5pPr>
              <a:defRPr sz="2000">
                <a:latin typeface="Arial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>
                <a:latin typeface="Arial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AB182AE3-760A-8E44-AB65-03A533386DFC}" type="datetime1">
              <a:rPr lang="en-US" smtClean="0"/>
              <a:pPr/>
              <a:t>1/2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246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 userDrawn="1"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176C-065F-124D-AAA4-94F2B7A2EC7C}" type="datetime1">
              <a:rPr lang="en-US" smtClean="0"/>
              <a:t>1/2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fld id="{106E12CD-FCB1-464E-A775-0B83FDDACE0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960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707" r:id="rId2"/>
    <p:sldLayoutId id="2147483701" r:id="rId3"/>
    <p:sldLayoutId id="2147483702" r:id="rId4"/>
    <p:sldLayoutId id="2147483703" r:id="rId5"/>
    <p:sldLayoutId id="2147483704" r:id="rId6"/>
    <p:sldLayoutId id="2147483705" r:id="rId7"/>
    <p:sldLayoutId id="2147483706" r:id="rId8"/>
    <p:sldLayoutId id="2147483708" r:id="rId9"/>
    <p:sldLayoutId id="2147483709" r:id="rId10"/>
    <p:sldLayoutId id="2147483710" r:id="rId11"/>
    <p:sldLayoutId id="2147483711" r:id="rId12"/>
    <p:sldLayoutId id="2147483712" r:id="rId13"/>
    <p:sldLayoutId id="2147483713" r:id="rId14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Arial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Arial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Arial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Arial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Arial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Arial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3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3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3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4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4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4.xml"/><Relationship Id="rId6" Type="http://schemas.openxmlformats.org/officeDocument/2006/relationships/diagramColors" Target="../diagrams/colors3.xml"/><Relationship Id="rId5" Type="http://schemas.openxmlformats.org/officeDocument/2006/relationships/diagramQuickStyle" Target="../diagrams/quickStyle3.xml"/><Relationship Id="rId4" Type="http://schemas.openxmlformats.org/officeDocument/2006/relationships/diagramLayout" Target="../diagrams/layout3.xml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3" Type="http://schemas.openxmlformats.org/officeDocument/2006/relationships/diagramData" Target="../diagrams/data4.xml"/><Relationship Id="rId7" Type="http://schemas.microsoft.com/office/2007/relationships/diagramDrawing" Target="../diagrams/drawing4.xml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4.xml"/><Relationship Id="rId6" Type="http://schemas.openxmlformats.org/officeDocument/2006/relationships/diagramColors" Target="../diagrams/colors4.xml"/><Relationship Id="rId5" Type="http://schemas.openxmlformats.org/officeDocument/2006/relationships/diagramQuickStyle" Target="../diagrams/quickStyle4.xml"/><Relationship Id="rId4" Type="http://schemas.openxmlformats.org/officeDocument/2006/relationships/diagramLayout" Target="../diagrams/layout4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5.xml"/><Relationship Id="rId7" Type="http://schemas.microsoft.com/office/2007/relationships/diagramDrawing" Target="../diagrams/drawing5.xml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4.xml"/><Relationship Id="rId6" Type="http://schemas.openxmlformats.org/officeDocument/2006/relationships/diagramColors" Target="../diagrams/colors5.xml"/><Relationship Id="rId5" Type="http://schemas.openxmlformats.org/officeDocument/2006/relationships/diagramQuickStyle" Target="../diagrams/quickStyle5.xml"/><Relationship Id="rId4" Type="http://schemas.openxmlformats.org/officeDocument/2006/relationships/diagramLayout" Target="../diagrams/layout5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6.xml"/><Relationship Id="rId7" Type="http://schemas.microsoft.com/office/2007/relationships/diagramDrawing" Target="../diagrams/drawing6.xml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4.xml"/><Relationship Id="rId6" Type="http://schemas.openxmlformats.org/officeDocument/2006/relationships/diagramColors" Target="../diagrams/colors6.xml"/><Relationship Id="rId5" Type="http://schemas.openxmlformats.org/officeDocument/2006/relationships/diagramQuickStyle" Target="../diagrams/quickStyle6.xml"/><Relationship Id="rId4" Type="http://schemas.openxmlformats.org/officeDocument/2006/relationships/diagramLayout" Target="../diagrams/layout6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7.xml"/><Relationship Id="rId7" Type="http://schemas.microsoft.com/office/2007/relationships/diagramDrawing" Target="../diagrams/drawing7.xml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4.xml"/><Relationship Id="rId6" Type="http://schemas.openxmlformats.org/officeDocument/2006/relationships/diagramColors" Target="../diagrams/colors7.xml"/><Relationship Id="rId5" Type="http://schemas.openxmlformats.org/officeDocument/2006/relationships/diagramQuickStyle" Target="../diagrams/quickStyle7.xml"/><Relationship Id="rId4" Type="http://schemas.openxmlformats.org/officeDocument/2006/relationships/diagramLayout" Target="../diagrams/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4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sv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4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4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4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4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4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4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4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19.svg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19.svg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19.sv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19.svg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19.svg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19.svg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21.svg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4.xml"/></Relationships>
</file>

<file path=ppt/slides/_rels/slide4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sv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14.xml"/><Relationship Id="rId6" Type="http://schemas.openxmlformats.org/officeDocument/2006/relationships/image" Target="../media/image25.svg"/><Relationship Id="rId5" Type="http://schemas.openxmlformats.org/officeDocument/2006/relationships/image" Target="../media/image24.png"/><Relationship Id="rId10" Type="http://schemas.openxmlformats.org/officeDocument/2006/relationships/image" Target="../media/image29.svg"/><Relationship Id="rId4" Type="http://schemas.openxmlformats.org/officeDocument/2006/relationships/image" Target="../media/image23.svg"/><Relationship Id="rId9" Type="http://schemas.openxmlformats.org/officeDocument/2006/relationships/image" Target="../media/image28.png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21.svg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4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4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45299"/>
            <a:ext cx="12192000" cy="6911391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81201" y="2343879"/>
            <a:ext cx="9487358" cy="850967"/>
          </a:xfrm>
        </p:spPr>
        <p:txBody>
          <a:bodyPr>
            <a:noAutofit/>
          </a:bodyPr>
          <a:lstStyle/>
          <a:p>
            <a:pPr>
              <a:spcBef>
                <a:spcPts val="0"/>
              </a:spcBef>
            </a:pPr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Developing a </a:t>
            </a:r>
            <a:r>
              <a:rPr lang="en-US" sz="2400" b="1" u="sng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</a:t>
            </a:r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hronic </a:t>
            </a:r>
            <a:r>
              <a:rPr lang="en-US" sz="2400" b="1" u="sng" dirty="0">
                <a:solidFill>
                  <a:schemeClr val="tx1">
                    <a:lumMod val="75000"/>
                    <a:lumOff val="25000"/>
                  </a:schemeClr>
                </a:solidFill>
              </a:rPr>
              <a:t>O</a:t>
            </a:r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pioid Use </a:t>
            </a:r>
            <a:r>
              <a:rPr lang="en-US" sz="2400" b="1" u="sng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</a:t>
            </a:r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ssessment and </a:t>
            </a:r>
            <a:r>
              <a:rPr lang="en-US" sz="2400" b="1" u="sng" dirty="0">
                <a:solidFill>
                  <a:schemeClr val="tx1">
                    <a:lumMod val="75000"/>
                    <a:lumOff val="25000"/>
                  </a:schemeClr>
                </a:solidFill>
              </a:rPr>
              <a:t>S</a:t>
            </a:r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reening </a:t>
            </a:r>
            <a:r>
              <a:rPr lang="en-US" sz="2400" b="1" u="sng" dirty="0">
                <a:solidFill>
                  <a:schemeClr val="tx1">
                    <a:lumMod val="75000"/>
                    <a:lumOff val="25000"/>
                  </a:schemeClr>
                </a:solidFill>
              </a:rPr>
              <a:t>T</a:t>
            </a:r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ool (COAST) for Young Adults with IBD</a:t>
            </a:r>
            <a:endParaRPr lang="en-US" sz="20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r>
              <a:rPr lang="en-US" sz="20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o-Design Session</a:t>
            </a:r>
          </a:p>
          <a:p>
            <a:endParaRPr lang="en-US" sz="20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endParaRPr lang="en-US" sz="16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C6824E4-5791-4EA2-AD19-71465DEFC1D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23728" y="6362508"/>
            <a:ext cx="2003223" cy="583351"/>
          </a:xfrm>
          <a:prstGeom prst="rect">
            <a:avLst/>
          </a:prstGeom>
        </p:spPr>
      </p:pic>
      <p:pic>
        <p:nvPicPr>
          <p:cNvPr id="4" name="Picture 3" descr="Logo, company name&#10;&#10;Description automatically generated">
            <a:extLst>
              <a:ext uri="{FF2B5EF4-FFF2-40B4-BE49-F238E27FC236}">
                <a16:creationId xmlns:a16="http://schemas.microsoft.com/office/drawing/2014/main" id="{F5A25F48-FFA0-68CD-0513-D6B3088BC8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10800" y="5008765"/>
            <a:ext cx="1922546" cy="1273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43333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b="1"/>
              <a:t>Key questions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9</a:t>
            </a:fld>
            <a:endParaRPr lang="en-US"/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105027" y="1641655"/>
            <a:ext cx="6278124" cy="1017639"/>
          </a:xfrm>
        </p:spPr>
        <p:txBody>
          <a:bodyPr anchor="ctr">
            <a:noAutofit/>
          </a:bodyPr>
          <a:lstStyle/>
          <a:p>
            <a:pPr marL="0" indent="0">
              <a:buNone/>
            </a:pPr>
            <a:r>
              <a:rPr lang="en-US" sz="1800"/>
              <a:t>What are the predictors of chronic opioid use among AYA with IBD and other painful, chronic digestive disorders?</a:t>
            </a:r>
          </a:p>
        </p:txBody>
      </p:sp>
      <p:sp>
        <p:nvSpPr>
          <p:cNvPr id="8" name="Subtitle 2">
            <a:extLst>
              <a:ext uri="{FF2B5EF4-FFF2-40B4-BE49-F238E27FC236}">
                <a16:creationId xmlns:a16="http://schemas.microsoft.com/office/drawing/2014/main" id="{C4E81C43-478B-4233-9B46-8E1E79A77FDB}"/>
              </a:ext>
            </a:extLst>
          </p:cNvPr>
          <p:cNvSpPr txBox="1">
            <a:spLocks/>
          </p:cNvSpPr>
          <p:nvPr/>
        </p:nvSpPr>
        <p:spPr>
          <a:xfrm>
            <a:off x="1901332" y="1932039"/>
            <a:ext cx="8389345" cy="35543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00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1780968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2945815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4110663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 txBox="1">
            <a:spLocks/>
          </p:cNvSpPr>
          <p:nvPr/>
        </p:nvSpPr>
        <p:spPr>
          <a:xfrm>
            <a:off x="3105027" y="2748456"/>
            <a:ext cx="6278124" cy="10176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/>
              <a:t>To deliver personalized chronic opioid use information to end-users (AYA and clinicians), what should the design of a digital opioid safety intervention look like? </a:t>
            </a:r>
          </a:p>
        </p:txBody>
      </p:sp>
      <p:sp>
        <p:nvSpPr>
          <p:cNvPr id="17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 txBox="1">
            <a:spLocks/>
          </p:cNvSpPr>
          <p:nvPr/>
        </p:nvSpPr>
        <p:spPr>
          <a:xfrm>
            <a:off x="3105027" y="3907127"/>
            <a:ext cx="6278124" cy="10176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/>
              <a:t>When we develop and pilot test the intervention, to what extent is it feasible and usable by end-users?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A26D019-0CC8-E240-A649-02744D8DDA46}"/>
              </a:ext>
            </a:extLst>
          </p:cNvPr>
          <p:cNvSpPr txBox="1"/>
          <p:nvPr/>
        </p:nvSpPr>
        <p:spPr>
          <a:xfrm>
            <a:off x="9907372" y="1643257"/>
            <a:ext cx="2006600" cy="1200329"/>
          </a:xfrm>
          <a:prstGeom prst="rect">
            <a:avLst/>
          </a:prstGeom>
          <a:solidFill>
            <a:schemeClr val="bg2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We will also share key findings from this work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EE3CD2C-A7AE-08CB-E0F7-7D9DD9E49632}"/>
              </a:ext>
            </a:extLst>
          </p:cNvPr>
          <p:cNvCxnSpPr>
            <a:cxnSpLocks/>
          </p:cNvCxnSpPr>
          <p:nvPr/>
        </p:nvCxnSpPr>
        <p:spPr>
          <a:xfrm flipH="1">
            <a:off x="9407517" y="2221115"/>
            <a:ext cx="4588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807FA023-9557-35D5-F2BD-86F0E0EBE6A6}"/>
              </a:ext>
            </a:extLst>
          </p:cNvPr>
          <p:cNvSpPr/>
          <p:nvPr/>
        </p:nvSpPr>
        <p:spPr>
          <a:xfrm>
            <a:off x="3105027" y="1780968"/>
            <a:ext cx="6278124" cy="826456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0869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/>
              <a:t>What have we learned so far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sz="2800"/>
              <a:t>We looked at NM EDW data (2018-2021) for 15-29 year old patients with IBD and other chronic GI disorders</a:t>
            </a:r>
          </a:p>
          <a:p>
            <a:endParaRPr lang="en-US" sz="2800"/>
          </a:p>
          <a:p>
            <a:r>
              <a:rPr lang="en-US" sz="2800"/>
              <a:t>Focused on describing </a:t>
            </a:r>
            <a:r>
              <a:rPr lang="en-US" sz="2800" b="1"/>
              <a:t>chronic opioid use </a:t>
            </a:r>
            <a:r>
              <a:rPr lang="en-US" sz="2800"/>
              <a:t>(≥90 consecutive days opioid receipt over 1 </a:t>
            </a:r>
            <a:r>
              <a:rPr lang="en-US" sz="2800" err="1"/>
              <a:t>yr</a:t>
            </a:r>
            <a:r>
              <a:rPr lang="en-US" sz="2800"/>
              <a:t>) </a:t>
            </a:r>
            <a:r>
              <a:rPr lang="en-US" sz="2800">
                <a:sym typeface="Wingdings" panose="05000000000000000000" pitchFamily="2" charset="2"/>
              </a:rPr>
              <a:t> gateway to opioid dependence </a:t>
            </a:r>
          </a:p>
          <a:p>
            <a:endParaRPr lang="en-US" sz="2800">
              <a:sym typeface="Wingdings" panose="05000000000000000000" pitchFamily="2" charset="2"/>
            </a:endParaRPr>
          </a:p>
          <a:p>
            <a:r>
              <a:rPr lang="en-US" sz="2800">
                <a:sym typeface="Wingdings" panose="05000000000000000000" pitchFamily="2" charset="2"/>
              </a:rPr>
              <a:t>Building a predictive model to understand risk factors</a:t>
            </a:r>
          </a:p>
          <a:p>
            <a:endParaRPr lang="en-US" sz="2800">
              <a:solidFill>
                <a:schemeClr val="bg1"/>
              </a:solidFill>
            </a:endParaRPr>
          </a:p>
          <a:p>
            <a:r>
              <a:rPr lang="en-US" sz="2800">
                <a:solidFill>
                  <a:schemeClr val="bg1"/>
                </a:solidFill>
              </a:rPr>
              <a:t>In a cohort of ~9K patients, &gt;30% had </a:t>
            </a:r>
            <a:r>
              <a:rPr lang="en-US" sz="28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1 opioid prescription</a:t>
            </a:r>
            <a:endParaRPr lang="en-US" sz="2800">
              <a:solidFill>
                <a:schemeClr val="bg1"/>
              </a:solidFill>
            </a:endParaRPr>
          </a:p>
          <a:p>
            <a:endParaRPr lang="en-US" sz="2800">
              <a:solidFill>
                <a:schemeClr val="bg1"/>
              </a:solidFill>
            </a:endParaRPr>
          </a:p>
          <a:p>
            <a:r>
              <a:rPr lang="en-US" sz="2800">
                <a:solidFill>
                  <a:schemeClr val="bg1"/>
                </a:solidFill>
              </a:rPr>
              <a:t>Among those (~3K patients), chronic opioid use ranged ~50-67%</a:t>
            </a:r>
          </a:p>
          <a:p>
            <a:endParaRPr lang="en-US" sz="280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8523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/>
              <a:t>What have we learned so far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sz="2800"/>
              <a:t>We looked at NM EDW data (2018-2021) for 15-29 year old patients with IBD and other chronic GI disorders</a:t>
            </a:r>
          </a:p>
          <a:p>
            <a:endParaRPr lang="en-US" sz="2800"/>
          </a:p>
          <a:p>
            <a:r>
              <a:rPr lang="en-US" sz="2800"/>
              <a:t>Focused on describing </a:t>
            </a:r>
            <a:r>
              <a:rPr lang="en-US" sz="2800" b="1"/>
              <a:t>chronic opioid use </a:t>
            </a:r>
            <a:r>
              <a:rPr lang="en-US" sz="2800"/>
              <a:t>(≥90 consecutive days opioid receipt over 1 </a:t>
            </a:r>
            <a:r>
              <a:rPr lang="en-US" sz="2800" err="1"/>
              <a:t>yr</a:t>
            </a:r>
            <a:r>
              <a:rPr lang="en-US" sz="2800"/>
              <a:t>) </a:t>
            </a:r>
            <a:r>
              <a:rPr lang="en-US" sz="2800">
                <a:sym typeface="Wingdings" panose="05000000000000000000" pitchFamily="2" charset="2"/>
              </a:rPr>
              <a:t> gateway to opioid dependence </a:t>
            </a:r>
          </a:p>
          <a:p>
            <a:endParaRPr lang="en-US" sz="2800">
              <a:sym typeface="Wingdings" panose="05000000000000000000" pitchFamily="2" charset="2"/>
            </a:endParaRPr>
          </a:p>
          <a:p>
            <a:r>
              <a:rPr lang="en-US" sz="2800">
                <a:sym typeface="Wingdings" panose="05000000000000000000" pitchFamily="2" charset="2"/>
              </a:rPr>
              <a:t>Building a predictive model to understand risk factors</a:t>
            </a:r>
          </a:p>
          <a:p>
            <a:endParaRPr lang="en-US" sz="2800"/>
          </a:p>
          <a:p>
            <a:r>
              <a:rPr lang="en-US" sz="2800"/>
              <a:t>In a cohort of ~9K patients, a third had </a:t>
            </a:r>
            <a:r>
              <a:rPr lang="en-US" sz="2800">
                <a:latin typeface="Arial" panose="020B0604020202020204" pitchFamily="34" charset="0"/>
                <a:cs typeface="Arial" panose="020B0604020202020204" pitchFamily="34" charset="0"/>
              </a:rPr>
              <a:t>≥1 opioid prescription</a:t>
            </a:r>
            <a:endParaRPr lang="en-US" sz="2800"/>
          </a:p>
          <a:p>
            <a:endParaRPr lang="en-US" sz="2800"/>
          </a:p>
          <a:p>
            <a:r>
              <a:rPr lang="en-US" sz="2800"/>
              <a:t>Among those (~3K patients), chronic opioid use ranged ~50-67%</a:t>
            </a:r>
          </a:p>
          <a:p>
            <a:endParaRPr lang="en-US" sz="280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84447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5F71684-C088-43D4-6DFD-941BFFC4B3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1981" t="5163" r="-1351" b="82314"/>
          <a:stretch/>
        </p:blipFill>
        <p:spPr>
          <a:xfrm>
            <a:off x="984739" y="5303339"/>
            <a:ext cx="2986036" cy="1053012"/>
          </a:xfrm>
          <a:prstGeom prst="rect">
            <a:avLst/>
          </a:prstGeom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2</a:t>
            </a:fld>
            <a:endParaRPr lang="en-US"/>
          </a:p>
        </p:txBody>
      </p:sp>
      <p:pic>
        <p:nvPicPr>
          <p:cNvPr id="7" name="Picture 6" descr="A graph of a bar&#10;&#10;Description automatically generated">
            <a:extLst>
              <a:ext uri="{FF2B5EF4-FFF2-40B4-BE49-F238E27FC236}">
                <a16:creationId xmlns:a16="http://schemas.microsoft.com/office/drawing/2014/main" id="{514B3B24-2F15-43EC-7297-B3645683FD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8223"/>
          <a:stretch/>
        </p:blipFill>
        <p:spPr>
          <a:xfrm>
            <a:off x="984739" y="291034"/>
            <a:ext cx="10012454" cy="502952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8A0BB296-AE7F-2C1E-542F-EEF1AA53728E}"/>
              </a:ext>
            </a:extLst>
          </p:cNvPr>
          <p:cNvSpPr/>
          <p:nvPr/>
        </p:nvSpPr>
        <p:spPr>
          <a:xfrm>
            <a:off x="984739" y="5479249"/>
            <a:ext cx="1205802" cy="19091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A11CEC7-3C57-8DB4-705C-C6E61B0E2CC0}"/>
              </a:ext>
            </a:extLst>
          </p:cNvPr>
          <p:cNvSpPr/>
          <p:nvPr/>
        </p:nvSpPr>
        <p:spPr>
          <a:xfrm>
            <a:off x="984739" y="1818640"/>
            <a:ext cx="210068" cy="1828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2689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5F71684-C088-43D4-6DFD-941BFFC4B3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1981" t="5163" r="-1351" b="82314"/>
          <a:stretch/>
        </p:blipFill>
        <p:spPr>
          <a:xfrm>
            <a:off x="984739" y="5303339"/>
            <a:ext cx="2986036" cy="1053012"/>
          </a:xfrm>
          <a:prstGeom prst="rect">
            <a:avLst/>
          </a:prstGeom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3</a:t>
            </a:fld>
            <a:endParaRPr lang="en-US"/>
          </a:p>
        </p:txBody>
      </p:sp>
      <p:pic>
        <p:nvPicPr>
          <p:cNvPr id="7" name="Picture 6" descr="A graph of a bar&#10;&#10;Description automatically generated">
            <a:extLst>
              <a:ext uri="{FF2B5EF4-FFF2-40B4-BE49-F238E27FC236}">
                <a16:creationId xmlns:a16="http://schemas.microsoft.com/office/drawing/2014/main" id="{514B3B24-2F15-43EC-7297-B3645683FD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8223"/>
          <a:stretch/>
        </p:blipFill>
        <p:spPr>
          <a:xfrm>
            <a:off x="984739" y="291034"/>
            <a:ext cx="10012454" cy="502952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8A0BB296-AE7F-2C1E-542F-EEF1AA53728E}"/>
              </a:ext>
            </a:extLst>
          </p:cNvPr>
          <p:cNvSpPr/>
          <p:nvPr/>
        </p:nvSpPr>
        <p:spPr>
          <a:xfrm>
            <a:off x="984739" y="5479249"/>
            <a:ext cx="1205802" cy="19091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A11CEC7-3C57-8DB4-705C-C6E61B0E2CC0}"/>
              </a:ext>
            </a:extLst>
          </p:cNvPr>
          <p:cNvSpPr/>
          <p:nvPr/>
        </p:nvSpPr>
        <p:spPr>
          <a:xfrm>
            <a:off x="984739" y="1818640"/>
            <a:ext cx="210068" cy="1828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8443416-B1B6-D9C6-CC4A-CECD6787C0D5}"/>
              </a:ext>
            </a:extLst>
          </p:cNvPr>
          <p:cNvSpPr/>
          <p:nvPr/>
        </p:nvSpPr>
        <p:spPr>
          <a:xfrm>
            <a:off x="6912864" y="630936"/>
            <a:ext cx="1380744" cy="4848313"/>
          </a:xfrm>
          <a:prstGeom prst="rect">
            <a:avLst/>
          </a:prstGeom>
          <a:noFill/>
          <a:ln w="57150">
            <a:solidFill>
              <a:schemeClr val="tx2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66223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5F71684-C088-43D4-6DFD-941BFFC4B3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1981" t="5163" r="-1351" b="82314"/>
          <a:stretch/>
        </p:blipFill>
        <p:spPr>
          <a:xfrm>
            <a:off x="984739" y="5303339"/>
            <a:ext cx="2986036" cy="1053012"/>
          </a:xfrm>
          <a:prstGeom prst="rect">
            <a:avLst/>
          </a:prstGeom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4</a:t>
            </a:fld>
            <a:endParaRPr lang="en-US"/>
          </a:p>
        </p:txBody>
      </p:sp>
      <p:pic>
        <p:nvPicPr>
          <p:cNvPr id="7" name="Picture 6" descr="A graph of a bar&#10;&#10;Description automatically generated">
            <a:extLst>
              <a:ext uri="{FF2B5EF4-FFF2-40B4-BE49-F238E27FC236}">
                <a16:creationId xmlns:a16="http://schemas.microsoft.com/office/drawing/2014/main" id="{514B3B24-2F15-43EC-7297-B3645683FD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8223"/>
          <a:stretch/>
        </p:blipFill>
        <p:spPr>
          <a:xfrm>
            <a:off x="984739" y="291034"/>
            <a:ext cx="10012454" cy="502952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8A0BB296-AE7F-2C1E-542F-EEF1AA53728E}"/>
              </a:ext>
            </a:extLst>
          </p:cNvPr>
          <p:cNvSpPr/>
          <p:nvPr/>
        </p:nvSpPr>
        <p:spPr>
          <a:xfrm>
            <a:off x="984739" y="5479249"/>
            <a:ext cx="1205802" cy="19091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A11CEC7-3C57-8DB4-705C-C6E61B0E2CC0}"/>
              </a:ext>
            </a:extLst>
          </p:cNvPr>
          <p:cNvSpPr/>
          <p:nvPr/>
        </p:nvSpPr>
        <p:spPr>
          <a:xfrm>
            <a:off x="984739" y="1818640"/>
            <a:ext cx="210068" cy="1828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8443416-B1B6-D9C6-CC4A-CECD6787C0D5}"/>
              </a:ext>
            </a:extLst>
          </p:cNvPr>
          <p:cNvSpPr/>
          <p:nvPr/>
        </p:nvSpPr>
        <p:spPr>
          <a:xfrm>
            <a:off x="6912864" y="630936"/>
            <a:ext cx="1380744" cy="4848313"/>
          </a:xfrm>
          <a:prstGeom prst="rect">
            <a:avLst/>
          </a:prstGeom>
          <a:noFill/>
          <a:ln w="57150">
            <a:solidFill>
              <a:schemeClr val="tx2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FC7F11D-243D-B32F-7E42-05F7F1D2D91E}"/>
              </a:ext>
            </a:extLst>
          </p:cNvPr>
          <p:cNvSpPr/>
          <p:nvPr/>
        </p:nvSpPr>
        <p:spPr>
          <a:xfrm>
            <a:off x="7754112" y="4617720"/>
            <a:ext cx="384048" cy="237744"/>
          </a:xfrm>
          <a:prstGeom prst="rect">
            <a:avLst/>
          </a:prstGeom>
          <a:noFill/>
          <a:ln w="38100">
            <a:solidFill>
              <a:schemeClr val="tx2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54748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5F71684-C088-43D4-6DFD-941BFFC4B3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1981" t="5163" r="-1351" b="82314"/>
          <a:stretch/>
        </p:blipFill>
        <p:spPr>
          <a:xfrm>
            <a:off x="984739" y="5303339"/>
            <a:ext cx="2986036" cy="1053012"/>
          </a:xfrm>
          <a:prstGeom prst="rect">
            <a:avLst/>
          </a:prstGeom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5</a:t>
            </a:fld>
            <a:endParaRPr lang="en-US"/>
          </a:p>
        </p:txBody>
      </p:sp>
      <p:pic>
        <p:nvPicPr>
          <p:cNvPr id="7" name="Picture 6" descr="A graph of a bar&#10;&#10;Description automatically generated">
            <a:extLst>
              <a:ext uri="{FF2B5EF4-FFF2-40B4-BE49-F238E27FC236}">
                <a16:creationId xmlns:a16="http://schemas.microsoft.com/office/drawing/2014/main" id="{514B3B24-2F15-43EC-7297-B3645683FD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8223"/>
          <a:stretch/>
        </p:blipFill>
        <p:spPr>
          <a:xfrm>
            <a:off x="984739" y="291034"/>
            <a:ext cx="10012454" cy="502952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8A0BB296-AE7F-2C1E-542F-EEF1AA53728E}"/>
              </a:ext>
            </a:extLst>
          </p:cNvPr>
          <p:cNvSpPr/>
          <p:nvPr/>
        </p:nvSpPr>
        <p:spPr>
          <a:xfrm>
            <a:off x="984739" y="5479249"/>
            <a:ext cx="1205802" cy="19091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A11CEC7-3C57-8DB4-705C-C6E61B0E2CC0}"/>
              </a:ext>
            </a:extLst>
          </p:cNvPr>
          <p:cNvSpPr/>
          <p:nvPr/>
        </p:nvSpPr>
        <p:spPr>
          <a:xfrm>
            <a:off x="984739" y="1818640"/>
            <a:ext cx="210068" cy="1828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8443416-B1B6-D9C6-CC4A-CECD6787C0D5}"/>
              </a:ext>
            </a:extLst>
          </p:cNvPr>
          <p:cNvSpPr/>
          <p:nvPr/>
        </p:nvSpPr>
        <p:spPr>
          <a:xfrm>
            <a:off x="6912864" y="630936"/>
            <a:ext cx="1380744" cy="4848313"/>
          </a:xfrm>
          <a:prstGeom prst="rect">
            <a:avLst/>
          </a:prstGeom>
          <a:noFill/>
          <a:ln w="57150">
            <a:solidFill>
              <a:schemeClr val="tx2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FC7F11D-243D-B32F-7E42-05F7F1D2D91E}"/>
              </a:ext>
            </a:extLst>
          </p:cNvPr>
          <p:cNvSpPr/>
          <p:nvPr/>
        </p:nvSpPr>
        <p:spPr>
          <a:xfrm>
            <a:off x="7754112" y="4617720"/>
            <a:ext cx="384048" cy="237744"/>
          </a:xfrm>
          <a:prstGeom prst="rect">
            <a:avLst/>
          </a:prstGeom>
          <a:noFill/>
          <a:ln w="38100">
            <a:solidFill>
              <a:schemeClr val="tx2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A780AFB-2A46-0468-AC2F-0DA353D1A78F}"/>
              </a:ext>
            </a:extLst>
          </p:cNvPr>
          <p:cNvSpPr/>
          <p:nvPr/>
        </p:nvSpPr>
        <p:spPr>
          <a:xfrm>
            <a:off x="7065264" y="2301240"/>
            <a:ext cx="384048" cy="237744"/>
          </a:xfrm>
          <a:prstGeom prst="rect">
            <a:avLst/>
          </a:prstGeom>
          <a:noFill/>
          <a:ln w="38100">
            <a:solidFill>
              <a:schemeClr val="tx2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32187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6</a:t>
            </a:fld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64D9789E-D50D-89D0-533A-4089CAEC5CC8}"/>
              </a:ext>
            </a:extLst>
          </p:cNvPr>
          <p:cNvSpPr txBox="1">
            <a:spLocks/>
          </p:cNvSpPr>
          <p:nvPr/>
        </p:nvSpPr>
        <p:spPr>
          <a:xfrm>
            <a:off x="472440" y="82830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r>
              <a:rPr lang="en-US" b="1"/>
              <a:t>Risk Score Development</a:t>
            </a:r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B3DB9D05-15BE-770F-6C66-9CF783534A87}"/>
              </a:ext>
            </a:extLst>
          </p:cNvPr>
          <p:cNvSpPr/>
          <p:nvPr/>
        </p:nvSpPr>
        <p:spPr>
          <a:xfrm>
            <a:off x="4606290" y="4705378"/>
            <a:ext cx="45720" cy="45719"/>
          </a:xfrm>
          <a:prstGeom prst="ellips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A7BD2218-78AB-1AEF-2627-EBAC2579BF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2346213"/>
              </p:ext>
            </p:extLst>
          </p:nvPr>
        </p:nvGraphicFramePr>
        <p:xfrm>
          <a:off x="2250440" y="1391920"/>
          <a:ext cx="7704346" cy="375518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18994">
                  <a:extLst>
                    <a:ext uri="{9D8B030D-6E8A-4147-A177-3AD203B41FA5}">
                      <a16:colId xmlns:a16="http://schemas.microsoft.com/office/drawing/2014/main" val="3659163071"/>
                    </a:ext>
                  </a:extLst>
                </a:gridCol>
                <a:gridCol w="4285352">
                  <a:extLst>
                    <a:ext uri="{9D8B030D-6E8A-4147-A177-3AD203B41FA5}">
                      <a16:colId xmlns:a16="http://schemas.microsoft.com/office/drawing/2014/main" val="2723358237"/>
                    </a:ext>
                  </a:extLst>
                </a:gridCol>
              </a:tblGrid>
              <a:tr h="780520">
                <a:tc>
                  <a:txBody>
                    <a:bodyPr/>
                    <a:lstStyle/>
                    <a:p>
                      <a:r>
                        <a:rPr lang="en-US"/>
                        <a:t>Factors Associated with Lower Odds of Chronic Opioid Use</a:t>
                      </a:r>
                    </a:p>
                  </a:txBody>
                  <a:tcP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/>
                        <a:t>Factors Associated with Higher Odds of Chronic Opioid Use</a:t>
                      </a:r>
                    </a:p>
                  </a:txBody>
                  <a:tcPr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9718396"/>
                  </a:ext>
                </a:extLst>
              </a:tr>
              <a:tr h="2974669">
                <a:tc>
                  <a:txBody>
                    <a:bodyPr/>
                    <a:lstStyle/>
                    <a:p>
                      <a:pPr marL="28575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Age 19 or younger 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Hispanic race/ethnicity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Concurrent </a:t>
                      </a: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ADHD dx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Appendectomy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performed during study period</a:t>
                      </a: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utpatient visit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within 6 months prior to cohort entry date</a:t>
                      </a:r>
                    </a:p>
                  </a:txBody>
                  <a:tcP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Public insurance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(Medicare or Medicaid)</a:t>
                      </a: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Non-digestive surgery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performed during study period</a:t>
                      </a: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utpatient </a:t>
                      </a: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Codeine Rx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utpatient </a:t>
                      </a: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Tramadol Rx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ther outpatient opioid Rx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(Oxycodone, Morphine, Hydromorphone,  Hydromorphone)</a:t>
                      </a:r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13456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5331632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7</a:t>
            </a:fld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64D9789E-D50D-89D0-533A-4089CAEC5CC8}"/>
              </a:ext>
            </a:extLst>
          </p:cNvPr>
          <p:cNvSpPr txBox="1">
            <a:spLocks/>
          </p:cNvSpPr>
          <p:nvPr/>
        </p:nvSpPr>
        <p:spPr>
          <a:xfrm>
            <a:off x="472440" y="82830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r>
              <a:rPr lang="en-US" b="1"/>
              <a:t>Risk Score Development</a:t>
            </a:r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B3DB9D05-15BE-770F-6C66-9CF783534A87}"/>
              </a:ext>
            </a:extLst>
          </p:cNvPr>
          <p:cNvSpPr/>
          <p:nvPr/>
        </p:nvSpPr>
        <p:spPr>
          <a:xfrm>
            <a:off x="4606290" y="4705378"/>
            <a:ext cx="45720" cy="45719"/>
          </a:xfrm>
          <a:prstGeom prst="ellips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A7BD2218-78AB-1AEF-2627-EBAC2579BF7F}"/>
              </a:ext>
            </a:extLst>
          </p:cNvPr>
          <p:cNvGraphicFramePr>
            <a:graphicFrameLocks noGrp="1"/>
          </p:cNvGraphicFramePr>
          <p:nvPr/>
        </p:nvGraphicFramePr>
        <p:xfrm>
          <a:off x="2250440" y="1391920"/>
          <a:ext cx="7704346" cy="375518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18994">
                  <a:extLst>
                    <a:ext uri="{9D8B030D-6E8A-4147-A177-3AD203B41FA5}">
                      <a16:colId xmlns:a16="http://schemas.microsoft.com/office/drawing/2014/main" val="3659163071"/>
                    </a:ext>
                  </a:extLst>
                </a:gridCol>
                <a:gridCol w="4285352">
                  <a:extLst>
                    <a:ext uri="{9D8B030D-6E8A-4147-A177-3AD203B41FA5}">
                      <a16:colId xmlns:a16="http://schemas.microsoft.com/office/drawing/2014/main" val="2723358237"/>
                    </a:ext>
                  </a:extLst>
                </a:gridCol>
              </a:tblGrid>
              <a:tr h="780520">
                <a:tc>
                  <a:txBody>
                    <a:bodyPr/>
                    <a:lstStyle/>
                    <a:p>
                      <a:r>
                        <a:rPr lang="en-US"/>
                        <a:t>Factors Associated with Lower Odds of Chronic Opioid Use</a:t>
                      </a:r>
                    </a:p>
                  </a:txBody>
                  <a:tcP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/>
                        <a:t>Factors Associated with Higher Odds of Chronic Opioid Use</a:t>
                      </a:r>
                    </a:p>
                  </a:txBody>
                  <a:tcPr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9718396"/>
                  </a:ext>
                </a:extLst>
              </a:tr>
              <a:tr h="2974669">
                <a:tc>
                  <a:txBody>
                    <a:bodyPr/>
                    <a:lstStyle/>
                    <a:p>
                      <a:pPr marL="28575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Age 19 or younger 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Hispanic race/ethnicity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Concurrent </a:t>
                      </a: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ADHD dx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Appendectomy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performed during study period</a:t>
                      </a: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utpatient visit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within 6 months prior to cohort entry date</a:t>
                      </a:r>
                    </a:p>
                  </a:txBody>
                  <a:tcP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8575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Public insurance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(Medicare or Medicaid)</a:t>
                      </a: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Non-digestive surgery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performed during study period</a:t>
                      </a: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utpatient </a:t>
                      </a: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Codeine Rx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utpatient </a:t>
                      </a: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Tramadol Rx</a:t>
                      </a:r>
                      <a:endParaRPr lang="en-US" sz="1800" b="0" i="0" u="none" strike="noStrike" noProof="0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285750" lvl="0" indent="-285750">
                        <a:buClr>
                          <a:srgbClr val="000000"/>
                        </a:buClr>
                        <a:buFont typeface="Arial,Sans-Serif" panose="020B0604020202020204" pitchFamily="34" charset="0"/>
                        <a:buChar char="•"/>
                      </a:pPr>
                      <a:r>
                        <a:rPr lang="en-US" sz="1800" b="1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Other outpatient opioid Rx </a:t>
                      </a:r>
                      <a:r>
                        <a:rPr lang="en-US" sz="1800" b="0" i="0" u="none" strike="noStrike" noProof="0">
                          <a:solidFill>
                            <a:srgbClr val="000000"/>
                          </a:solidFill>
                          <a:latin typeface="Calibri"/>
                        </a:rPr>
                        <a:t>(Oxycodone, Morphine, Hydromorphone,  Hydromorphone)</a:t>
                      </a:r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134565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2EF944F-E44E-4866-A228-790F60B10F21}"/>
              </a:ext>
            </a:extLst>
          </p:cNvPr>
          <p:cNvSpPr txBox="1"/>
          <p:nvPr/>
        </p:nvSpPr>
        <p:spPr>
          <a:xfrm>
            <a:off x="10160000" y="2422435"/>
            <a:ext cx="1767840" cy="147732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/>
              <a:t>+1</a:t>
            </a:r>
            <a:r>
              <a:rPr lang="en-US"/>
              <a:t> for the </a:t>
            </a:r>
            <a:r>
              <a:rPr lang="en-US" b="1"/>
              <a:t>presence of any high risk factors</a:t>
            </a:r>
            <a:r>
              <a:rPr lang="en-US"/>
              <a:t> that apply to a patient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521B1D43-4C70-1975-A037-8F46518C7B32}"/>
              </a:ext>
            </a:extLst>
          </p:cNvPr>
          <p:cNvCxnSpPr>
            <a:stCxn id="3" idx="1"/>
          </p:cNvCxnSpPr>
          <p:nvPr/>
        </p:nvCxnSpPr>
        <p:spPr>
          <a:xfrm flipH="1" flipV="1">
            <a:off x="9941560" y="3022599"/>
            <a:ext cx="218440" cy="1385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AF3190C6-4556-3A64-40C0-2C55471DE55A}"/>
              </a:ext>
            </a:extLst>
          </p:cNvPr>
          <p:cNvSpPr txBox="1"/>
          <p:nvPr/>
        </p:nvSpPr>
        <p:spPr>
          <a:xfrm>
            <a:off x="264160" y="2884100"/>
            <a:ext cx="1767840" cy="147732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/>
              <a:t>+1</a:t>
            </a:r>
            <a:r>
              <a:rPr lang="en-US"/>
              <a:t> for the </a:t>
            </a:r>
            <a:r>
              <a:rPr lang="en-US" b="1"/>
              <a:t>absence of any low risk factors</a:t>
            </a:r>
            <a:r>
              <a:rPr lang="en-US"/>
              <a:t> that apply to a patient 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B4F77248-11ED-C944-CA65-C509C3295A72}"/>
              </a:ext>
            </a:extLst>
          </p:cNvPr>
          <p:cNvCxnSpPr>
            <a:cxnSpLocks/>
          </p:cNvCxnSpPr>
          <p:nvPr/>
        </p:nvCxnSpPr>
        <p:spPr>
          <a:xfrm>
            <a:off x="2032000" y="3622764"/>
            <a:ext cx="2184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48E6454F-106C-6CBE-3239-9B10FA65CF6D}"/>
              </a:ext>
            </a:extLst>
          </p:cNvPr>
          <p:cNvSpPr txBox="1"/>
          <p:nvPr/>
        </p:nvSpPr>
        <p:spPr>
          <a:xfrm>
            <a:off x="2153920" y="5709920"/>
            <a:ext cx="7914640" cy="3693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/>
              <a:t>Add all points to obtain risk score, out of a maximum possible 13</a:t>
            </a:r>
          </a:p>
        </p:txBody>
      </p:sp>
    </p:spTree>
    <p:extLst>
      <p:ext uri="{BB962C8B-B14F-4D97-AF65-F5344CB8AC3E}">
        <p14:creationId xmlns:p14="http://schemas.microsoft.com/office/powerpoint/2010/main" val="168985122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18E8CF-68D0-068A-6B1B-000ED7A14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>
                <a:cs typeface="Arial"/>
              </a:rPr>
              <a:t>Results</a:t>
            </a:r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369C7820-6639-2F11-34CA-E090A9672D6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361439" y="1261386"/>
            <a:ext cx="8336158" cy="4536695"/>
          </a:xfr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4DFC84-09E3-C34D-3F4A-480819215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8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82E0CCD-9194-3E98-1DF4-0391E6E62EF5}"/>
              </a:ext>
            </a:extLst>
          </p:cNvPr>
          <p:cNvSpPr txBox="1"/>
          <p:nvPr/>
        </p:nvSpPr>
        <p:spPr>
          <a:xfrm>
            <a:off x="9149365" y="1596443"/>
            <a:ext cx="2669683" cy="341632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>
                <a:latin typeface="Arial"/>
                <a:cs typeface="Calibri"/>
              </a:rPr>
              <a:t>Predictive risk scores applied to patients with </a:t>
            </a:r>
            <a:r>
              <a:rPr lang="en-US" sz="1800"/>
              <a:t>≥1 </a:t>
            </a:r>
            <a:r>
              <a:rPr lang="en-US">
                <a:latin typeface="Arial"/>
                <a:cs typeface="Calibri"/>
              </a:rPr>
              <a:t>outpatient opioid Rx</a:t>
            </a:r>
            <a:endParaRPr lang="en-US">
              <a:latin typeface="Arial"/>
              <a:cs typeface="Arial"/>
            </a:endParaRPr>
          </a:p>
          <a:p>
            <a:pPr marL="285750" indent="-285750">
              <a:buFont typeface="Arial"/>
              <a:buChar char="•"/>
            </a:pPr>
            <a:r>
              <a:rPr lang="en-US">
                <a:latin typeface="Arial"/>
                <a:cs typeface="Calibri"/>
              </a:rPr>
              <a:t>Scores ranged from 3-11</a:t>
            </a:r>
          </a:p>
          <a:p>
            <a:pPr marL="285750" indent="-285750">
              <a:buFont typeface="Arial"/>
              <a:buChar char="•"/>
            </a:pPr>
            <a:r>
              <a:rPr lang="en-US">
                <a:latin typeface="Arial"/>
                <a:cs typeface="Calibri"/>
              </a:rPr>
              <a:t>Positive relationship between score + risk of chronic opioid use</a:t>
            </a:r>
          </a:p>
          <a:p>
            <a:pPr marL="285750" indent="-285750">
              <a:buFont typeface="Arial"/>
              <a:buChar char="•"/>
            </a:pPr>
            <a:r>
              <a:rPr lang="en-US">
                <a:latin typeface="Arial"/>
                <a:cs typeface="Calibri"/>
              </a:rPr>
              <a:t>Score of 11 is a perfect predictor</a:t>
            </a:r>
          </a:p>
          <a:p>
            <a:endParaRPr lang="en-US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08343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b="1"/>
              <a:t>Acknowledgements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600205"/>
            <a:ext cx="11179126" cy="452596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b="1"/>
              <a:t>Disclosures / Conflicts of Interest</a:t>
            </a:r>
            <a:r>
              <a:rPr lang="en-US" sz="2400"/>
              <a:t> </a:t>
            </a:r>
          </a:p>
          <a:p>
            <a:r>
              <a:rPr lang="en-US" sz="2400"/>
              <a:t>None</a:t>
            </a:r>
          </a:p>
          <a:p>
            <a:pPr marL="0" indent="0">
              <a:buNone/>
            </a:pPr>
            <a:endParaRPr lang="en-US" sz="2400"/>
          </a:p>
          <a:p>
            <a:pPr marL="0" indent="0">
              <a:buNone/>
            </a:pPr>
            <a:r>
              <a:rPr lang="en-US" sz="2400" b="1"/>
              <a:t>Funding / Support</a:t>
            </a:r>
          </a:p>
          <a:p>
            <a:r>
              <a:rPr lang="en-US" sz="2400"/>
              <a:t>Crohn’s &amp; Colitis Foundation (CCF) Award # 882519 (PI: Balbale)</a:t>
            </a:r>
          </a:p>
          <a:p>
            <a:pPr marL="0" indent="0">
              <a:buNone/>
            </a:pPr>
            <a:endParaRPr lang="en-US" sz="2400"/>
          </a:p>
          <a:p>
            <a:pPr marL="0" indent="0">
              <a:buNone/>
            </a:pPr>
            <a:r>
              <a:rPr lang="en-US" sz="2400" b="1"/>
              <a:t>Disclaimer </a:t>
            </a:r>
          </a:p>
          <a:p>
            <a:r>
              <a:rPr lang="en-US" sz="2400"/>
              <a:t>Views expressed in this session are those of the researchers and do not necessarily represent the views of the CCF</a:t>
            </a:r>
          </a:p>
          <a:p>
            <a:pPr marL="0" indent="0">
              <a:buNone/>
            </a:pPr>
            <a:endParaRPr lang="en-US" sz="2400"/>
          </a:p>
          <a:p>
            <a:pPr marL="0" indent="0">
              <a:buNone/>
            </a:pPr>
            <a:endParaRPr lang="en-US" sz="240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89459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19</a:t>
            </a:fld>
            <a:endParaRPr lang="en-US"/>
          </a:p>
        </p:txBody>
      </p:sp>
      <p:sp>
        <p:nvSpPr>
          <p:cNvPr id="27" name="Title 1">
            <a:extLst>
              <a:ext uri="{FF2B5EF4-FFF2-40B4-BE49-F238E27FC236}">
                <a16:creationId xmlns:a16="http://schemas.microsoft.com/office/drawing/2014/main" id="{34553FEF-6D06-FA8B-04C7-EA00A1723B8E}"/>
              </a:ext>
            </a:extLst>
          </p:cNvPr>
          <p:cNvSpPr txBox="1">
            <a:spLocks/>
          </p:cNvSpPr>
          <p:nvPr/>
        </p:nvSpPr>
        <p:spPr>
          <a:xfrm>
            <a:off x="762000" y="4270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r>
              <a:rPr lang="en-US" b="1"/>
              <a:t>Our overarching vision</a:t>
            </a:r>
          </a:p>
          <a:p>
            <a:r>
              <a:rPr lang="en-US" sz="2800" b="1"/>
              <a:t>Paradigm shift in pain management safety for AYA with IBD</a:t>
            </a:r>
          </a:p>
        </p:txBody>
      </p:sp>
      <p:pic>
        <p:nvPicPr>
          <p:cNvPr id="3" name="Picture 2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28640D49-F222-6B90-47B3-310B696E8F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1127" y="2220686"/>
            <a:ext cx="1586204" cy="1586204"/>
          </a:xfrm>
          <a:prstGeom prst="rect">
            <a:avLst/>
          </a:prstGeom>
        </p:spPr>
      </p:pic>
      <p:pic>
        <p:nvPicPr>
          <p:cNvPr id="6" name="Picture 5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6299F95B-8213-325B-EFE2-5BC9C318A9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18907" y="2052735"/>
            <a:ext cx="1922106" cy="1922106"/>
          </a:xfrm>
          <a:prstGeom prst="rect">
            <a:avLst/>
          </a:prstGeom>
        </p:spPr>
      </p:pic>
      <p:pic>
        <p:nvPicPr>
          <p:cNvPr id="8" name="Picture 7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1D0DC3E5-8005-433B-2E8A-BDFC275680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55662" y="2248678"/>
            <a:ext cx="1558212" cy="1558212"/>
          </a:xfrm>
          <a:prstGeom prst="rect">
            <a:avLst/>
          </a:prstGeom>
        </p:spPr>
      </p:pic>
      <p:pic>
        <p:nvPicPr>
          <p:cNvPr id="10" name="Picture 9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1DAF3D5B-8AF6-F21D-B8DD-5A8EB93C55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64326" y="2369976"/>
            <a:ext cx="1315616" cy="1315616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6D4FF8F3-53F2-8A89-8B30-7847DEBC2A98}"/>
              </a:ext>
            </a:extLst>
          </p:cNvPr>
          <p:cNvSpPr/>
          <p:nvPr/>
        </p:nvSpPr>
        <p:spPr>
          <a:xfrm>
            <a:off x="441416" y="3806890"/>
            <a:ext cx="1849111" cy="1036610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disciplinary research</a:t>
            </a:r>
            <a:endParaRPr lang="en-CA" sz="16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4E25B19-F85A-710D-28F7-08E7D4241F2E}"/>
              </a:ext>
            </a:extLst>
          </p:cNvPr>
          <p:cNvSpPr/>
          <p:nvPr/>
        </p:nvSpPr>
        <p:spPr>
          <a:xfrm>
            <a:off x="3455404" y="3806890"/>
            <a:ext cx="1849111" cy="1036610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amwork + collaboration</a:t>
            </a:r>
            <a:endParaRPr lang="en-CA" sz="16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5E849ED-1DBD-0A65-879C-E075FF56FDDB}"/>
              </a:ext>
            </a:extLst>
          </p:cNvPr>
          <p:cNvSpPr/>
          <p:nvPr/>
        </p:nvSpPr>
        <p:spPr>
          <a:xfrm>
            <a:off x="6336278" y="3806890"/>
            <a:ext cx="2119619" cy="1036610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and clinical partners</a:t>
            </a:r>
            <a:endParaRPr lang="en-CA" sz="16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4A6F8D6-8DC2-E1C3-494C-864DE7BFDE62}"/>
              </a:ext>
            </a:extLst>
          </p:cNvPr>
          <p:cNvSpPr/>
          <p:nvPr/>
        </p:nvSpPr>
        <p:spPr>
          <a:xfrm>
            <a:off x="8875281" y="3806890"/>
            <a:ext cx="3222231" cy="1036610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ring findings in community + academic settings</a:t>
            </a:r>
            <a:endParaRPr lang="en-CA" sz="16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879283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0</a:t>
            </a:fld>
            <a:endParaRPr lang="en-US"/>
          </a:p>
        </p:txBody>
      </p:sp>
      <p:graphicFrame>
        <p:nvGraphicFramePr>
          <p:cNvPr id="7" name="Diagram 6"/>
          <p:cNvGraphicFramePr/>
          <p:nvPr>
            <p:extLst>
              <p:ext uri="{D42A27DB-BD31-4B8C-83A1-F6EECF244321}">
                <p14:modId xmlns:p14="http://schemas.microsoft.com/office/powerpoint/2010/main" val="1391155935"/>
              </p:ext>
            </p:extLst>
          </p:nvPr>
        </p:nvGraphicFramePr>
        <p:xfrm>
          <a:off x="1860121" y="453762"/>
          <a:ext cx="8128000" cy="53076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240274226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1</a:t>
            </a:fld>
            <a:endParaRPr lang="en-US"/>
          </a:p>
        </p:txBody>
      </p:sp>
      <p:graphicFrame>
        <p:nvGraphicFramePr>
          <p:cNvPr id="7" name="Diagram 6"/>
          <p:cNvGraphicFramePr/>
          <p:nvPr>
            <p:extLst>
              <p:ext uri="{D42A27DB-BD31-4B8C-83A1-F6EECF244321}">
                <p14:modId xmlns:p14="http://schemas.microsoft.com/office/powerpoint/2010/main" val="1545590755"/>
              </p:ext>
            </p:extLst>
          </p:nvPr>
        </p:nvGraphicFramePr>
        <p:xfrm>
          <a:off x="1860121" y="453762"/>
          <a:ext cx="8128000" cy="53076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7566303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2</a:t>
            </a:fld>
            <a:endParaRPr lang="en-US"/>
          </a:p>
        </p:txBody>
      </p:sp>
      <p:graphicFrame>
        <p:nvGraphicFramePr>
          <p:cNvPr id="7" name="Diagram 6"/>
          <p:cNvGraphicFramePr/>
          <p:nvPr>
            <p:extLst>
              <p:ext uri="{D42A27DB-BD31-4B8C-83A1-F6EECF244321}">
                <p14:modId xmlns:p14="http://schemas.microsoft.com/office/powerpoint/2010/main" val="2350190963"/>
              </p:ext>
            </p:extLst>
          </p:nvPr>
        </p:nvGraphicFramePr>
        <p:xfrm>
          <a:off x="1860121" y="453762"/>
          <a:ext cx="8128000" cy="53076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62326719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3</a:t>
            </a:fld>
            <a:endParaRPr lang="en-US"/>
          </a:p>
        </p:txBody>
      </p:sp>
      <p:graphicFrame>
        <p:nvGraphicFramePr>
          <p:cNvPr id="7" name="Diagram 6"/>
          <p:cNvGraphicFramePr/>
          <p:nvPr>
            <p:extLst>
              <p:ext uri="{D42A27DB-BD31-4B8C-83A1-F6EECF244321}">
                <p14:modId xmlns:p14="http://schemas.microsoft.com/office/powerpoint/2010/main" val="2043622732"/>
              </p:ext>
            </p:extLst>
          </p:nvPr>
        </p:nvGraphicFramePr>
        <p:xfrm>
          <a:off x="1860121" y="453762"/>
          <a:ext cx="8128000" cy="53076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cxnSp>
        <p:nvCxnSpPr>
          <p:cNvPr id="3" name="Straight Connector 2"/>
          <p:cNvCxnSpPr/>
          <p:nvPr/>
        </p:nvCxnSpPr>
        <p:spPr>
          <a:xfrm flipV="1">
            <a:off x="8669612" y="2543820"/>
            <a:ext cx="922038" cy="99690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8669611" y="3540722"/>
            <a:ext cx="922039" cy="132691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" name="Picture 1" descr="A yellow sign with a red green and black light&#10;&#10;Description automatically generated">
            <a:extLst>
              <a:ext uri="{FF2B5EF4-FFF2-40B4-BE49-F238E27FC236}">
                <a16:creationId xmlns:a16="http://schemas.microsoft.com/office/drawing/2014/main" id="{14FE556B-EE7B-C899-CEA4-C3AD8F3D0BD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9365" t="18613" r="39444" b="19721"/>
          <a:stretch/>
        </p:blipFill>
        <p:spPr>
          <a:xfrm>
            <a:off x="9779448" y="1524923"/>
            <a:ext cx="1385375" cy="40315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DC0435-272D-9710-CD42-20C683889E16}"/>
              </a:ext>
            </a:extLst>
          </p:cNvPr>
          <p:cNvSpPr txBox="1"/>
          <p:nvPr/>
        </p:nvSpPr>
        <p:spPr>
          <a:xfrm>
            <a:off x="10078266" y="2011680"/>
            <a:ext cx="787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HIG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E196F00-D765-6E2A-5850-F0F18F9F55FA}"/>
              </a:ext>
            </a:extLst>
          </p:cNvPr>
          <p:cNvSpPr txBox="1"/>
          <p:nvPr/>
        </p:nvSpPr>
        <p:spPr>
          <a:xfrm>
            <a:off x="10078265" y="4578096"/>
            <a:ext cx="787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LOW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E9133FA-C5DB-ADD7-4897-8BE4FE4E388A}"/>
              </a:ext>
            </a:extLst>
          </p:cNvPr>
          <p:cNvSpPr txBox="1"/>
          <p:nvPr/>
        </p:nvSpPr>
        <p:spPr>
          <a:xfrm>
            <a:off x="9928065" y="3294888"/>
            <a:ext cx="1088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MEDIUM</a:t>
            </a:r>
          </a:p>
        </p:txBody>
      </p:sp>
    </p:spTree>
    <p:extLst>
      <p:ext uri="{BB962C8B-B14F-4D97-AF65-F5344CB8AC3E}">
        <p14:creationId xmlns:p14="http://schemas.microsoft.com/office/powerpoint/2010/main" val="382399461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4</a:t>
            </a:fld>
            <a:endParaRPr lang="en-US"/>
          </a:p>
        </p:txBody>
      </p:sp>
      <p:graphicFrame>
        <p:nvGraphicFramePr>
          <p:cNvPr id="7" name="Diagram 6"/>
          <p:cNvGraphicFramePr/>
          <p:nvPr>
            <p:extLst>
              <p:ext uri="{D42A27DB-BD31-4B8C-83A1-F6EECF244321}">
                <p14:modId xmlns:p14="http://schemas.microsoft.com/office/powerpoint/2010/main" val="1797946644"/>
              </p:ext>
            </p:extLst>
          </p:nvPr>
        </p:nvGraphicFramePr>
        <p:xfrm>
          <a:off x="1860121" y="453762"/>
          <a:ext cx="8128000" cy="53076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01631906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5</a:t>
            </a:fld>
            <a:endParaRPr lang="en-US"/>
          </a:p>
        </p:txBody>
      </p:sp>
      <p:graphicFrame>
        <p:nvGraphicFramePr>
          <p:cNvPr id="7" name="Diagram 6"/>
          <p:cNvGraphicFramePr/>
          <p:nvPr>
            <p:extLst>
              <p:ext uri="{D42A27DB-BD31-4B8C-83A1-F6EECF244321}">
                <p14:modId xmlns:p14="http://schemas.microsoft.com/office/powerpoint/2010/main" val="2344082419"/>
              </p:ext>
            </p:extLst>
          </p:nvPr>
        </p:nvGraphicFramePr>
        <p:xfrm>
          <a:off x="1860121" y="453762"/>
          <a:ext cx="8128000" cy="53076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92631038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6</a:t>
            </a:fld>
            <a:endParaRPr lang="en-US"/>
          </a:p>
        </p:txBody>
      </p:sp>
      <p:graphicFrame>
        <p:nvGraphicFramePr>
          <p:cNvPr id="7" name="Diagram 6"/>
          <p:cNvGraphicFramePr/>
          <p:nvPr>
            <p:extLst>
              <p:ext uri="{D42A27DB-BD31-4B8C-83A1-F6EECF244321}">
                <p14:modId xmlns:p14="http://schemas.microsoft.com/office/powerpoint/2010/main" val="1074629561"/>
              </p:ext>
            </p:extLst>
          </p:nvPr>
        </p:nvGraphicFramePr>
        <p:xfrm>
          <a:off x="1860121" y="453762"/>
          <a:ext cx="8128000" cy="53076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77145817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/>
              <a:t>What would this look like in IBD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sz="2800"/>
              <a:t>We want to hear your ideas!</a:t>
            </a:r>
          </a:p>
          <a:p>
            <a:endParaRPr lang="en-US" sz="2800"/>
          </a:p>
          <a:p>
            <a:r>
              <a:rPr lang="en-US" sz="2800"/>
              <a:t>It will no doubt be a longer dialogue that needs to include many more viewpoints </a:t>
            </a:r>
            <a:r>
              <a:rPr lang="en-US" sz="2800">
                <a:sym typeface="Wingdings" panose="05000000000000000000" pitchFamily="2" charset="2"/>
              </a:rPr>
              <a:t> this co-design session = important first step</a:t>
            </a:r>
          </a:p>
          <a:p>
            <a:endParaRPr lang="en-US" sz="2800"/>
          </a:p>
          <a:p>
            <a:r>
              <a:rPr lang="en-US" sz="2800"/>
              <a:t>Keep in mind</a:t>
            </a:r>
          </a:p>
          <a:p>
            <a:pPr lvl="1"/>
            <a:r>
              <a:rPr lang="en-US" sz="2400"/>
              <a:t>This is a safe space for creative, collaborative ideas</a:t>
            </a:r>
          </a:p>
          <a:p>
            <a:pPr lvl="1"/>
            <a:r>
              <a:rPr lang="en-US" sz="2400"/>
              <a:t>Where you can lean into your view as a patient and / or clinician</a:t>
            </a:r>
          </a:p>
          <a:p>
            <a:pPr lvl="1"/>
            <a:r>
              <a:rPr lang="en-US" sz="2400"/>
              <a:t>It’s a unique approach </a:t>
            </a:r>
            <a:r>
              <a:rPr lang="en-US" sz="2400">
                <a:sym typeface="Wingdings" panose="05000000000000000000" pitchFamily="2" charset="2"/>
              </a:rPr>
              <a:t> if you</a:t>
            </a:r>
            <a:r>
              <a:rPr lang="en-US" sz="2400"/>
              <a:t> feel uncomfortable, let us know</a:t>
            </a:r>
          </a:p>
          <a:p>
            <a:pPr lvl="1"/>
            <a:r>
              <a:rPr lang="en-US" sz="2400"/>
              <a:t>Session will be recorded</a:t>
            </a:r>
          </a:p>
          <a:p>
            <a:endParaRPr lang="en-US" sz="280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21339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E9CD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>
            <a:extLst>
              <a:ext uri="{FF2B5EF4-FFF2-40B4-BE49-F238E27FC236}">
                <a16:creationId xmlns:a16="http://schemas.microsoft.com/office/drawing/2014/main" id="{EF64D892-CD53-B2EA-E3B7-6A6EB15FD63E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hape 0">
            <a:extLst>
              <a:ext uri="{FF2B5EF4-FFF2-40B4-BE49-F238E27FC236}">
                <a16:creationId xmlns:a16="http://schemas.microsoft.com/office/drawing/2014/main" id="{25ECC424-89A9-DA4B-9139-BED5DC6CBA78}"/>
              </a:ext>
            </a:extLst>
          </p:cNvPr>
          <p:cNvSpPr/>
          <p:nvPr/>
        </p:nvSpPr>
        <p:spPr>
          <a:xfrm>
            <a:off x="-2153925" y="-976343"/>
            <a:ext cx="7354593" cy="7353674"/>
          </a:xfrm>
          <a:prstGeom prst="ellipse">
            <a:avLst/>
          </a:prstGeom>
          <a:solidFill>
            <a:srgbClr val="FFFFFF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r"/>
            <a:r>
              <a:rPr lang="en-US" sz="4000">
                <a:latin typeface="Poppins" pitchFamily="2" charset="77"/>
                <a:cs typeface="Poppins" pitchFamily="2" charset="77"/>
              </a:rPr>
              <a:t>Roundtable Introduction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8</a:t>
            </a:fld>
            <a:endParaRPr lang="en-US"/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24E5DBF7-878B-6431-50E0-DC139A4C47F0}"/>
              </a:ext>
            </a:extLst>
          </p:cNvPr>
          <p:cNvSpPr/>
          <p:nvPr/>
        </p:nvSpPr>
        <p:spPr>
          <a:xfrm>
            <a:off x="5404543" y="1880591"/>
            <a:ext cx="2792329" cy="1899529"/>
          </a:xfrm>
          <a:prstGeom prst="round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7ECB0AD-6DA7-CC71-A348-5348D0A8795E}"/>
              </a:ext>
            </a:extLst>
          </p:cNvPr>
          <p:cNvSpPr txBox="1"/>
          <p:nvPr/>
        </p:nvSpPr>
        <p:spPr>
          <a:xfrm>
            <a:off x="5935292" y="2537868"/>
            <a:ext cx="173082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Nam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641B6F1-8100-B4DE-8C77-75E8CC80FD7F}"/>
              </a:ext>
            </a:extLst>
          </p:cNvPr>
          <p:cNvSpPr txBox="1"/>
          <p:nvPr/>
        </p:nvSpPr>
        <p:spPr>
          <a:xfrm>
            <a:off x="8934414" y="2291646"/>
            <a:ext cx="252004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Expert </a:t>
            </a:r>
          </a:p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Rol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462DC7F-7909-B1C8-02AE-C3C3E18BEAC4}"/>
              </a:ext>
            </a:extLst>
          </p:cNvPr>
          <p:cNvSpPr txBox="1"/>
          <p:nvPr/>
        </p:nvSpPr>
        <p:spPr>
          <a:xfrm>
            <a:off x="7158038" y="4607701"/>
            <a:ext cx="252004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Tylenol or Advil?</a:t>
            </a:r>
          </a:p>
        </p:txBody>
      </p:sp>
      <p:pic>
        <p:nvPicPr>
          <p:cNvPr id="14" name="Image 0" descr=" ">
            <a:extLst>
              <a:ext uri="{FF2B5EF4-FFF2-40B4-BE49-F238E27FC236}">
                <a16:creationId xmlns:a16="http://schemas.microsoft.com/office/drawing/2014/main" id="{E59A0769-1129-0573-45D5-876C2CDF23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-2301" y="1692276"/>
            <a:ext cx="4670943" cy="3197482"/>
          </a:xfrm>
          <a:prstGeom prst="rect">
            <a:avLst/>
          </a:prstGeom>
        </p:spPr>
      </p:pic>
      <p:sp>
        <p:nvSpPr>
          <p:cNvPr id="17" name="Rounded Rectangle 16">
            <a:extLst>
              <a:ext uri="{FF2B5EF4-FFF2-40B4-BE49-F238E27FC236}">
                <a16:creationId xmlns:a16="http://schemas.microsoft.com/office/drawing/2014/main" id="{88F68E40-17B7-2A98-7B0B-DB232C61A5E3}"/>
              </a:ext>
            </a:extLst>
          </p:cNvPr>
          <p:cNvSpPr/>
          <p:nvPr/>
        </p:nvSpPr>
        <p:spPr>
          <a:xfrm>
            <a:off x="8763835" y="1880490"/>
            <a:ext cx="2792329" cy="1899529"/>
          </a:xfrm>
          <a:prstGeom prst="round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ounded Rectangle 17">
            <a:extLst>
              <a:ext uri="{FF2B5EF4-FFF2-40B4-BE49-F238E27FC236}">
                <a16:creationId xmlns:a16="http://schemas.microsoft.com/office/drawing/2014/main" id="{B30324B7-7ED2-B165-4F2F-0A90D8C3978F}"/>
              </a:ext>
            </a:extLst>
          </p:cNvPr>
          <p:cNvSpPr/>
          <p:nvPr/>
        </p:nvSpPr>
        <p:spPr>
          <a:xfrm>
            <a:off x="7021896" y="4191175"/>
            <a:ext cx="2792329" cy="1899529"/>
          </a:xfrm>
          <a:prstGeom prst="round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1523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b="1"/>
              <a:t>Today’s agend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600205"/>
            <a:ext cx="11179126" cy="4525963"/>
          </a:xfrm>
        </p:spPr>
        <p:txBody>
          <a:bodyPr>
            <a:normAutofit fontScale="70000" lnSpcReduction="20000"/>
          </a:bodyPr>
          <a:lstStyle/>
          <a:p>
            <a:pPr marL="0" indent="0">
              <a:buNone/>
            </a:pPr>
            <a:r>
              <a:rPr lang="en-US" sz="2400" b="1"/>
              <a:t>Welcome + thank you</a:t>
            </a:r>
            <a:endParaRPr lang="en-US" sz="2400"/>
          </a:p>
          <a:p>
            <a:r>
              <a:rPr lang="en-US" sz="2400"/>
              <a:t>Introductions</a:t>
            </a:r>
          </a:p>
          <a:p>
            <a:r>
              <a:rPr lang="en-US" sz="2400"/>
              <a:t>Why have we brought everyone together?</a:t>
            </a:r>
          </a:p>
          <a:p>
            <a:r>
              <a:rPr lang="en-US" sz="2400"/>
              <a:t>What we’ve learned so far</a:t>
            </a:r>
          </a:p>
          <a:p>
            <a:endParaRPr lang="en-US" sz="2400"/>
          </a:p>
          <a:p>
            <a:pPr marL="0" indent="0">
              <a:buNone/>
            </a:pPr>
            <a:endParaRPr lang="en-US" sz="2400"/>
          </a:p>
          <a:p>
            <a:pPr marL="0" indent="0">
              <a:buNone/>
            </a:pPr>
            <a:r>
              <a:rPr lang="en-US" sz="2400" b="1"/>
              <a:t>Co-design activities</a:t>
            </a:r>
          </a:p>
          <a:p>
            <a:r>
              <a:rPr lang="en-US" sz="2400"/>
              <a:t>Thinking differently overview</a:t>
            </a:r>
          </a:p>
          <a:p>
            <a:r>
              <a:rPr lang="en-US" sz="2400"/>
              <a:t>Review brainstorm best practices</a:t>
            </a:r>
          </a:p>
          <a:p>
            <a:r>
              <a:rPr lang="en-US" sz="2400"/>
              <a:t>Activity 1: “Breaking the Rules”</a:t>
            </a:r>
          </a:p>
          <a:p>
            <a:r>
              <a:rPr lang="en-US" sz="2400"/>
              <a:t>Activity 2: “Wild Card”</a:t>
            </a:r>
          </a:p>
          <a:p>
            <a:r>
              <a:rPr lang="en-US" sz="2400"/>
              <a:t>Dot voting</a:t>
            </a:r>
          </a:p>
          <a:p>
            <a:pPr marL="0" indent="0">
              <a:buNone/>
            </a:pPr>
            <a:endParaRPr lang="en-US" sz="2400"/>
          </a:p>
          <a:p>
            <a:pPr marL="0" indent="0">
              <a:buNone/>
            </a:pPr>
            <a:r>
              <a:rPr lang="en-US" sz="2400" b="1"/>
              <a:t>Wrap</a:t>
            </a:r>
          </a:p>
          <a:p>
            <a:r>
              <a:rPr lang="en-US" sz="2400"/>
              <a:t>Next steps + questions</a:t>
            </a:r>
          </a:p>
          <a:p>
            <a:r>
              <a:rPr lang="en-US" sz="2400"/>
              <a:t>Thank you!</a:t>
            </a:r>
          </a:p>
          <a:p>
            <a:pPr marL="0" indent="0">
              <a:buNone/>
            </a:pPr>
            <a:endParaRPr lang="en-US" sz="2400"/>
          </a:p>
          <a:p>
            <a:pPr marL="0" indent="0">
              <a:buNone/>
            </a:pPr>
            <a:endParaRPr lang="en-US" sz="240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</a:t>
            </a:fld>
            <a:endParaRPr lang="en-US"/>
          </a:p>
        </p:txBody>
      </p:sp>
      <p:pic>
        <p:nvPicPr>
          <p:cNvPr id="8" name="Picture 7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0B24594F-531F-69CF-8354-5F22F0040E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85104" y="136524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763391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Thinking Differentl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207885-7543-BDC7-7D73-52C111498D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24643" y="1624013"/>
            <a:ext cx="9742714" cy="4525963"/>
          </a:xfrm>
        </p:spPr>
        <p:txBody>
          <a:bodyPr/>
          <a:lstStyle/>
          <a:p>
            <a:pPr marL="0" indent="0" algn="ctr">
              <a:buNone/>
            </a:pPr>
            <a:endParaRPr lang="en-US" sz="1800">
              <a:latin typeface="Poppins" pitchFamily="2" charset="77"/>
              <a:ea typeface="Arial Unicode MS" panose="020B0604020202020204" pitchFamily="34" charset="-128"/>
              <a:cs typeface="Poppins" pitchFamily="2" charset="77"/>
            </a:endParaRPr>
          </a:p>
          <a:p>
            <a:pPr marL="0" indent="0" algn="ctr">
              <a:lnSpc>
                <a:spcPct val="150000"/>
              </a:lnSpc>
              <a:buNone/>
            </a:pPr>
            <a:r>
              <a:rPr lang="en-US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“</a:t>
            </a:r>
            <a:r>
              <a:rPr lang="en-US">
                <a:effectLst/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Creative thinking involves breaking out of established patterns (valleys) in order to look at things in a different way.” </a:t>
            </a:r>
          </a:p>
          <a:p>
            <a:pPr marL="0" indent="0" algn="r">
              <a:buNone/>
            </a:pPr>
            <a:endParaRPr lang="en-US" sz="1800" i="1">
              <a:solidFill>
                <a:schemeClr val="bg1">
                  <a:lumMod val="50000"/>
                </a:schemeClr>
              </a:solidFill>
              <a:effectLst/>
              <a:latin typeface="Poppins" pitchFamily="2" charset="77"/>
              <a:ea typeface="Arial Unicode MS" panose="020B0604020202020204" pitchFamily="34" charset="-128"/>
              <a:cs typeface="Poppins" pitchFamily="2" charset="77"/>
            </a:endParaRPr>
          </a:p>
          <a:p>
            <a:pPr marL="0" indent="0" algn="r">
              <a:buNone/>
            </a:pPr>
            <a:r>
              <a:rPr lang="en-US" sz="1800" i="1">
                <a:solidFill>
                  <a:schemeClr val="bg1">
                    <a:lumMod val="50000"/>
                  </a:schemeClr>
                </a:solidFill>
                <a:effectLst/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- Edward de Bono</a:t>
            </a:r>
            <a:r>
              <a:rPr lang="en-US" sz="1800">
                <a:effectLst/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</a:t>
            </a:r>
            <a:endParaRPr lang="en-US">
              <a:latin typeface="Poppins" pitchFamily="2" charset="77"/>
              <a:cs typeface="Poppins" pitchFamily="2" charset="77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52720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Thinking Differently</a:t>
            </a:r>
          </a:p>
        </p:txBody>
      </p:sp>
      <p:pic>
        <p:nvPicPr>
          <p:cNvPr id="6" name="Content Placeholder 5" descr="A comparison of a river&#10;&#10;Description automatically generated">
            <a:extLst>
              <a:ext uri="{FF2B5EF4-FFF2-40B4-BE49-F238E27FC236}">
                <a16:creationId xmlns:a16="http://schemas.microsoft.com/office/drawing/2014/main" id="{AB633693-D7B5-7E7A-C470-30C6987B47E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707228" y="1600200"/>
            <a:ext cx="10777544" cy="4525963"/>
          </a:xfr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55935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Thinking Differently</a:t>
            </a:r>
          </a:p>
        </p:txBody>
      </p:sp>
      <p:pic>
        <p:nvPicPr>
          <p:cNvPr id="6" name="Content Placeholder 5" descr="A comparison of a river&#10;&#10;Description automatically generated">
            <a:extLst>
              <a:ext uri="{FF2B5EF4-FFF2-40B4-BE49-F238E27FC236}">
                <a16:creationId xmlns:a16="http://schemas.microsoft.com/office/drawing/2014/main" id="{AB633693-D7B5-7E7A-C470-30C6987B47E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707228" y="1600200"/>
            <a:ext cx="10777544" cy="4525963"/>
          </a:xfr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206702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A107A241-62B2-AA0F-9AD6-7DD6B0CF8B47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Thinking Differently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75126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A107A241-62B2-AA0F-9AD6-7DD6B0CF8B47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Thinking Differently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3</a:t>
            </a:fld>
            <a:endParaRPr lang="en-US"/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AE2A5D8E-2209-C56E-E753-DC1CB99AD536}"/>
              </a:ext>
            </a:extLst>
          </p:cNvPr>
          <p:cNvSpPr/>
          <p:nvPr/>
        </p:nvSpPr>
        <p:spPr>
          <a:xfrm>
            <a:off x="883342" y="2117658"/>
            <a:ext cx="2792329" cy="1899529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97AB7A9-7043-9FA6-230C-DA4099D740B8}"/>
              </a:ext>
            </a:extLst>
          </p:cNvPr>
          <p:cNvSpPr txBox="1"/>
          <p:nvPr/>
        </p:nvSpPr>
        <p:spPr>
          <a:xfrm>
            <a:off x="1259351" y="2775034"/>
            <a:ext cx="204030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Attention</a:t>
            </a:r>
          </a:p>
        </p:txBody>
      </p:sp>
    </p:spTree>
    <p:extLst>
      <p:ext uri="{BB962C8B-B14F-4D97-AF65-F5344CB8AC3E}">
        <p14:creationId xmlns:p14="http://schemas.microsoft.com/office/powerpoint/2010/main" val="1260269122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A107A241-62B2-AA0F-9AD6-7DD6B0CF8B47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Thinking Differently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4</a:t>
            </a:fld>
            <a:endParaRPr lang="en-US"/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AE2A5D8E-2209-C56E-E753-DC1CB99AD536}"/>
              </a:ext>
            </a:extLst>
          </p:cNvPr>
          <p:cNvSpPr/>
          <p:nvPr/>
        </p:nvSpPr>
        <p:spPr>
          <a:xfrm>
            <a:off x="883342" y="2117658"/>
            <a:ext cx="2792329" cy="1899529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E4B7F44F-7D8D-CC8D-CE79-2423F1A07B9D}"/>
              </a:ext>
            </a:extLst>
          </p:cNvPr>
          <p:cNvSpPr/>
          <p:nvPr/>
        </p:nvSpPr>
        <p:spPr>
          <a:xfrm>
            <a:off x="4699835" y="2117658"/>
            <a:ext cx="2792329" cy="1899529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97AB7A9-7043-9FA6-230C-DA4099D740B8}"/>
              </a:ext>
            </a:extLst>
          </p:cNvPr>
          <p:cNvSpPr txBox="1"/>
          <p:nvPr/>
        </p:nvSpPr>
        <p:spPr>
          <a:xfrm>
            <a:off x="1259351" y="2775034"/>
            <a:ext cx="204030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Atten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7B2B003-43BF-CBA3-9FA6-0B22E56CF51F}"/>
              </a:ext>
            </a:extLst>
          </p:cNvPr>
          <p:cNvSpPr txBox="1"/>
          <p:nvPr/>
        </p:nvSpPr>
        <p:spPr>
          <a:xfrm>
            <a:off x="5075844" y="2775033"/>
            <a:ext cx="204030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Escape</a:t>
            </a:r>
          </a:p>
        </p:txBody>
      </p:sp>
    </p:spTree>
    <p:extLst>
      <p:ext uri="{BB962C8B-B14F-4D97-AF65-F5344CB8AC3E}">
        <p14:creationId xmlns:p14="http://schemas.microsoft.com/office/powerpoint/2010/main" val="30797094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A107A241-62B2-AA0F-9AD6-7DD6B0CF8B47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Thinking Differently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5</a:t>
            </a:fld>
            <a:endParaRPr lang="en-US"/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AE2A5D8E-2209-C56E-E753-DC1CB99AD536}"/>
              </a:ext>
            </a:extLst>
          </p:cNvPr>
          <p:cNvSpPr/>
          <p:nvPr/>
        </p:nvSpPr>
        <p:spPr>
          <a:xfrm>
            <a:off x="883342" y="2117658"/>
            <a:ext cx="2792329" cy="1899529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E4B7F44F-7D8D-CC8D-CE79-2423F1A07B9D}"/>
              </a:ext>
            </a:extLst>
          </p:cNvPr>
          <p:cNvSpPr/>
          <p:nvPr/>
        </p:nvSpPr>
        <p:spPr>
          <a:xfrm>
            <a:off x="4699835" y="2117658"/>
            <a:ext cx="2792329" cy="1899529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13662978-FB65-9104-3811-78D96F6F4AD6}"/>
              </a:ext>
            </a:extLst>
          </p:cNvPr>
          <p:cNvSpPr/>
          <p:nvPr/>
        </p:nvSpPr>
        <p:spPr>
          <a:xfrm>
            <a:off x="8516328" y="2117658"/>
            <a:ext cx="2792329" cy="1899529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97AB7A9-7043-9FA6-230C-DA4099D740B8}"/>
              </a:ext>
            </a:extLst>
          </p:cNvPr>
          <p:cNvSpPr txBox="1"/>
          <p:nvPr/>
        </p:nvSpPr>
        <p:spPr>
          <a:xfrm>
            <a:off x="1259351" y="2775034"/>
            <a:ext cx="204030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Atten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7B2B003-43BF-CBA3-9FA6-0B22E56CF51F}"/>
              </a:ext>
            </a:extLst>
          </p:cNvPr>
          <p:cNvSpPr txBox="1"/>
          <p:nvPr/>
        </p:nvSpPr>
        <p:spPr>
          <a:xfrm>
            <a:off x="5075844" y="2775033"/>
            <a:ext cx="204030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Escap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E10553-26C3-B7CF-F208-AAF2AEA14555}"/>
              </a:ext>
            </a:extLst>
          </p:cNvPr>
          <p:cNvSpPr txBox="1"/>
          <p:nvPr/>
        </p:nvSpPr>
        <p:spPr>
          <a:xfrm>
            <a:off x="8704333" y="2775033"/>
            <a:ext cx="241631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Movement</a:t>
            </a:r>
          </a:p>
        </p:txBody>
      </p:sp>
    </p:spTree>
    <p:extLst>
      <p:ext uri="{BB962C8B-B14F-4D97-AF65-F5344CB8AC3E}">
        <p14:creationId xmlns:p14="http://schemas.microsoft.com/office/powerpoint/2010/main" val="20185675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0"/>
          <p:cNvSpPr/>
          <p:nvPr/>
        </p:nvSpPr>
        <p:spPr>
          <a:xfrm>
            <a:off x="6095969" y="448"/>
            <a:ext cx="6095968" cy="6331772"/>
          </a:xfrm>
          <a:prstGeom prst="rect">
            <a:avLst/>
          </a:prstGeom>
          <a:solidFill>
            <a:srgbClr val="F6FFBC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3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94418" y="317905"/>
            <a:ext cx="5499071" cy="6228539"/>
          </a:xfrm>
          <a:prstGeom prst="rect">
            <a:avLst/>
          </a:prstGeom>
        </p:spPr>
      </p:pic>
      <p:sp>
        <p:nvSpPr>
          <p:cNvPr id="4" name="Shape 1"/>
          <p:cNvSpPr/>
          <p:nvPr/>
        </p:nvSpPr>
        <p:spPr>
          <a:xfrm>
            <a:off x="850896" y="822664"/>
            <a:ext cx="4603726" cy="5225370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F69D21DC-A5D0-8A3A-E305-871F1BE45BC3}"/>
              </a:ext>
            </a:extLst>
          </p:cNvPr>
          <p:cNvSpPr txBox="1">
            <a:spLocks/>
          </p:cNvSpPr>
          <p:nvPr/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Brainstorm Best </a:t>
            </a:r>
          </a:p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Practices</a:t>
            </a: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7EF55DA3-E702-185C-F036-B2883334C30F}"/>
              </a:ext>
            </a:extLst>
          </p:cNvPr>
          <p:cNvSpPr txBox="1">
            <a:spLocks/>
          </p:cNvSpPr>
          <p:nvPr/>
        </p:nvSpPr>
        <p:spPr>
          <a:xfrm>
            <a:off x="609600" y="1600608"/>
            <a:ext cx="10972800" cy="4525963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200000"/>
              </a:lnSpc>
            </a:pPr>
            <a:endParaRPr lang="en-US" sz="2800">
              <a:latin typeface="Poppins" pitchFamily="2" charset="77"/>
              <a:cs typeface="Poppins" pitchFamily="2" charset="77"/>
            </a:endParaRPr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0"/>
          <p:cNvSpPr/>
          <p:nvPr/>
        </p:nvSpPr>
        <p:spPr>
          <a:xfrm>
            <a:off x="6095969" y="448"/>
            <a:ext cx="6095968" cy="6331772"/>
          </a:xfrm>
          <a:prstGeom prst="rect">
            <a:avLst/>
          </a:prstGeom>
          <a:solidFill>
            <a:srgbClr val="F6FFBC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3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94418" y="317905"/>
            <a:ext cx="5499071" cy="6228539"/>
          </a:xfrm>
          <a:prstGeom prst="rect">
            <a:avLst/>
          </a:prstGeom>
        </p:spPr>
      </p:pic>
      <p:sp>
        <p:nvSpPr>
          <p:cNvPr id="4" name="Shape 1"/>
          <p:cNvSpPr/>
          <p:nvPr/>
        </p:nvSpPr>
        <p:spPr>
          <a:xfrm>
            <a:off x="850896" y="822664"/>
            <a:ext cx="4603726" cy="5225370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F69D21DC-A5D0-8A3A-E305-871F1BE45BC3}"/>
              </a:ext>
            </a:extLst>
          </p:cNvPr>
          <p:cNvSpPr txBox="1">
            <a:spLocks/>
          </p:cNvSpPr>
          <p:nvPr/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Brainstorm Best </a:t>
            </a:r>
          </a:p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Practices</a:t>
            </a: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7EF55DA3-E702-185C-F036-B2883334C30F}"/>
              </a:ext>
            </a:extLst>
          </p:cNvPr>
          <p:cNvSpPr txBox="1">
            <a:spLocks/>
          </p:cNvSpPr>
          <p:nvPr/>
        </p:nvSpPr>
        <p:spPr>
          <a:xfrm>
            <a:off x="609600" y="1600608"/>
            <a:ext cx="10972800" cy="4525963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Criticism is ruled out</a:t>
            </a:r>
          </a:p>
        </p:txBody>
      </p:sp>
    </p:spTree>
    <p:extLst>
      <p:ext uri="{BB962C8B-B14F-4D97-AF65-F5344CB8AC3E}">
        <p14:creationId xmlns:p14="http://schemas.microsoft.com/office/powerpoint/2010/main" val="874751033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0"/>
          <p:cNvSpPr/>
          <p:nvPr/>
        </p:nvSpPr>
        <p:spPr>
          <a:xfrm>
            <a:off x="6095969" y="448"/>
            <a:ext cx="6095968" cy="6331772"/>
          </a:xfrm>
          <a:prstGeom prst="rect">
            <a:avLst/>
          </a:prstGeom>
          <a:solidFill>
            <a:srgbClr val="F6FFBC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3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94418" y="317905"/>
            <a:ext cx="5499071" cy="6228539"/>
          </a:xfrm>
          <a:prstGeom prst="rect">
            <a:avLst/>
          </a:prstGeom>
        </p:spPr>
      </p:pic>
      <p:sp>
        <p:nvSpPr>
          <p:cNvPr id="4" name="Shape 1"/>
          <p:cNvSpPr/>
          <p:nvPr/>
        </p:nvSpPr>
        <p:spPr>
          <a:xfrm>
            <a:off x="850896" y="822664"/>
            <a:ext cx="4603726" cy="5225370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F69D21DC-A5D0-8A3A-E305-871F1BE45BC3}"/>
              </a:ext>
            </a:extLst>
          </p:cNvPr>
          <p:cNvSpPr txBox="1">
            <a:spLocks/>
          </p:cNvSpPr>
          <p:nvPr/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Brainstorm Best </a:t>
            </a:r>
          </a:p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Practices</a:t>
            </a: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7EF55DA3-E702-185C-F036-B2883334C30F}"/>
              </a:ext>
            </a:extLst>
          </p:cNvPr>
          <p:cNvSpPr txBox="1">
            <a:spLocks/>
          </p:cNvSpPr>
          <p:nvPr/>
        </p:nvSpPr>
        <p:spPr>
          <a:xfrm>
            <a:off x="609600" y="1600608"/>
            <a:ext cx="10972800" cy="4525963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Criticism is ruled out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Go for quantity</a:t>
            </a:r>
          </a:p>
        </p:txBody>
      </p:sp>
    </p:spTree>
    <p:extLst>
      <p:ext uri="{BB962C8B-B14F-4D97-AF65-F5344CB8AC3E}">
        <p14:creationId xmlns:p14="http://schemas.microsoft.com/office/powerpoint/2010/main" val="16724990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/>
              <a:t>Why have we brought everyone together?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302209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0"/>
          <p:cNvSpPr/>
          <p:nvPr/>
        </p:nvSpPr>
        <p:spPr>
          <a:xfrm>
            <a:off x="6095969" y="448"/>
            <a:ext cx="6095968" cy="6331772"/>
          </a:xfrm>
          <a:prstGeom prst="rect">
            <a:avLst/>
          </a:prstGeom>
          <a:solidFill>
            <a:srgbClr val="F6FFBC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3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94418" y="317905"/>
            <a:ext cx="5499071" cy="6228539"/>
          </a:xfrm>
          <a:prstGeom prst="rect">
            <a:avLst/>
          </a:prstGeom>
        </p:spPr>
      </p:pic>
      <p:sp>
        <p:nvSpPr>
          <p:cNvPr id="4" name="Shape 1"/>
          <p:cNvSpPr/>
          <p:nvPr/>
        </p:nvSpPr>
        <p:spPr>
          <a:xfrm>
            <a:off x="850896" y="822664"/>
            <a:ext cx="4603726" cy="5225370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F69D21DC-A5D0-8A3A-E305-871F1BE45BC3}"/>
              </a:ext>
            </a:extLst>
          </p:cNvPr>
          <p:cNvSpPr txBox="1">
            <a:spLocks/>
          </p:cNvSpPr>
          <p:nvPr/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Brainstorm Best </a:t>
            </a:r>
          </a:p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Practices</a:t>
            </a: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7EF55DA3-E702-185C-F036-B2883334C30F}"/>
              </a:ext>
            </a:extLst>
          </p:cNvPr>
          <p:cNvSpPr txBox="1">
            <a:spLocks/>
          </p:cNvSpPr>
          <p:nvPr/>
        </p:nvSpPr>
        <p:spPr>
          <a:xfrm>
            <a:off x="609600" y="1600608"/>
            <a:ext cx="10972800" cy="4525963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Criticism is ruled out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Go for quantity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Encourage wild ideas</a:t>
            </a:r>
          </a:p>
        </p:txBody>
      </p:sp>
    </p:spTree>
    <p:extLst>
      <p:ext uri="{BB962C8B-B14F-4D97-AF65-F5344CB8AC3E}">
        <p14:creationId xmlns:p14="http://schemas.microsoft.com/office/powerpoint/2010/main" val="2014590987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0"/>
          <p:cNvSpPr/>
          <p:nvPr/>
        </p:nvSpPr>
        <p:spPr>
          <a:xfrm>
            <a:off x="6095969" y="448"/>
            <a:ext cx="6095968" cy="6331772"/>
          </a:xfrm>
          <a:prstGeom prst="rect">
            <a:avLst/>
          </a:prstGeom>
          <a:solidFill>
            <a:srgbClr val="F6FFBC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3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94418" y="317905"/>
            <a:ext cx="5499071" cy="6228539"/>
          </a:xfrm>
          <a:prstGeom prst="rect">
            <a:avLst/>
          </a:prstGeom>
        </p:spPr>
      </p:pic>
      <p:sp>
        <p:nvSpPr>
          <p:cNvPr id="4" name="Shape 1"/>
          <p:cNvSpPr/>
          <p:nvPr/>
        </p:nvSpPr>
        <p:spPr>
          <a:xfrm>
            <a:off x="850896" y="822664"/>
            <a:ext cx="4603726" cy="5225370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F69D21DC-A5D0-8A3A-E305-871F1BE45BC3}"/>
              </a:ext>
            </a:extLst>
          </p:cNvPr>
          <p:cNvSpPr txBox="1">
            <a:spLocks/>
          </p:cNvSpPr>
          <p:nvPr/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Brainstorm Best </a:t>
            </a:r>
          </a:p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Practices</a:t>
            </a: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7EF55DA3-E702-185C-F036-B2883334C30F}"/>
              </a:ext>
            </a:extLst>
          </p:cNvPr>
          <p:cNvSpPr txBox="1">
            <a:spLocks/>
          </p:cNvSpPr>
          <p:nvPr/>
        </p:nvSpPr>
        <p:spPr>
          <a:xfrm>
            <a:off x="609600" y="1600608"/>
            <a:ext cx="10972800" cy="4525963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Criticism is ruled out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Go for quantity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Encourage wild ideas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Build on the ideas of others</a:t>
            </a:r>
          </a:p>
        </p:txBody>
      </p:sp>
    </p:spTree>
    <p:extLst>
      <p:ext uri="{BB962C8B-B14F-4D97-AF65-F5344CB8AC3E}">
        <p14:creationId xmlns:p14="http://schemas.microsoft.com/office/powerpoint/2010/main" val="88445849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0"/>
          <p:cNvSpPr/>
          <p:nvPr/>
        </p:nvSpPr>
        <p:spPr>
          <a:xfrm>
            <a:off x="6095969" y="448"/>
            <a:ext cx="6095968" cy="6331772"/>
          </a:xfrm>
          <a:prstGeom prst="rect">
            <a:avLst/>
          </a:prstGeom>
          <a:solidFill>
            <a:srgbClr val="F6FFBC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3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94418" y="317905"/>
            <a:ext cx="5499071" cy="6228539"/>
          </a:xfrm>
          <a:prstGeom prst="rect">
            <a:avLst/>
          </a:prstGeom>
        </p:spPr>
      </p:pic>
      <p:sp>
        <p:nvSpPr>
          <p:cNvPr id="4" name="Shape 1"/>
          <p:cNvSpPr/>
          <p:nvPr/>
        </p:nvSpPr>
        <p:spPr>
          <a:xfrm>
            <a:off x="850896" y="822664"/>
            <a:ext cx="4603726" cy="5225370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F69D21DC-A5D0-8A3A-E305-871F1BE45BC3}"/>
              </a:ext>
            </a:extLst>
          </p:cNvPr>
          <p:cNvSpPr txBox="1">
            <a:spLocks/>
          </p:cNvSpPr>
          <p:nvPr/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Brainstorm Best </a:t>
            </a:r>
          </a:p>
          <a:p>
            <a:pPr algn="l"/>
            <a:r>
              <a:rPr lang="en-US" sz="4000">
                <a:latin typeface="Poppins" pitchFamily="2" charset="77"/>
                <a:cs typeface="Poppins" pitchFamily="2" charset="77"/>
              </a:rPr>
              <a:t>Practices</a:t>
            </a:r>
          </a:p>
        </p:txBody>
      </p:sp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7EF55DA3-E702-185C-F036-B2883334C30F}"/>
              </a:ext>
            </a:extLst>
          </p:cNvPr>
          <p:cNvSpPr txBox="1">
            <a:spLocks/>
          </p:cNvSpPr>
          <p:nvPr/>
        </p:nvSpPr>
        <p:spPr>
          <a:xfrm>
            <a:off x="609600" y="1600608"/>
            <a:ext cx="10972800" cy="4525963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Criticism is ruled out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Go for quantity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Encourage wild ideas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Build on the ideas of others</a:t>
            </a:r>
          </a:p>
          <a:p>
            <a:pPr>
              <a:lnSpc>
                <a:spcPct val="200000"/>
              </a:lnSpc>
            </a:pPr>
            <a:r>
              <a:rPr lang="en-US" sz="2800">
                <a:latin typeface="Poppins" pitchFamily="2" charset="77"/>
                <a:cs typeface="Poppins" pitchFamily="2" charset="77"/>
              </a:rPr>
              <a:t>One conversation at a time</a:t>
            </a:r>
          </a:p>
        </p:txBody>
      </p:sp>
    </p:spTree>
    <p:extLst>
      <p:ext uri="{BB962C8B-B14F-4D97-AF65-F5344CB8AC3E}">
        <p14:creationId xmlns:p14="http://schemas.microsoft.com/office/powerpoint/2010/main" val="66841614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1F09B950-4DA7-C287-23F2-1AA444BD3875}"/>
              </a:ext>
            </a:extLst>
          </p:cNvPr>
          <p:cNvSpPr/>
          <p:nvPr/>
        </p:nvSpPr>
        <p:spPr>
          <a:xfrm>
            <a:off x="0" y="0"/>
            <a:ext cx="12192000" cy="6347637"/>
          </a:xfrm>
          <a:prstGeom prst="rect">
            <a:avLst/>
          </a:prstGeom>
          <a:solidFill>
            <a:srgbClr val="A06AF9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Shape 0"/>
          <p:cNvSpPr/>
          <p:nvPr/>
        </p:nvSpPr>
        <p:spPr>
          <a:xfrm>
            <a:off x="1422393" y="1390916"/>
            <a:ext cx="4076679" cy="4076169"/>
          </a:xfrm>
          <a:prstGeom prst="ellipse">
            <a:avLst/>
          </a:prstGeom>
          <a:solidFill>
            <a:srgbClr val="FFFFFF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3" name="Text 1"/>
          <p:cNvSpPr/>
          <p:nvPr/>
        </p:nvSpPr>
        <p:spPr>
          <a:xfrm>
            <a:off x="6095968" y="2880855"/>
            <a:ext cx="5579505" cy="1102640"/>
          </a:xfrm>
          <a:prstGeom prst="rect">
            <a:avLst/>
          </a:prstGeom>
          <a:noFill/>
          <a:ln/>
        </p:spPr>
        <p:txBody>
          <a:bodyPr wrap="square" lIns="0" tIns="0" rIns="0" bIns="0" rtlCol="0" anchor="b"/>
          <a:lstStyle/>
          <a:p>
            <a:pPr>
              <a:lnSpc>
                <a:spcPts val="6846"/>
              </a:lnSpc>
            </a:pPr>
            <a:r>
              <a:rPr lang="en-US" sz="4600">
                <a:solidFill>
                  <a:srgbClr val="FFFFFF">
                    <a:alpha val="100000"/>
                  </a:srgbClr>
                </a:solidFill>
                <a:latin typeface="Poppins SemiBold" pitchFamily="34" charset="0"/>
                <a:ea typeface="Poppins SemiBold" pitchFamily="34" charset="-122"/>
                <a:cs typeface="Poppins SemiBold" pitchFamily="34" charset="-120"/>
              </a:rPr>
              <a:t>Breaking the Rules</a:t>
            </a:r>
            <a:endParaRPr lang="en-US" sz="4600"/>
          </a:p>
        </p:txBody>
      </p:sp>
      <p:pic>
        <p:nvPicPr>
          <p:cNvPr id="4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47649" y="1149647"/>
            <a:ext cx="5251423" cy="4565056"/>
          </a:xfrm>
          <a:prstGeom prst="rect">
            <a:avLst/>
          </a:prstGeom>
        </p:spPr>
      </p:pic>
      <p:sp>
        <p:nvSpPr>
          <p:cNvPr id="7" name="Text 1">
            <a:extLst>
              <a:ext uri="{FF2B5EF4-FFF2-40B4-BE49-F238E27FC236}">
                <a16:creationId xmlns:a16="http://schemas.microsoft.com/office/drawing/2014/main" id="{E62C7723-1BDF-CB3C-C42E-4469FBA79127}"/>
              </a:ext>
            </a:extLst>
          </p:cNvPr>
          <p:cNvSpPr/>
          <p:nvPr/>
        </p:nvSpPr>
        <p:spPr>
          <a:xfrm>
            <a:off x="6095968" y="2329535"/>
            <a:ext cx="5579505" cy="110264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>
              <a:lnSpc>
                <a:spcPts val="6846"/>
              </a:lnSpc>
            </a:pPr>
            <a:r>
              <a:rPr lang="en-US" sz="2400">
                <a:solidFill>
                  <a:srgbClr val="FFFFFF">
                    <a:alpha val="100000"/>
                  </a:srgbClr>
                </a:solidFill>
                <a:latin typeface="Poppins SemiBold" pitchFamily="34" charset="0"/>
                <a:cs typeface="Poppins SemiBold" pitchFamily="34" charset="-120"/>
              </a:rPr>
              <a:t>ACTIVITY ONE</a:t>
            </a:r>
            <a:endParaRPr lang="en-US" sz="2400"/>
          </a:p>
        </p:txBody>
      </p: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Breaking the Rul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207885-7543-BDC7-7D73-52C111498D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24642" y="1082150"/>
            <a:ext cx="8088691" cy="5606520"/>
          </a:xfrm>
        </p:spPr>
        <p:txBody>
          <a:bodyPr>
            <a:normAutofit fontScale="47500" lnSpcReduction="20000"/>
          </a:bodyPr>
          <a:lstStyle/>
          <a:p>
            <a:pPr>
              <a:lnSpc>
                <a:spcPct val="200000"/>
              </a:lnSpc>
              <a:buFont typeface="+mj-lt"/>
              <a:buAutoNum type="arabicPeriod"/>
            </a:pPr>
            <a:r>
              <a:rPr lang="en-US" sz="51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Identify the underlying rules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You might: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-Simply list them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-Create a process map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-Tell stories about personal experiences</a:t>
            </a:r>
          </a:p>
          <a:p>
            <a:pPr marL="355600" indent="-355600">
              <a:lnSpc>
                <a:spcPct val="200000"/>
              </a:lnSpc>
              <a:buFont typeface="+mj-lt"/>
              <a:buAutoNum type="arabicPeriod" startAt="2"/>
            </a:pPr>
            <a:r>
              <a:rPr lang="en-US" sz="51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Creatively challenge the rules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You might: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-Ask questions like </a:t>
            </a:r>
            <a:r>
              <a:rPr lang="en-US" sz="3600" i="1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“what aspects of this rule can we break?”</a:t>
            </a: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 				and </a:t>
            </a:r>
            <a:r>
              <a:rPr lang="en-US" sz="3600" i="1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“which would we like to keep?”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-Propose an alternative simple rule</a:t>
            </a:r>
          </a:p>
          <a:p>
            <a:pPr marL="355600" indent="-355600">
              <a:lnSpc>
                <a:spcPct val="200000"/>
              </a:lnSpc>
              <a:buFont typeface="+mj-lt"/>
              <a:buAutoNum type="arabicPeriod" startAt="3"/>
            </a:pPr>
            <a:r>
              <a:rPr lang="en-US" sz="51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Generate new ideas in your “new world”!</a:t>
            </a:r>
          </a:p>
          <a:p>
            <a:pPr marL="0" indent="0">
              <a:buNone/>
            </a:pPr>
            <a:r>
              <a:rPr lang="en-US" sz="32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</a:t>
            </a: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You might: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-Play out the scenario</a:t>
            </a:r>
          </a:p>
          <a:p>
            <a:pPr marL="0" indent="0">
              <a:buNone/>
            </a:pPr>
            <a:r>
              <a:rPr lang="en-US" sz="3600">
                <a:latin typeface="Poppins" pitchFamily="2" charset="77"/>
                <a:ea typeface="Arial Unicode MS" panose="020B0604020202020204" pitchFamily="34" charset="-128"/>
                <a:cs typeface="Poppins" pitchFamily="2" charset="77"/>
              </a:rPr>
              <a:t>		-Draw out the new proces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4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981360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864C4CCA-983F-54B2-A067-F38B689C854F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Shape 0"/>
          <p:cNvSpPr/>
          <p:nvPr/>
        </p:nvSpPr>
        <p:spPr>
          <a:xfrm>
            <a:off x="1111245" y="2178213"/>
            <a:ext cx="4514827" cy="3663473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3" name="Shape 1"/>
          <p:cNvSpPr/>
          <p:nvPr/>
        </p:nvSpPr>
        <p:spPr>
          <a:xfrm>
            <a:off x="1111245" y="2178213"/>
            <a:ext cx="4514827" cy="1257136"/>
          </a:xfrm>
          <a:prstGeom prst="roundRect">
            <a:avLst>
              <a:gd name="adj" fmla="val 25091"/>
            </a:avLst>
          </a:prstGeom>
          <a:solidFill>
            <a:srgbClr val="FFFFFF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4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295394" y="2178213"/>
            <a:ext cx="1257293" cy="1257136"/>
          </a:xfrm>
          <a:prstGeom prst="rect">
            <a:avLst/>
          </a:prstGeom>
        </p:spPr>
      </p:pic>
      <p:sp>
        <p:nvSpPr>
          <p:cNvPr id="5" name="Text 2"/>
          <p:cNvSpPr/>
          <p:nvPr/>
        </p:nvSpPr>
        <p:spPr>
          <a:xfrm>
            <a:off x="3022585" y="2346466"/>
            <a:ext cx="2482837" cy="920630"/>
          </a:xfrm>
          <a:prstGeom prst="rect">
            <a:avLst/>
          </a:prstGeom>
          <a:noFill/>
          <a:ln/>
        </p:spPr>
        <p:txBody>
          <a:bodyPr wrap="square" lIns="0" tIns="0" rIns="0" bIns="0" rtlCol="0" anchor="ctr"/>
          <a:lstStyle/>
          <a:p>
            <a:pPr>
              <a:lnSpc>
                <a:spcPts val="2250"/>
              </a:lnSpc>
            </a:pPr>
            <a:r>
              <a:rPr lang="en-US" sz="1500">
                <a:solidFill>
                  <a:srgbClr val="000000">
                    <a:alpha val="100000"/>
                  </a:srgbClr>
                </a:solidFill>
                <a:latin typeface="Poppins Regular" pitchFamily="34" charset="0"/>
                <a:ea typeface="Poppins Regular" pitchFamily="34" charset="-122"/>
                <a:cs typeface="Poppins Regular" pitchFamily="34" charset="-120"/>
              </a:rPr>
              <a:t>Setting realistic expectations is crucial in pain management</a:t>
            </a:r>
            <a:endParaRPr lang="en-US" sz="1500"/>
          </a:p>
        </p:txBody>
      </p:sp>
      <p:sp>
        <p:nvSpPr>
          <p:cNvPr id="6" name="Shape 3"/>
          <p:cNvSpPr/>
          <p:nvPr/>
        </p:nvSpPr>
        <p:spPr>
          <a:xfrm>
            <a:off x="1111245" y="4140108"/>
            <a:ext cx="4514827" cy="1257136"/>
          </a:xfrm>
          <a:prstGeom prst="roundRect">
            <a:avLst>
              <a:gd name="adj" fmla="val 25091"/>
            </a:avLst>
          </a:prstGeom>
          <a:solidFill>
            <a:srgbClr val="FFFFFF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7" name="Image 1" descr=" "/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314444" y="4140108"/>
            <a:ext cx="1257293" cy="1257136"/>
          </a:xfrm>
          <a:prstGeom prst="rect">
            <a:avLst/>
          </a:prstGeom>
        </p:spPr>
      </p:pic>
      <p:sp>
        <p:nvSpPr>
          <p:cNvPr id="8" name="Text 4"/>
          <p:cNvSpPr/>
          <p:nvPr/>
        </p:nvSpPr>
        <p:spPr>
          <a:xfrm>
            <a:off x="3041635" y="4308361"/>
            <a:ext cx="2444737" cy="920630"/>
          </a:xfrm>
          <a:prstGeom prst="rect">
            <a:avLst/>
          </a:prstGeom>
          <a:noFill/>
          <a:ln/>
        </p:spPr>
        <p:txBody>
          <a:bodyPr wrap="square" lIns="0" tIns="0" rIns="0" bIns="0" rtlCol="0" anchor="ctr"/>
          <a:lstStyle/>
          <a:p>
            <a:pPr>
              <a:lnSpc>
                <a:spcPts val="2250"/>
              </a:lnSpc>
            </a:pPr>
            <a:r>
              <a:rPr lang="en-US" sz="1500">
                <a:solidFill>
                  <a:srgbClr val="000000">
                    <a:alpha val="100000"/>
                  </a:srgbClr>
                </a:solidFill>
                <a:latin typeface="Poppins Regular" pitchFamily="34" charset="0"/>
                <a:ea typeface="Poppins Regular" pitchFamily="34" charset="-122"/>
                <a:cs typeface="Poppins Regular" pitchFamily="34" charset="-120"/>
              </a:rPr>
              <a:t>Pain is difficult for both patients and providers to accurately assess</a:t>
            </a:r>
            <a:endParaRPr lang="en-US" sz="1500"/>
          </a:p>
        </p:txBody>
      </p:sp>
      <p:sp>
        <p:nvSpPr>
          <p:cNvPr id="9" name="Shape 5"/>
          <p:cNvSpPr/>
          <p:nvPr/>
        </p:nvSpPr>
        <p:spPr>
          <a:xfrm>
            <a:off x="6616666" y="2178213"/>
            <a:ext cx="4514827" cy="3663473"/>
          </a:xfrm>
          <a:prstGeom prst="rect">
            <a:avLst/>
          </a:prstGeom>
          <a:noFill/>
          <a:ln/>
        </p:spPr>
        <p:txBody>
          <a:bodyPr/>
          <a:lstStyle/>
          <a:p>
            <a:endParaRPr lang="en-US"/>
          </a:p>
        </p:txBody>
      </p:sp>
      <p:sp>
        <p:nvSpPr>
          <p:cNvPr id="10" name="Shape 6"/>
          <p:cNvSpPr/>
          <p:nvPr/>
        </p:nvSpPr>
        <p:spPr>
          <a:xfrm>
            <a:off x="6616666" y="2178213"/>
            <a:ext cx="4514827" cy="1257136"/>
          </a:xfrm>
          <a:prstGeom prst="roundRect">
            <a:avLst>
              <a:gd name="adj" fmla="val 25091"/>
            </a:avLst>
          </a:prstGeom>
          <a:solidFill>
            <a:srgbClr val="FFFFFF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11" name="Image 2" descr=" "/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6689690" y="2178213"/>
            <a:ext cx="1257293" cy="1257136"/>
          </a:xfrm>
          <a:prstGeom prst="rect">
            <a:avLst/>
          </a:prstGeom>
        </p:spPr>
      </p:pic>
      <p:sp>
        <p:nvSpPr>
          <p:cNvPr id="12" name="Text 7"/>
          <p:cNvSpPr/>
          <p:nvPr/>
        </p:nvSpPr>
        <p:spPr>
          <a:xfrm>
            <a:off x="8416881" y="2357049"/>
            <a:ext cx="2702969" cy="899466"/>
          </a:xfrm>
          <a:prstGeom prst="rect">
            <a:avLst/>
          </a:prstGeom>
          <a:noFill/>
          <a:ln/>
        </p:spPr>
        <p:txBody>
          <a:bodyPr wrap="square" lIns="0" tIns="0" rIns="0" bIns="0" rtlCol="0" anchor="ctr"/>
          <a:lstStyle/>
          <a:p>
            <a:pPr>
              <a:lnSpc>
                <a:spcPts val="2175"/>
              </a:lnSpc>
            </a:pPr>
            <a:r>
              <a:rPr lang="en-US" sz="1450">
                <a:solidFill>
                  <a:srgbClr val="000000">
                    <a:alpha val="100000"/>
                  </a:srgbClr>
                </a:solidFill>
                <a:latin typeface="Poppins Regular" pitchFamily="34" charset="0"/>
                <a:ea typeface="Poppins Regular" pitchFamily="34" charset="-122"/>
                <a:cs typeface="Poppins Regular" pitchFamily="34" charset="-120"/>
              </a:rPr>
              <a:t>Inadequate support moving from pediatric to adult care can lead to challenges later</a:t>
            </a:r>
            <a:endParaRPr lang="en-US" sz="1450"/>
          </a:p>
        </p:txBody>
      </p:sp>
      <p:sp>
        <p:nvSpPr>
          <p:cNvPr id="13" name="Shape 8"/>
          <p:cNvSpPr/>
          <p:nvPr/>
        </p:nvSpPr>
        <p:spPr>
          <a:xfrm>
            <a:off x="6616666" y="4140108"/>
            <a:ext cx="4514827" cy="1257136"/>
          </a:xfrm>
          <a:prstGeom prst="roundRect">
            <a:avLst>
              <a:gd name="adj" fmla="val 25091"/>
            </a:avLst>
          </a:prstGeom>
          <a:solidFill>
            <a:srgbClr val="FFFFFF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pic>
        <p:nvPicPr>
          <p:cNvPr id="14" name="Image 3" descr=" "/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6778590" y="4140108"/>
            <a:ext cx="1257293" cy="1257136"/>
          </a:xfrm>
          <a:prstGeom prst="rect">
            <a:avLst/>
          </a:prstGeom>
        </p:spPr>
      </p:pic>
      <p:sp>
        <p:nvSpPr>
          <p:cNvPr id="15" name="Text 9"/>
          <p:cNvSpPr/>
          <p:nvPr/>
        </p:nvSpPr>
        <p:spPr>
          <a:xfrm>
            <a:off x="8505781" y="4308361"/>
            <a:ext cx="2527287" cy="920630"/>
          </a:xfrm>
          <a:prstGeom prst="rect">
            <a:avLst/>
          </a:prstGeom>
          <a:noFill/>
          <a:ln/>
        </p:spPr>
        <p:txBody>
          <a:bodyPr wrap="square" lIns="0" tIns="0" rIns="0" bIns="0" rtlCol="0" anchor="ctr"/>
          <a:lstStyle/>
          <a:p>
            <a:pPr>
              <a:lnSpc>
                <a:spcPts val="2250"/>
              </a:lnSpc>
            </a:pPr>
            <a:r>
              <a:rPr lang="en-US" sz="1500">
                <a:solidFill>
                  <a:srgbClr val="000000">
                    <a:alpha val="100000"/>
                  </a:srgbClr>
                </a:solidFill>
                <a:latin typeface="Poppins Regular" pitchFamily="34" charset="0"/>
                <a:ea typeface="Poppins Regular" pitchFamily="34" charset="-122"/>
                <a:cs typeface="Poppins Regular" pitchFamily="34" charset="-120"/>
              </a:rPr>
              <a:t>Siloed care hampers collaboration across a patient’s care team</a:t>
            </a:r>
            <a:endParaRPr lang="en-US" sz="1500"/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078F1931-B4AE-6332-525F-249B4145D5AA}"/>
              </a:ext>
            </a:extLst>
          </p:cNvPr>
          <p:cNvSpPr txBox="1">
            <a:spLocks/>
          </p:cNvSpPr>
          <p:nvPr/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Arial"/>
                <a:ea typeface="+mj-ea"/>
                <a:cs typeface="+mj-cs"/>
              </a:defRPr>
            </a:lvl1pPr>
          </a:lstStyle>
          <a:p>
            <a:r>
              <a:rPr lang="en-US" sz="4000">
                <a:latin typeface="Poppins" pitchFamily="2" charset="77"/>
                <a:cs typeface="Poppins" pitchFamily="2" charset="77"/>
              </a:rPr>
              <a:t>Key Themes from Primary Research</a:t>
            </a:r>
          </a:p>
        </p:txBody>
      </p:sp>
    </p:spTree>
    <p:extLst>
      <p:ext uri="{BB962C8B-B14F-4D97-AF65-F5344CB8AC3E}">
        <p14:creationId xmlns:p14="http://schemas.microsoft.com/office/powerpoint/2010/main" val="608645504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1F09B950-4DA7-C287-23F2-1AA444BD3875}"/>
              </a:ext>
            </a:extLst>
          </p:cNvPr>
          <p:cNvSpPr/>
          <p:nvPr/>
        </p:nvSpPr>
        <p:spPr>
          <a:xfrm>
            <a:off x="0" y="0"/>
            <a:ext cx="12192000" cy="6347637"/>
          </a:xfrm>
          <a:prstGeom prst="rect">
            <a:avLst/>
          </a:prstGeom>
          <a:solidFill>
            <a:srgbClr val="A06AF9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Shape 0"/>
          <p:cNvSpPr/>
          <p:nvPr/>
        </p:nvSpPr>
        <p:spPr>
          <a:xfrm>
            <a:off x="1422393" y="1390916"/>
            <a:ext cx="4076679" cy="4076169"/>
          </a:xfrm>
          <a:prstGeom prst="ellipse">
            <a:avLst/>
          </a:prstGeom>
          <a:solidFill>
            <a:srgbClr val="FFFFFF">
              <a:alpha val="100000"/>
            </a:srgbClr>
          </a:solidFill>
          <a:ln/>
        </p:spPr>
        <p:txBody>
          <a:bodyPr/>
          <a:lstStyle/>
          <a:p>
            <a:endParaRPr lang="en-US"/>
          </a:p>
        </p:txBody>
      </p:sp>
      <p:sp>
        <p:nvSpPr>
          <p:cNvPr id="3" name="Text 1"/>
          <p:cNvSpPr/>
          <p:nvPr/>
        </p:nvSpPr>
        <p:spPr>
          <a:xfrm>
            <a:off x="6095968" y="2880855"/>
            <a:ext cx="5579505" cy="1102640"/>
          </a:xfrm>
          <a:prstGeom prst="rect">
            <a:avLst/>
          </a:prstGeom>
          <a:noFill/>
          <a:ln/>
        </p:spPr>
        <p:txBody>
          <a:bodyPr wrap="square" lIns="0" tIns="0" rIns="0" bIns="0" rtlCol="0" anchor="b"/>
          <a:lstStyle/>
          <a:p>
            <a:pPr>
              <a:lnSpc>
                <a:spcPts val="6846"/>
              </a:lnSpc>
            </a:pPr>
            <a:r>
              <a:rPr lang="en-US" sz="4600">
                <a:solidFill>
                  <a:srgbClr val="FFFFFF">
                    <a:alpha val="100000"/>
                  </a:srgbClr>
                </a:solidFill>
                <a:latin typeface="Poppins SemiBold" pitchFamily="34" charset="0"/>
                <a:ea typeface="Poppins SemiBold" pitchFamily="34" charset="-122"/>
                <a:cs typeface="Poppins SemiBold" pitchFamily="34" charset="-120"/>
              </a:rPr>
              <a:t>Wild Card</a:t>
            </a:r>
            <a:endParaRPr lang="en-US" sz="4600"/>
          </a:p>
        </p:txBody>
      </p:sp>
      <p:pic>
        <p:nvPicPr>
          <p:cNvPr id="4" name="Image 0" descr=" 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47649" y="1149647"/>
            <a:ext cx="5251423" cy="4565056"/>
          </a:xfrm>
          <a:prstGeom prst="rect">
            <a:avLst/>
          </a:prstGeom>
        </p:spPr>
      </p:pic>
      <p:sp>
        <p:nvSpPr>
          <p:cNvPr id="7" name="Text 1">
            <a:extLst>
              <a:ext uri="{FF2B5EF4-FFF2-40B4-BE49-F238E27FC236}">
                <a16:creationId xmlns:a16="http://schemas.microsoft.com/office/drawing/2014/main" id="{E62C7723-1BDF-CB3C-C42E-4469FBA79127}"/>
              </a:ext>
            </a:extLst>
          </p:cNvPr>
          <p:cNvSpPr/>
          <p:nvPr/>
        </p:nvSpPr>
        <p:spPr>
          <a:xfrm>
            <a:off x="6095968" y="2329535"/>
            <a:ext cx="5579505" cy="110264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>
              <a:lnSpc>
                <a:spcPts val="6846"/>
              </a:lnSpc>
            </a:pPr>
            <a:r>
              <a:rPr lang="en-US" sz="2400">
                <a:solidFill>
                  <a:srgbClr val="FFFFFF">
                    <a:alpha val="100000"/>
                  </a:srgbClr>
                </a:solidFill>
                <a:latin typeface="Poppins SemiBold" pitchFamily="34" charset="0"/>
                <a:cs typeface="Poppins SemiBold" pitchFamily="34" charset="-120"/>
              </a:rPr>
              <a:t>ACTIVITY TWO</a:t>
            </a:r>
            <a:endParaRPr lang="en-US" sz="2400"/>
          </a:p>
        </p:txBody>
      </p:sp>
    </p:spTree>
    <p:extLst>
      <p:ext uri="{BB962C8B-B14F-4D97-AF65-F5344CB8AC3E}">
        <p14:creationId xmlns:p14="http://schemas.microsoft.com/office/powerpoint/2010/main" val="2213343965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A107A241-62B2-AA0F-9AD6-7DD6B0CF8B47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Wild Card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46</a:t>
            </a:fld>
            <a:endParaRPr lang="en-US"/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AE2A5D8E-2209-C56E-E753-DC1CB99AD536}"/>
              </a:ext>
            </a:extLst>
          </p:cNvPr>
          <p:cNvSpPr/>
          <p:nvPr/>
        </p:nvSpPr>
        <p:spPr>
          <a:xfrm>
            <a:off x="1982603" y="1417638"/>
            <a:ext cx="8226793" cy="4592704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97AB7A9-7043-9FA6-230C-DA4099D740B8}"/>
              </a:ext>
            </a:extLst>
          </p:cNvPr>
          <p:cNvSpPr txBox="1"/>
          <p:nvPr/>
        </p:nvSpPr>
        <p:spPr>
          <a:xfrm>
            <a:off x="2598209" y="1692276"/>
            <a:ext cx="6995577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After identifying an infiltrate across factories globally, all over-the-counter pain relievers have been recalled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77C07C-5423-C3DD-3FA0-1C74E67ACE4A}"/>
              </a:ext>
            </a:extLst>
          </p:cNvPr>
          <p:cNvSpPr txBox="1"/>
          <p:nvPr/>
        </p:nvSpPr>
        <p:spPr>
          <a:xfrm>
            <a:off x="2255302" y="4150464"/>
            <a:ext cx="76813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>
                <a:solidFill>
                  <a:schemeClr val="tx1">
                    <a:lumMod val="65000"/>
                    <a:lumOff val="35000"/>
                  </a:schemeClr>
                </a:solidFill>
                <a:latin typeface="Poppins" pitchFamily="2" charset="77"/>
                <a:cs typeface="Poppins" pitchFamily="2" charset="77"/>
              </a:rPr>
              <a:t>How can we control patient pain through alternate routes? How will patients be advised if they won’t have access to these medications? </a:t>
            </a:r>
          </a:p>
        </p:txBody>
      </p:sp>
    </p:spTree>
    <p:extLst>
      <p:ext uri="{BB962C8B-B14F-4D97-AF65-F5344CB8AC3E}">
        <p14:creationId xmlns:p14="http://schemas.microsoft.com/office/powerpoint/2010/main" val="2467879601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A107A241-62B2-AA0F-9AD6-7DD6B0CF8B47}"/>
              </a:ext>
            </a:extLst>
          </p:cNvPr>
          <p:cNvSpPr/>
          <p:nvPr/>
        </p:nvSpPr>
        <p:spPr>
          <a:xfrm>
            <a:off x="0" y="0"/>
            <a:ext cx="12192000" cy="6356351"/>
          </a:xfrm>
          <a:prstGeom prst="rect">
            <a:avLst/>
          </a:prstGeom>
          <a:solidFill>
            <a:srgbClr val="E9CD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91EFF52-3FCA-B3F7-040C-F80C3BA78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>
                <a:latin typeface="Poppins" pitchFamily="2" charset="77"/>
                <a:cs typeface="Poppins" pitchFamily="2" charset="77"/>
              </a:rPr>
              <a:t>Wild Card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8F5324-B65E-BD45-51E3-C8B85860B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47</a:t>
            </a:fld>
            <a:endParaRPr lang="en-US"/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AE2A5D8E-2209-C56E-E753-DC1CB99AD536}"/>
              </a:ext>
            </a:extLst>
          </p:cNvPr>
          <p:cNvSpPr/>
          <p:nvPr/>
        </p:nvSpPr>
        <p:spPr>
          <a:xfrm>
            <a:off x="1982603" y="1417638"/>
            <a:ext cx="8226793" cy="4592704"/>
          </a:xfrm>
          <a:prstGeom prst="round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B763137-20FE-985D-B464-029B91123AF6}"/>
              </a:ext>
            </a:extLst>
          </p:cNvPr>
          <p:cNvSpPr txBox="1"/>
          <p:nvPr/>
        </p:nvSpPr>
        <p:spPr>
          <a:xfrm>
            <a:off x="2443093" y="1692276"/>
            <a:ext cx="7305812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Poppins" pitchFamily="2" charset="77"/>
                <a:cs typeface="Poppins" pitchFamily="2" charset="77"/>
              </a:rPr>
              <a:t>Earlier today, the Supreme Court ruled that it is now illegal for providers to talk about their patients with one another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7263E1-FF96-B883-B922-ED46C9C9458C}"/>
              </a:ext>
            </a:extLst>
          </p:cNvPr>
          <p:cNvSpPr txBox="1"/>
          <p:nvPr/>
        </p:nvSpPr>
        <p:spPr>
          <a:xfrm>
            <a:off x="2118951" y="4102230"/>
            <a:ext cx="79540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>
                <a:solidFill>
                  <a:schemeClr val="tx1">
                    <a:lumMod val="65000"/>
                    <a:lumOff val="35000"/>
                  </a:schemeClr>
                </a:solidFill>
                <a:latin typeface="Poppins" pitchFamily="2" charset="77"/>
                <a:cs typeface="Poppins" pitchFamily="2" charset="77"/>
              </a:rPr>
              <a:t>As providers (yes, </a:t>
            </a:r>
            <a:r>
              <a:rPr lang="en-US" sz="2400" b="1">
                <a:solidFill>
                  <a:schemeClr val="tx1">
                    <a:lumMod val="65000"/>
                    <a:lumOff val="35000"/>
                  </a:schemeClr>
                </a:solidFill>
                <a:latin typeface="Poppins" pitchFamily="2" charset="77"/>
                <a:cs typeface="Poppins" pitchFamily="2" charset="77"/>
              </a:rPr>
              <a:t>all</a:t>
            </a:r>
            <a:r>
              <a:rPr lang="en-US" sz="2400">
                <a:solidFill>
                  <a:schemeClr val="tx1">
                    <a:lumMod val="65000"/>
                    <a:lumOff val="35000"/>
                  </a:schemeClr>
                </a:solidFill>
                <a:latin typeface="Poppins" pitchFamily="2" charset="77"/>
                <a:cs typeface="Poppins" pitchFamily="2" charset="77"/>
              </a:rPr>
              <a:t> of you are providers now!), how will you continue to provide comprehensive care for your patients? How will you approach cases where your patient has multiple conditions?</a:t>
            </a:r>
          </a:p>
        </p:txBody>
      </p:sp>
    </p:spTree>
    <p:extLst>
      <p:ext uri="{BB962C8B-B14F-4D97-AF65-F5344CB8AC3E}">
        <p14:creationId xmlns:p14="http://schemas.microsoft.com/office/powerpoint/2010/main" val="1628187591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/>
              <a:t>Next step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599" y="1600201"/>
            <a:ext cx="11057264" cy="4525963"/>
          </a:xfrm>
        </p:spPr>
        <p:txBody>
          <a:bodyPr>
            <a:normAutofit/>
          </a:bodyPr>
          <a:lstStyle/>
          <a:p>
            <a:endParaRPr lang="en-US" sz="2800"/>
          </a:p>
          <a:p>
            <a:r>
              <a:rPr lang="en-US" sz="2800"/>
              <a:t>You will be hearing from us soon for any follow-up discussion</a:t>
            </a:r>
          </a:p>
          <a:p>
            <a:endParaRPr lang="en-US" sz="2800"/>
          </a:p>
          <a:p>
            <a:r>
              <a:rPr lang="en-US" sz="2800"/>
              <a:t>If you’d like to be more involved or have questions </a:t>
            </a:r>
            <a:r>
              <a:rPr lang="en-US" sz="2800">
                <a:sym typeface="Wingdings" panose="05000000000000000000" pitchFamily="2" charset="2"/>
              </a:rPr>
              <a:t> let us know!</a:t>
            </a:r>
            <a:endParaRPr lang="en-US" sz="2800"/>
          </a:p>
          <a:p>
            <a:endParaRPr lang="en-US" sz="2800"/>
          </a:p>
          <a:p>
            <a:pPr marL="0" indent="0">
              <a:buNone/>
            </a:pPr>
            <a:endParaRPr lang="en-US" sz="2800"/>
          </a:p>
          <a:p>
            <a:endParaRPr lang="en-US" sz="2800"/>
          </a:p>
          <a:p>
            <a:pPr lvl="1"/>
            <a:endParaRPr lang="en-US" sz="2400"/>
          </a:p>
          <a:p>
            <a:pPr marL="457200" lvl="1" indent="0">
              <a:buNone/>
            </a:pPr>
            <a:endParaRPr lang="en-US" sz="2400"/>
          </a:p>
          <a:p>
            <a:pPr marL="457200" lvl="1" indent="0">
              <a:buNone/>
            </a:pPr>
            <a:endParaRPr lang="en-US" sz="2000"/>
          </a:p>
          <a:p>
            <a:pPr marL="914400" lvl="2" indent="0">
              <a:buNone/>
            </a:pPr>
            <a:endParaRPr lang="en-US" sz="2000"/>
          </a:p>
          <a:p>
            <a:pPr lvl="2"/>
            <a:endParaRPr lang="en-US" sz="200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4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3746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/>
              <a:t>Why have we brought everyone together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sz="2800"/>
              <a:t>Improving the safety of pain management and reducing unsafe opioid use (e.g. chronic use) is a top priority nationally + for the CCF and NM</a:t>
            </a:r>
          </a:p>
          <a:p>
            <a:endParaRPr lang="en-US" sz="2800"/>
          </a:p>
          <a:p>
            <a:r>
              <a:rPr lang="en-US" sz="2800"/>
              <a:t>We need practical, evidence-based solutions for this problem that meet patient and clinician needs</a:t>
            </a:r>
          </a:p>
          <a:p>
            <a:endParaRPr lang="en-US" sz="2800"/>
          </a:p>
          <a:p>
            <a:r>
              <a:rPr lang="en-US" sz="2800">
                <a:solidFill>
                  <a:schemeClr val="bg1"/>
                </a:solidFill>
              </a:rPr>
              <a:t>Adolescents and young adults (AYA) with IBD have complex healthcare needs in a vulnerable stage of life</a:t>
            </a:r>
          </a:p>
          <a:p>
            <a:endParaRPr lang="en-US" sz="2800">
              <a:solidFill>
                <a:schemeClr val="bg1"/>
              </a:solidFill>
            </a:endParaRPr>
          </a:p>
          <a:p>
            <a:r>
              <a:rPr lang="en-US" sz="2800">
                <a:solidFill>
                  <a:schemeClr val="bg1"/>
                </a:solidFill>
              </a:rPr>
              <a:t>When it comes to pain management / opioid use </a:t>
            </a:r>
            <a:r>
              <a:rPr lang="en-US" sz="2800">
                <a:solidFill>
                  <a:schemeClr val="bg1"/>
                </a:solidFill>
                <a:sym typeface="Wingdings" panose="05000000000000000000" pitchFamily="2" charset="2"/>
              </a:rPr>
              <a:t></a:t>
            </a:r>
            <a:r>
              <a:rPr lang="en-US" sz="2800">
                <a:solidFill>
                  <a:schemeClr val="bg1"/>
                </a:solidFill>
              </a:rPr>
              <a:t> patients and clinicians are not always on the same page</a:t>
            </a:r>
          </a:p>
          <a:p>
            <a:pPr marL="0" indent="0">
              <a:buNone/>
            </a:pPr>
            <a:endParaRPr lang="en-US" sz="2800"/>
          </a:p>
          <a:p>
            <a:r>
              <a:rPr lang="en-US" sz="2800" b="1">
                <a:solidFill>
                  <a:schemeClr val="bg1"/>
                </a:solidFill>
              </a:rPr>
              <a:t>From our perspective, working directly with you to design a potential solution is key </a:t>
            </a:r>
            <a:r>
              <a:rPr lang="en-US" sz="2800" b="1">
                <a:solidFill>
                  <a:schemeClr val="bg1"/>
                </a:solidFill>
                <a:sym typeface="Wingdings" panose="05000000000000000000" pitchFamily="2" charset="2"/>
              </a:rPr>
              <a:t> our goal is to make it make sense!</a:t>
            </a:r>
            <a:endParaRPr lang="en-US" sz="2800" b="1">
              <a:solidFill>
                <a:schemeClr val="bg1"/>
              </a:solidFill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162803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/>
              <a:t>Thank you!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599" y="1600201"/>
            <a:ext cx="11057264" cy="4525963"/>
          </a:xfrm>
        </p:spPr>
        <p:txBody>
          <a:bodyPr>
            <a:normAutofit fontScale="92500" lnSpcReduction="10000"/>
          </a:bodyPr>
          <a:lstStyle/>
          <a:p>
            <a:endParaRPr lang="en-US" sz="2800"/>
          </a:p>
          <a:p>
            <a:r>
              <a:rPr lang="en-US" sz="2800"/>
              <a:t>CCF CDA Team</a:t>
            </a:r>
          </a:p>
          <a:p>
            <a:pPr marL="0" indent="0">
              <a:buNone/>
            </a:pPr>
            <a:endParaRPr lang="en-US" sz="2800"/>
          </a:p>
          <a:p>
            <a:r>
              <a:rPr lang="en-US" sz="2800"/>
              <a:t>Division of Gastroenterology &amp; Hepatology</a:t>
            </a:r>
            <a:endParaRPr lang="en-US" sz="2400"/>
          </a:p>
          <a:p>
            <a:endParaRPr lang="en-US" sz="2800"/>
          </a:p>
          <a:p>
            <a:r>
              <a:rPr lang="en-US" sz="2800"/>
              <a:t>Institute for Public Health and Medicine</a:t>
            </a:r>
          </a:p>
          <a:p>
            <a:pPr lvl="1"/>
            <a:r>
              <a:rPr lang="en-US" sz="2400"/>
              <a:t>Center for Health Services &amp; Outcomes Research</a:t>
            </a:r>
          </a:p>
          <a:p>
            <a:pPr lvl="1"/>
            <a:r>
              <a:rPr lang="en-US" sz="2400"/>
              <a:t>Northwestern Quality Improvement, Research, &amp; Education in Surgery</a:t>
            </a:r>
          </a:p>
          <a:p>
            <a:endParaRPr lang="en-US" sz="2800"/>
          </a:p>
          <a:p>
            <a:r>
              <a:rPr lang="en-US" sz="2800"/>
              <a:t>Segal Design Institute @ McCormick School of Engineering</a:t>
            </a:r>
          </a:p>
          <a:p>
            <a:endParaRPr lang="en-US" sz="2800"/>
          </a:p>
          <a:p>
            <a:pPr marL="0" indent="0">
              <a:buNone/>
            </a:pPr>
            <a:endParaRPr lang="en-US" sz="2800"/>
          </a:p>
          <a:p>
            <a:endParaRPr lang="en-US" sz="2800"/>
          </a:p>
          <a:p>
            <a:pPr lvl="1"/>
            <a:endParaRPr lang="en-US" sz="2400"/>
          </a:p>
          <a:p>
            <a:pPr marL="457200" lvl="1" indent="0">
              <a:buNone/>
            </a:pPr>
            <a:endParaRPr lang="en-US" sz="2400"/>
          </a:p>
          <a:p>
            <a:pPr marL="457200" lvl="1" indent="0">
              <a:buNone/>
            </a:pPr>
            <a:endParaRPr lang="en-US" sz="2000"/>
          </a:p>
          <a:p>
            <a:pPr marL="914400" lvl="2" indent="0">
              <a:buNone/>
            </a:pPr>
            <a:endParaRPr lang="en-US" sz="2000"/>
          </a:p>
          <a:p>
            <a:pPr lvl="2"/>
            <a:endParaRPr lang="en-US" sz="200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4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6164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/>
              <a:t>Why have we brought everyone together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sz="2800"/>
              <a:t>Improving the safety of pain management and reducing unsafe opioid use (e.g. chronic use) is a top priority nationally + for the CCF and NM</a:t>
            </a:r>
          </a:p>
          <a:p>
            <a:endParaRPr lang="en-US" sz="2800"/>
          </a:p>
          <a:p>
            <a:r>
              <a:rPr lang="en-US" sz="2800"/>
              <a:t>We need practical, evidence-based solutions for this problem that meet patient and clinician needs</a:t>
            </a:r>
          </a:p>
          <a:p>
            <a:endParaRPr lang="en-US" sz="2800"/>
          </a:p>
          <a:p>
            <a:r>
              <a:rPr lang="en-US" sz="2800"/>
              <a:t>Adolescents and young adults (AYA) with IBD have complex healthcare needs in a vulnerable stage of life</a:t>
            </a:r>
          </a:p>
          <a:p>
            <a:endParaRPr lang="en-US" sz="2800"/>
          </a:p>
          <a:p>
            <a:r>
              <a:rPr lang="en-US" sz="2800"/>
              <a:t>When it comes to pain management / opioid use </a:t>
            </a:r>
            <a:r>
              <a:rPr lang="en-US" sz="2800">
                <a:sym typeface="Wingdings" panose="05000000000000000000" pitchFamily="2" charset="2"/>
              </a:rPr>
              <a:t></a:t>
            </a:r>
            <a:r>
              <a:rPr lang="en-US" sz="2800"/>
              <a:t> patients and clinicians are not always on the same page and there are many influences outside IBD care</a:t>
            </a:r>
          </a:p>
          <a:p>
            <a:pPr marL="0" indent="0">
              <a:buNone/>
            </a:pPr>
            <a:endParaRPr lang="en-US" sz="2800"/>
          </a:p>
          <a:p>
            <a:r>
              <a:rPr lang="en-US" sz="2800" b="1">
                <a:solidFill>
                  <a:schemeClr val="bg1"/>
                </a:solidFill>
              </a:rPr>
              <a:t>From our perspective, working directly with you to design a potential solution is key </a:t>
            </a:r>
            <a:r>
              <a:rPr lang="en-US" sz="2800" b="1">
                <a:solidFill>
                  <a:schemeClr val="bg1"/>
                </a:solidFill>
                <a:sym typeface="Wingdings" panose="05000000000000000000" pitchFamily="2" charset="2"/>
              </a:rPr>
              <a:t> our goal is to make it make sense!</a:t>
            </a:r>
            <a:endParaRPr lang="en-US" sz="2800" b="1">
              <a:solidFill>
                <a:schemeClr val="bg1"/>
              </a:solidFill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7242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4E27F-D033-421D-AEE5-50EBC7BB9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/>
              <a:t>Why have we brought everyone together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91B214-3481-427C-B184-5B1985478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sz="2800"/>
              <a:t>Improving the safety of pain management and reducing unsafe opioid use (e.g. chronic use) is a top priority nationally + for the CCF and NM</a:t>
            </a:r>
          </a:p>
          <a:p>
            <a:endParaRPr lang="en-US" sz="2800"/>
          </a:p>
          <a:p>
            <a:r>
              <a:rPr lang="en-US" sz="2800"/>
              <a:t>We need practical, evidence-based solutions for this problem that meet patient and clinician needs</a:t>
            </a:r>
          </a:p>
          <a:p>
            <a:endParaRPr lang="en-US" sz="2800"/>
          </a:p>
          <a:p>
            <a:r>
              <a:rPr lang="en-US" sz="2800"/>
              <a:t>Adolescents and young adults (AYA) with IBD have complex healthcare needs in a vulnerable stage of life</a:t>
            </a:r>
          </a:p>
          <a:p>
            <a:endParaRPr lang="en-US" sz="2800"/>
          </a:p>
          <a:p>
            <a:r>
              <a:rPr lang="en-US" sz="2800"/>
              <a:t>When it comes to pain management / opioid use </a:t>
            </a:r>
            <a:r>
              <a:rPr lang="en-US" sz="2800">
                <a:sym typeface="Wingdings" panose="05000000000000000000" pitchFamily="2" charset="2"/>
              </a:rPr>
              <a:t></a:t>
            </a:r>
            <a:r>
              <a:rPr lang="en-US" sz="2800"/>
              <a:t> patients and clinicians are not always on the same page and there are many influences outside IBD care</a:t>
            </a:r>
          </a:p>
          <a:p>
            <a:pPr marL="0" indent="0">
              <a:buNone/>
            </a:pPr>
            <a:endParaRPr lang="en-US" sz="2800"/>
          </a:p>
          <a:p>
            <a:r>
              <a:rPr lang="en-US" sz="2800" b="1"/>
              <a:t>From our perspective, working directly with you to design a potential solution is key </a:t>
            </a:r>
            <a:r>
              <a:rPr lang="en-US" sz="2800" b="1">
                <a:sym typeface="Wingdings" panose="05000000000000000000" pitchFamily="2" charset="2"/>
              </a:rPr>
              <a:t> our goal is to make it make sense!</a:t>
            </a:r>
            <a:endParaRPr lang="en-US" sz="2800" b="1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D940B6-60A0-444C-8A30-44BC73B0B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5572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b="1"/>
              <a:t>Key questions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7</a:t>
            </a:fld>
            <a:endParaRPr lang="en-US"/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105027" y="1641655"/>
            <a:ext cx="6278124" cy="1017639"/>
          </a:xfrm>
        </p:spPr>
        <p:txBody>
          <a:bodyPr anchor="ctr">
            <a:noAutofit/>
          </a:bodyPr>
          <a:lstStyle/>
          <a:p>
            <a:pPr marL="0" indent="0">
              <a:buNone/>
            </a:pPr>
            <a:r>
              <a:rPr lang="en-US" sz="1800"/>
              <a:t>What are the predictors of chronic opioid use among AYA with IBD and other painful, chronic digestive disorders?</a:t>
            </a:r>
          </a:p>
        </p:txBody>
      </p:sp>
      <p:sp>
        <p:nvSpPr>
          <p:cNvPr id="8" name="Subtitle 2">
            <a:extLst>
              <a:ext uri="{FF2B5EF4-FFF2-40B4-BE49-F238E27FC236}">
                <a16:creationId xmlns:a16="http://schemas.microsoft.com/office/drawing/2014/main" id="{C4E81C43-478B-4233-9B46-8E1E79A77FDB}"/>
              </a:ext>
            </a:extLst>
          </p:cNvPr>
          <p:cNvSpPr txBox="1">
            <a:spLocks/>
          </p:cNvSpPr>
          <p:nvPr/>
        </p:nvSpPr>
        <p:spPr>
          <a:xfrm>
            <a:off x="1901332" y="1932039"/>
            <a:ext cx="8389345" cy="35543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00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1780968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3EADCAC0-EC12-4C99-8F63-E8CAE9E29D16}"/>
              </a:ext>
            </a:extLst>
          </p:cNvPr>
          <p:cNvSpPr txBox="1">
            <a:spLocks/>
          </p:cNvSpPr>
          <p:nvPr/>
        </p:nvSpPr>
        <p:spPr>
          <a:xfrm>
            <a:off x="4385187" y="4619833"/>
            <a:ext cx="5825612" cy="1017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endParaRPr lang="en-US" sz="200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2945815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4110663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 txBox="1">
            <a:spLocks/>
          </p:cNvSpPr>
          <p:nvPr/>
        </p:nvSpPr>
        <p:spPr>
          <a:xfrm>
            <a:off x="3105027" y="2748456"/>
            <a:ext cx="6278124" cy="10176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/>
              <a:t>To deliver personalized chronic opioid use information to end-users (AYA and clinicians), what should the design of a digital opioid safety intervention look like? </a:t>
            </a:r>
          </a:p>
        </p:txBody>
      </p:sp>
      <p:sp>
        <p:nvSpPr>
          <p:cNvPr id="17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 txBox="1">
            <a:spLocks/>
          </p:cNvSpPr>
          <p:nvPr/>
        </p:nvSpPr>
        <p:spPr>
          <a:xfrm>
            <a:off x="3105027" y="3907127"/>
            <a:ext cx="6278124" cy="10176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/>
              <a:t>When we develop and pilot test the intervention, to what extent is it feasible and usable by end-users?</a:t>
            </a:r>
          </a:p>
        </p:txBody>
      </p:sp>
    </p:spTree>
    <p:extLst>
      <p:ext uri="{BB962C8B-B14F-4D97-AF65-F5344CB8AC3E}">
        <p14:creationId xmlns:p14="http://schemas.microsoft.com/office/powerpoint/2010/main" val="2630816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b="1"/>
              <a:t>Key questions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E12CD-FCB1-464E-A775-0B83FDDACE03}" type="slidenum">
              <a:rPr lang="en-US" smtClean="0"/>
              <a:pPr/>
              <a:t>8</a:t>
            </a:fld>
            <a:endParaRPr lang="en-US"/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105027" y="1641655"/>
            <a:ext cx="6278124" cy="1017639"/>
          </a:xfrm>
        </p:spPr>
        <p:txBody>
          <a:bodyPr anchor="ctr">
            <a:noAutofit/>
          </a:bodyPr>
          <a:lstStyle/>
          <a:p>
            <a:pPr marL="0" indent="0">
              <a:buNone/>
            </a:pPr>
            <a:r>
              <a:rPr lang="en-US" sz="1800"/>
              <a:t>What are the predictors of chronic opioid use among AYA with IBD and other painful, chronic digestive disorders?</a:t>
            </a:r>
          </a:p>
        </p:txBody>
      </p:sp>
      <p:sp>
        <p:nvSpPr>
          <p:cNvPr id="8" name="Subtitle 2">
            <a:extLst>
              <a:ext uri="{FF2B5EF4-FFF2-40B4-BE49-F238E27FC236}">
                <a16:creationId xmlns:a16="http://schemas.microsoft.com/office/drawing/2014/main" id="{C4E81C43-478B-4233-9B46-8E1E79A77FDB}"/>
              </a:ext>
            </a:extLst>
          </p:cNvPr>
          <p:cNvSpPr txBox="1">
            <a:spLocks/>
          </p:cNvSpPr>
          <p:nvPr/>
        </p:nvSpPr>
        <p:spPr>
          <a:xfrm>
            <a:off x="1901332" y="1932039"/>
            <a:ext cx="8389345" cy="35543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00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1780968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2945815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49233C3-D6EC-4B70-A37E-87D090F9965C}"/>
              </a:ext>
            </a:extLst>
          </p:cNvPr>
          <p:cNvSpPr/>
          <p:nvPr/>
        </p:nvSpPr>
        <p:spPr>
          <a:xfrm>
            <a:off x="1793632" y="4110663"/>
            <a:ext cx="1065946" cy="712850"/>
          </a:xfrm>
          <a:prstGeom prst="rect">
            <a:avLst/>
          </a:prstGeom>
          <a:solidFill>
            <a:srgbClr val="0070C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CA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 txBox="1">
            <a:spLocks/>
          </p:cNvSpPr>
          <p:nvPr/>
        </p:nvSpPr>
        <p:spPr>
          <a:xfrm>
            <a:off x="3105027" y="2748456"/>
            <a:ext cx="6278124" cy="10176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/>
              <a:t>To deliver personalized chronic opioid use information to end-users (AYA and clinicians), what should the design of a digital opioid safety intervention look like? </a:t>
            </a:r>
          </a:p>
        </p:txBody>
      </p:sp>
      <p:sp>
        <p:nvSpPr>
          <p:cNvPr id="17" name="Content Placeholder 2">
            <a:extLst>
              <a:ext uri="{FF2B5EF4-FFF2-40B4-BE49-F238E27FC236}">
                <a16:creationId xmlns:a16="http://schemas.microsoft.com/office/drawing/2014/main" id="{56EB9455-1662-4990-A79B-452FD83FA5AE}"/>
              </a:ext>
            </a:extLst>
          </p:cNvPr>
          <p:cNvSpPr txBox="1">
            <a:spLocks/>
          </p:cNvSpPr>
          <p:nvPr/>
        </p:nvSpPr>
        <p:spPr>
          <a:xfrm>
            <a:off x="3105027" y="3907127"/>
            <a:ext cx="6278124" cy="10176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marL="342891" indent="-342891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1pPr>
            <a:lvl2pPr marL="742932" indent="-28574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2pPr>
            <a:lvl3pPr marL="1142971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3pPr>
            <a:lvl4pPr marL="1600160" indent="-228594" algn="l" defTabSz="457189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4pPr>
            <a:lvl5pPr marL="2057349" indent="-228594" algn="l" defTabSz="457189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Arial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/>
              <a:t>When we develop and pilot test the intervention, to what extent is it feasible and usable by end-users?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A26D019-0CC8-E240-A649-02744D8DDA46}"/>
              </a:ext>
            </a:extLst>
          </p:cNvPr>
          <p:cNvSpPr txBox="1"/>
          <p:nvPr/>
        </p:nvSpPr>
        <p:spPr>
          <a:xfrm>
            <a:off x="9907372" y="3097153"/>
            <a:ext cx="2006600" cy="369332"/>
          </a:xfrm>
          <a:prstGeom prst="rect">
            <a:avLst/>
          </a:prstGeom>
          <a:solidFill>
            <a:schemeClr val="bg2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Our focus today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EE3CD2C-A7AE-08CB-E0F7-7D9DD9E49632}"/>
              </a:ext>
            </a:extLst>
          </p:cNvPr>
          <p:cNvCxnSpPr>
            <a:cxnSpLocks/>
          </p:cNvCxnSpPr>
          <p:nvPr/>
        </p:nvCxnSpPr>
        <p:spPr>
          <a:xfrm flipH="1">
            <a:off x="9407517" y="3281819"/>
            <a:ext cx="4588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807FA023-9557-35D5-F2BD-86F0E0EBE6A6}"/>
              </a:ext>
            </a:extLst>
          </p:cNvPr>
          <p:cNvSpPr/>
          <p:nvPr/>
        </p:nvSpPr>
        <p:spPr>
          <a:xfrm>
            <a:off x="3105027" y="2659294"/>
            <a:ext cx="6278124" cy="1241660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734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D07A7A9B6A24A4DBD2D1A2B4128CBFA" ma:contentTypeVersion="12" ma:contentTypeDescription="Create a new document." ma:contentTypeScope="" ma:versionID="9b035e9b2f25b5c646d642c0f2e2c4ef">
  <xsd:schema xmlns:xsd="http://www.w3.org/2001/XMLSchema" xmlns:xs="http://www.w3.org/2001/XMLSchema" xmlns:p="http://schemas.microsoft.com/office/2006/metadata/properties" xmlns:ns2="41992e79-4270-4cdf-b097-f7584826223c" xmlns:ns3="0fcc5bc0-4866-4881-a053-3fc24d0ba78f" targetNamespace="http://schemas.microsoft.com/office/2006/metadata/properties" ma:root="true" ma:fieldsID="45feb2088859fb8390f9a491f63d890c" ns2:_="" ns3:_="">
    <xsd:import namespace="41992e79-4270-4cdf-b097-f7584826223c"/>
    <xsd:import namespace="0fcc5bc0-4866-4881-a053-3fc24d0ba78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992e79-4270-4cdf-b097-f7584826223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c2d55d72-5afa-45f9-90b6-e0708aeee9a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fcc5bc0-4866-4881-a053-3fc24d0ba78f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af4749ff-b63f-48e4-a0d8-a11332cf113b}" ma:internalName="TaxCatchAll" ma:showField="CatchAllData" ma:web="0fcc5bc0-4866-4881-a053-3fc24d0ba78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0fcc5bc0-4866-4881-a053-3fc24d0ba78f" xsi:nil="true"/>
    <lcf76f155ced4ddcb4097134ff3c332f xmlns="41992e79-4270-4cdf-b097-f7584826223c">
      <Terms xmlns="http://schemas.microsoft.com/office/infopath/2007/PartnerControls"/>
    </lcf76f155ced4ddcb4097134ff3c332f>
    <SharedWithUsers xmlns="0fcc5bc0-4866-4881-a053-3fc24d0ba78f">
      <UserInfo>
        <DisplayName>Mallory N Perez</DisplayName>
        <AccountId>24</AccountId>
        <AccountType/>
      </UserInfo>
    </SharedWithUsers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2EB79CE-6D25-4248-9F19-43A707972B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1992e79-4270-4cdf-b097-f7584826223c"/>
    <ds:schemaRef ds:uri="0fcc5bc0-4866-4881-a053-3fc24d0ba78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F9854AE-4407-4F67-8093-E59122A9AC23}">
  <ds:schemaRefs>
    <ds:schemaRef ds:uri="0fcc5bc0-4866-4881-a053-3fc24d0ba78f"/>
    <ds:schemaRef ds:uri="41992e79-4270-4cdf-b097-f7584826223c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67FA1C8B-AC0F-4A1F-AD49-350591A4E70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71</Words>
  <Application>Microsoft Macintosh PowerPoint</Application>
  <PresentationFormat>Widescreen</PresentationFormat>
  <Paragraphs>437</Paragraphs>
  <Slides>50</Slides>
  <Notes>45</Notes>
  <HiddenSlides>0</HiddenSlides>
  <MMClips>0</MMClips>
  <ScaleCrop>false</ScaleCrop>
  <HeadingPairs>
    <vt:vector size="6" baseType="variant">
      <vt:variant>
        <vt:lpstr>Fonts Used</vt:lpstr>
      </vt:variant>
      <vt:variant>
        <vt:i4>1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0</vt:i4>
      </vt:variant>
    </vt:vector>
  </HeadingPairs>
  <TitlesOfParts>
    <vt:vector size="62" baseType="lpstr">
      <vt:lpstr>Arial</vt:lpstr>
      <vt:lpstr>Arial,Sans-Serif</vt:lpstr>
      <vt:lpstr>Calibri</vt:lpstr>
      <vt:lpstr>Frutiger</vt:lpstr>
      <vt:lpstr>Karla</vt:lpstr>
      <vt:lpstr>Poppins</vt:lpstr>
      <vt:lpstr>Poppins Regular</vt:lpstr>
      <vt:lpstr>Poppins SemiBold</vt:lpstr>
      <vt:lpstr>Symbol</vt:lpstr>
      <vt:lpstr>Wingdings</vt:lpstr>
      <vt:lpstr>ZapfDingbatsITC</vt:lpstr>
      <vt:lpstr>Office Theme</vt:lpstr>
      <vt:lpstr>PowerPoint Presentation</vt:lpstr>
      <vt:lpstr>Acknowledgements</vt:lpstr>
      <vt:lpstr>Today’s agenda</vt:lpstr>
      <vt:lpstr>Why have we brought everyone together?</vt:lpstr>
      <vt:lpstr>Why have we brought everyone together?</vt:lpstr>
      <vt:lpstr>Why have we brought everyone together?</vt:lpstr>
      <vt:lpstr>Why have we brought everyone together?</vt:lpstr>
      <vt:lpstr>Key questions</vt:lpstr>
      <vt:lpstr>Key questions</vt:lpstr>
      <vt:lpstr>Key questions</vt:lpstr>
      <vt:lpstr>What have we learned so far?</vt:lpstr>
      <vt:lpstr>What have we learned so far?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Result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What would this look like in IBD?</vt:lpstr>
      <vt:lpstr>Roundtable Introductions</vt:lpstr>
      <vt:lpstr>Thinking Differently</vt:lpstr>
      <vt:lpstr>Thinking Differently</vt:lpstr>
      <vt:lpstr>Thinking Differently</vt:lpstr>
      <vt:lpstr>Thinking Differently</vt:lpstr>
      <vt:lpstr>Thinking Differently</vt:lpstr>
      <vt:lpstr>Thinking Differently</vt:lpstr>
      <vt:lpstr>Thinking Differently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Breaking the Rules</vt:lpstr>
      <vt:lpstr>PowerPoint Presentation</vt:lpstr>
      <vt:lpstr>PowerPoint Presentation</vt:lpstr>
      <vt:lpstr>Wild Card</vt:lpstr>
      <vt:lpstr>Wild Card</vt:lpstr>
      <vt:lpstr>Next steps</vt:lpstr>
      <vt:lpstr>Thank you!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va Balbale</dc:creator>
  <cp:lastModifiedBy>Younan, Maria</cp:lastModifiedBy>
  <cp:revision>3</cp:revision>
  <dcterms:created xsi:type="dcterms:W3CDTF">2020-04-01T04:30:17Z</dcterms:created>
  <dcterms:modified xsi:type="dcterms:W3CDTF">2026-01-28T04:57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D07A7A9B6A24A4DBD2D1A2B4128CBFA</vt:lpwstr>
  </property>
  <property fmtid="{D5CDD505-2E9C-101B-9397-08002B2CF9AE}" pid="3" name="MediaServiceImageTags">
    <vt:lpwstr/>
  </property>
</Properties>
</file>